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bhishek Ojha" userId="253db238782fe597" providerId="LiveId" clId="{48F4AE56-B12B-4ED2-BA64-EE21170A5BFA}"/>
    <pc:docChg chg="undo custSel addSld delSld modSld sldOrd">
      <pc:chgData name="Abhishek Ojha" userId="253db238782fe597" providerId="LiveId" clId="{48F4AE56-B12B-4ED2-BA64-EE21170A5BFA}" dt="2023-06-29T09:23:19.736" v="7183" actId="47"/>
      <pc:docMkLst>
        <pc:docMk/>
      </pc:docMkLst>
      <pc:sldChg chg="modSp del mod">
        <pc:chgData name="Abhishek Ojha" userId="253db238782fe597" providerId="LiveId" clId="{48F4AE56-B12B-4ED2-BA64-EE21170A5BFA}" dt="2023-06-29T09:23:19.736" v="7183" actId="47"/>
        <pc:sldMkLst>
          <pc:docMk/>
          <pc:sldMk cId="2655172486" sldId="256"/>
        </pc:sldMkLst>
        <pc:picChg chg="mod modCrop">
          <ac:chgData name="Abhishek Ojha" userId="253db238782fe597" providerId="LiveId" clId="{48F4AE56-B12B-4ED2-BA64-EE21170A5BFA}" dt="2023-06-24T09:55:47.168" v="5951" actId="1076"/>
          <ac:picMkLst>
            <pc:docMk/>
            <pc:sldMk cId="2655172486" sldId="256"/>
            <ac:picMk id="5" creationId="{38464A3B-99FB-CBDD-92DE-F9D45EC7EAC0}"/>
          </ac:picMkLst>
        </pc:picChg>
      </pc:sldChg>
      <pc:sldChg chg="addSp delSp modSp new mod">
        <pc:chgData name="Abhishek Ojha" userId="253db238782fe597" providerId="LiveId" clId="{48F4AE56-B12B-4ED2-BA64-EE21170A5BFA}" dt="2023-06-27T05:50:47.940" v="7143" actId="1076"/>
        <pc:sldMkLst>
          <pc:docMk/>
          <pc:sldMk cId="650187009" sldId="257"/>
        </pc:sldMkLst>
        <pc:spChg chg="del">
          <ac:chgData name="Abhishek Ojha" userId="253db238782fe597" providerId="LiveId" clId="{48F4AE56-B12B-4ED2-BA64-EE21170A5BFA}" dt="2023-06-23T04:54:22.063" v="1" actId="478"/>
          <ac:spMkLst>
            <pc:docMk/>
            <pc:sldMk cId="650187009" sldId="257"/>
            <ac:spMk id="2" creationId="{AF612C67-11CE-D625-2C97-CB770E97CAE1}"/>
          </ac:spMkLst>
        </pc:spChg>
        <pc:spChg chg="add mod">
          <ac:chgData name="Abhishek Ojha" userId="253db238782fe597" providerId="LiveId" clId="{48F4AE56-B12B-4ED2-BA64-EE21170A5BFA}" dt="2023-06-27T05:39:46.111" v="6739" actId="1076"/>
          <ac:spMkLst>
            <pc:docMk/>
            <pc:sldMk cId="650187009" sldId="257"/>
            <ac:spMk id="3" creationId="{BC45CECE-37F1-8C92-D29E-70EC0C6927D8}"/>
          </ac:spMkLst>
        </pc:spChg>
        <pc:spChg chg="del">
          <ac:chgData name="Abhishek Ojha" userId="253db238782fe597" providerId="LiveId" clId="{48F4AE56-B12B-4ED2-BA64-EE21170A5BFA}" dt="2023-06-23T04:54:22.063" v="1" actId="478"/>
          <ac:spMkLst>
            <pc:docMk/>
            <pc:sldMk cId="650187009" sldId="257"/>
            <ac:spMk id="3" creationId="{D5C9EBDD-24CD-BCA4-852D-A5835E2DBE36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7" creationId="{372EDBA7-5ABE-6228-B73B-E3DE28453AE1}"/>
          </ac:spMkLst>
        </pc:spChg>
        <pc:spChg chg="add mod">
          <ac:chgData name="Abhishek Ojha" userId="253db238782fe597" providerId="LiveId" clId="{48F4AE56-B12B-4ED2-BA64-EE21170A5BFA}" dt="2023-06-23T06:39:19.617" v="3662" actId="14100"/>
          <ac:spMkLst>
            <pc:docMk/>
            <pc:sldMk cId="650187009" sldId="257"/>
            <ac:spMk id="9" creationId="{26DA55EB-9367-34C0-06EF-C89E8EA5B213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10" creationId="{773B9B0D-7234-D247-10AD-957F23402087}"/>
          </ac:spMkLst>
        </pc:spChg>
        <pc:spChg chg="add mod">
          <ac:chgData name="Abhishek Ojha" userId="253db238782fe597" providerId="LiveId" clId="{48F4AE56-B12B-4ED2-BA64-EE21170A5BFA}" dt="2023-06-23T05:07:25.799" v="505" actId="20577"/>
          <ac:spMkLst>
            <pc:docMk/>
            <pc:sldMk cId="650187009" sldId="257"/>
            <ac:spMk id="11" creationId="{F2ADA8B1-C869-7AE5-26E2-B3A8FA6D7C4D}"/>
          </ac:spMkLst>
        </pc:spChg>
        <pc:spChg chg="add mod topLvl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17" creationId="{B89637B7-4329-C1D5-EA76-88889A0CD539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18" creationId="{D4314901-9957-E965-7EAC-F319E634FFCC}"/>
          </ac:spMkLst>
        </pc:spChg>
        <pc:spChg chg="add del mod">
          <ac:chgData name="Abhishek Ojha" userId="253db238782fe597" providerId="LiveId" clId="{48F4AE56-B12B-4ED2-BA64-EE21170A5BFA}" dt="2023-06-23T05:48:02.502" v="2213" actId="478"/>
          <ac:spMkLst>
            <pc:docMk/>
            <pc:sldMk cId="650187009" sldId="257"/>
            <ac:spMk id="19" creationId="{9E784CCC-B405-4D13-6D71-7529E2BFB016}"/>
          </ac:spMkLst>
        </pc:spChg>
        <pc:spChg chg="add del mod">
          <ac:chgData name="Abhishek Ojha" userId="253db238782fe597" providerId="LiveId" clId="{48F4AE56-B12B-4ED2-BA64-EE21170A5BFA}" dt="2023-06-23T05:47:59.784" v="2212" actId="478"/>
          <ac:spMkLst>
            <pc:docMk/>
            <pc:sldMk cId="650187009" sldId="257"/>
            <ac:spMk id="20" creationId="{DDB48DC1-9B55-43A4-34F4-F7C6B59DD793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1" creationId="{FF65A728-239D-EAD1-CBC6-8FE50D4EBBE4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3" creationId="{A599F222-B1F3-2B74-EB66-111FEBD2AB40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4" creationId="{79FB70ED-848C-1AFB-6D1F-3BEB160DFE7C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5" creationId="{3F10FE84-ECCE-8C70-CBF4-FF32ADEC3E50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6" creationId="{2B6F9BB7-A89E-84EF-B7AD-0FB2D5914950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7" creationId="{C6EFB81B-66F2-AF6D-7ABE-1AB9EFC95729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8" creationId="{B2D48EF4-3AAA-D748-14BB-2EA705741071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29" creationId="{2DA32B13-3261-EEAD-7A11-EE6C4636BC22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0" creationId="{7DB0B694-63B4-59EA-1541-405657816BAB}"/>
          </ac:spMkLst>
        </pc:spChg>
        <pc:spChg chg="add mod topLvl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1" creationId="{E0730C8F-8251-C566-45EA-CA42EBE64745}"/>
          </ac:spMkLst>
        </pc:spChg>
        <pc:spChg chg="add mod topLvl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2" creationId="{3671A01A-E727-32B3-8822-799AEF2E7F28}"/>
          </ac:spMkLst>
        </pc:spChg>
        <pc:spChg chg="add mod topLvl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3" creationId="{47CCD645-6997-2F40-E184-8D86F66FD4C5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6" creationId="{4189FBE8-B2EA-78FC-1992-1849DB0462D8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7" creationId="{78D506DA-548D-924D-693A-E2C5BB3E7E46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8" creationId="{D01DE944-82DE-B7E0-365D-8CC5E99338C1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39" creationId="{5C12DB1C-0DF8-286C-E2CB-33E399896524}"/>
          </ac:spMkLst>
        </pc:spChg>
        <pc:spChg chg="add del mod">
          <ac:chgData name="Abhishek Ojha" userId="253db238782fe597" providerId="LiveId" clId="{48F4AE56-B12B-4ED2-BA64-EE21170A5BFA}" dt="2023-06-23T06:09:09.160" v="2627" actId="478"/>
          <ac:spMkLst>
            <pc:docMk/>
            <pc:sldMk cId="650187009" sldId="257"/>
            <ac:spMk id="42" creationId="{A76046C0-B6EF-C6E4-3CA9-54FF0302CB24}"/>
          </ac:spMkLst>
        </pc:spChg>
        <pc:spChg chg="add del mod">
          <ac:chgData name="Abhishek Ojha" userId="253db238782fe597" providerId="LiveId" clId="{48F4AE56-B12B-4ED2-BA64-EE21170A5BFA}" dt="2023-06-23T06:09:09.160" v="2627" actId="478"/>
          <ac:spMkLst>
            <pc:docMk/>
            <pc:sldMk cId="650187009" sldId="257"/>
            <ac:spMk id="43" creationId="{E8AD383F-93CE-6CE2-A2E6-0ADD4408D730}"/>
          </ac:spMkLst>
        </pc:spChg>
        <pc:spChg chg="add del mod">
          <ac:chgData name="Abhishek Ojha" userId="253db238782fe597" providerId="LiveId" clId="{48F4AE56-B12B-4ED2-BA64-EE21170A5BFA}" dt="2023-06-23T06:09:26.885" v="2681" actId="478"/>
          <ac:spMkLst>
            <pc:docMk/>
            <pc:sldMk cId="650187009" sldId="257"/>
            <ac:spMk id="44" creationId="{F91BE007-4C78-9426-1BCA-3DC1CCB8EB29}"/>
          </ac:spMkLst>
        </pc:spChg>
        <pc:spChg chg="add del mod">
          <ac:chgData name="Abhishek Ojha" userId="253db238782fe597" providerId="LiveId" clId="{48F4AE56-B12B-4ED2-BA64-EE21170A5BFA}" dt="2023-06-23T06:09:31.040" v="2683" actId="478"/>
          <ac:spMkLst>
            <pc:docMk/>
            <pc:sldMk cId="650187009" sldId="257"/>
            <ac:spMk id="45" creationId="{B474F2DB-A07C-883C-946A-6EE4EFD2CEE0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46" creationId="{5AD058D2-3F3D-27A5-B843-655889DD2D24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47" creationId="{E986F9FF-EA42-CEBB-42F9-0782D5741A91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48" creationId="{73107E53-8558-6A06-80DB-290B9CD41185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49" creationId="{EA7ED44F-AF13-6F99-D0A8-2E3B69689F1B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50" creationId="{5C1DF496-46E9-44BE-7BE7-BC471B516BB5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51" creationId="{F4148F60-9276-D3EC-5BA0-E281BD13D152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55" creationId="{E05A3662-6E28-EE19-910F-CDACF11BF250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56" creationId="{D304A32C-1B14-D1D8-4E43-64FB3C389672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57" creationId="{6733B559-3E3D-6F55-64AB-246BA44C08C4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58" creationId="{B5598CFE-F323-7AA6-49B8-0B4FEC5FE1BB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59" creationId="{F534FFD1-300A-68E2-2AF8-A67104FA0B5F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0" creationId="{572FE5E9-6E13-958E-0AE5-C8A5F2BDF1D3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1" creationId="{4C834D94-1671-3962-13F3-E1B369DF844B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2" creationId="{27714D33-B2EE-9EA9-5B8D-B9CEDB55E319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3" creationId="{7C358889-B772-68F9-C6EA-3663C5FD9680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4" creationId="{7DFDF85E-2394-8FF8-EF21-D458B75851A8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6" creationId="{096F721A-10A3-E81F-A2F9-3CE63616DD59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7" creationId="{ACA2D3DA-8AF9-5B62-626E-930B5C10CA59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8" creationId="{C7DA980F-D2C7-AFE0-F5AC-9F21788ABC5F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69" creationId="{5A8D9A38-0F48-EE79-578B-9C16D26519D2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0" creationId="{7B2FFF99-A2A0-04D2-66D7-3731E01DC3AF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1" creationId="{4CA1F9F2-FF18-B170-7DFF-1A66E6CA8C90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2" creationId="{2691CD00-F367-3A09-5C5A-6105C2C41617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5" creationId="{9DE295DA-6748-FDAF-A85C-A0F17E852E0A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6" creationId="{EE0BBE39-D6E7-FFD9-C3CC-D499BE4CFE1E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7" creationId="{AD9E64CF-5CA0-B8B9-62C7-4B8B1C816C1B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8" creationId="{E6509B26-0E08-BA42-6932-AFCD5B1F45E5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79" creationId="{C5336FFA-B7D9-F9F4-4252-5BD91C9B8B4C}"/>
          </ac:spMkLst>
        </pc:spChg>
        <pc:spChg chg="mod">
          <ac:chgData name="Abhishek Ojha" userId="253db238782fe597" providerId="LiveId" clId="{48F4AE56-B12B-4ED2-BA64-EE21170A5BFA}" dt="2023-06-23T06:23:02.112" v="3295" actId="571"/>
          <ac:spMkLst>
            <pc:docMk/>
            <pc:sldMk cId="650187009" sldId="257"/>
            <ac:spMk id="80" creationId="{73923740-1B1F-F825-9993-2A4D8ABF9BED}"/>
          </ac:spMkLst>
        </pc:spChg>
        <pc:spChg chg="add mod">
          <ac:chgData name="Abhishek Ojha" userId="253db238782fe597" providerId="LiveId" clId="{48F4AE56-B12B-4ED2-BA64-EE21170A5BFA}" dt="2023-06-27T05:50:47.940" v="7143" actId="1076"/>
          <ac:spMkLst>
            <pc:docMk/>
            <pc:sldMk cId="650187009" sldId="257"/>
            <ac:spMk id="82" creationId="{72ABF007-4FF0-4501-94EF-21A7156E09E7}"/>
          </ac:spMkLst>
        </pc:spChg>
        <pc:spChg chg="add del mod">
          <ac:chgData name="Abhishek Ojha" userId="253db238782fe597" providerId="LiveId" clId="{48F4AE56-B12B-4ED2-BA64-EE21170A5BFA}" dt="2023-06-23T06:41:31.145" v="3904"/>
          <ac:spMkLst>
            <pc:docMk/>
            <pc:sldMk cId="650187009" sldId="257"/>
            <ac:spMk id="83" creationId="{277D1E68-F493-A2F2-143A-3564DF5B0FE9}"/>
          </ac:spMkLst>
        </pc:spChg>
        <pc:spChg chg="add mod">
          <ac:chgData name="Abhishek Ojha" userId="253db238782fe597" providerId="LiveId" clId="{48F4AE56-B12B-4ED2-BA64-EE21170A5BFA}" dt="2023-06-23T06:44:22.886" v="4210" actId="113"/>
          <ac:spMkLst>
            <pc:docMk/>
            <pc:sldMk cId="650187009" sldId="257"/>
            <ac:spMk id="85" creationId="{245933A4-1A10-5AEB-9BB7-E317940CAE40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86" creationId="{50C09425-11EF-7776-478A-7D6BF50AF2C1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87" creationId="{928A4726-5A5C-DBD1-2EC6-232A51737176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88" creationId="{3BCFF66B-358B-4847-1746-9A49C48AB6CC}"/>
          </ac:spMkLst>
        </pc:spChg>
        <pc:spChg chg="add mod">
          <ac:chgData name="Abhishek Ojha" userId="253db238782fe597" providerId="LiveId" clId="{48F4AE56-B12B-4ED2-BA64-EE21170A5BFA}" dt="2023-06-27T05:34:11.052" v="6729" actId="571"/>
          <ac:spMkLst>
            <pc:docMk/>
            <pc:sldMk cId="650187009" sldId="257"/>
            <ac:spMk id="89" creationId="{08607674-80D8-9CCD-976F-12094A699A91}"/>
          </ac:spMkLst>
        </pc:spChg>
        <pc:grpChg chg="add mod">
          <ac:chgData name="Abhishek Ojha" userId="253db238782fe597" providerId="LiveId" clId="{48F4AE56-B12B-4ED2-BA64-EE21170A5BFA}" dt="2023-06-27T05:34:11.052" v="6729" actId="571"/>
          <ac:grpSpMkLst>
            <pc:docMk/>
            <pc:sldMk cId="650187009" sldId="257"/>
            <ac:grpSpMk id="12" creationId="{96939A7E-03EE-E8CC-297A-B2D0DC1C1ADD}"/>
          </ac:grpSpMkLst>
        </pc:grpChg>
        <pc:grpChg chg="add mod">
          <ac:chgData name="Abhishek Ojha" userId="253db238782fe597" providerId="LiveId" clId="{48F4AE56-B12B-4ED2-BA64-EE21170A5BFA}" dt="2023-06-23T06:42:23.384" v="3986" actId="1076"/>
          <ac:grpSpMkLst>
            <pc:docMk/>
            <pc:sldMk cId="650187009" sldId="257"/>
            <ac:grpSpMk id="13" creationId="{A03C35B5-15F8-4DCA-EDDB-BCC85D9FF9BC}"/>
          </ac:grpSpMkLst>
        </pc:grpChg>
        <pc:grpChg chg="add mod">
          <ac:chgData name="Abhishek Ojha" userId="253db238782fe597" providerId="LiveId" clId="{48F4AE56-B12B-4ED2-BA64-EE21170A5BFA}" dt="2023-06-23T05:45:12.992" v="2038" actId="164"/>
          <ac:grpSpMkLst>
            <pc:docMk/>
            <pc:sldMk cId="650187009" sldId="257"/>
            <ac:grpSpMk id="34" creationId="{3D5EEA18-7FBE-141C-13D6-0882D6CD1BE8}"/>
          </ac:grpSpMkLst>
        </pc:grpChg>
        <pc:grpChg chg="add del mod">
          <ac:chgData name="Abhishek Ojha" userId="253db238782fe597" providerId="LiveId" clId="{48F4AE56-B12B-4ED2-BA64-EE21170A5BFA}" dt="2023-06-23T05:50:52.438" v="2401" actId="165"/>
          <ac:grpSpMkLst>
            <pc:docMk/>
            <pc:sldMk cId="650187009" sldId="257"/>
            <ac:grpSpMk id="35" creationId="{0875E9E5-12A6-BD00-BE33-929376A04D48}"/>
          </ac:grpSpMkLst>
        </pc:grpChg>
        <pc:grpChg chg="add mod">
          <ac:chgData name="Abhishek Ojha" userId="253db238782fe597" providerId="LiveId" clId="{48F4AE56-B12B-4ED2-BA64-EE21170A5BFA}" dt="2023-06-27T05:34:11.052" v="6729" actId="571"/>
          <ac:grpSpMkLst>
            <pc:docMk/>
            <pc:sldMk cId="650187009" sldId="257"/>
            <ac:grpSpMk id="40" creationId="{E66DEC0D-414C-D2F6-8ED3-1FD6ADE9F982}"/>
          </ac:grpSpMkLst>
        </pc:grpChg>
        <pc:grpChg chg="add mod topLvl">
          <ac:chgData name="Abhishek Ojha" userId="253db238782fe597" providerId="LiveId" clId="{48F4AE56-B12B-4ED2-BA64-EE21170A5BFA}" dt="2023-06-27T05:34:11.052" v="6729" actId="571"/>
          <ac:grpSpMkLst>
            <pc:docMk/>
            <pc:sldMk cId="650187009" sldId="257"/>
            <ac:grpSpMk id="41" creationId="{DBF6E14E-872E-074C-F6AD-E7249F513A83}"/>
          </ac:grpSpMkLst>
        </pc:grpChg>
        <pc:grpChg chg="add mod topLvl">
          <ac:chgData name="Abhishek Ojha" userId="253db238782fe597" providerId="LiveId" clId="{48F4AE56-B12B-4ED2-BA64-EE21170A5BFA}" dt="2023-06-27T05:34:11.052" v="6729" actId="571"/>
          <ac:grpSpMkLst>
            <pc:docMk/>
            <pc:sldMk cId="650187009" sldId="257"/>
            <ac:grpSpMk id="52" creationId="{F5633127-17DA-730C-DF6C-3EE61FEEF949}"/>
          </ac:grpSpMkLst>
        </pc:grpChg>
        <pc:grpChg chg="add mod">
          <ac:chgData name="Abhishek Ojha" userId="253db238782fe597" providerId="LiveId" clId="{48F4AE56-B12B-4ED2-BA64-EE21170A5BFA}" dt="2023-06-23T06:23:02.112" v="3295" actId="571"/>
          <ac:grpSpMkLst>
            <pc:docMk/>
            <pc:sldMk cId="650187009" sldId="257"/>
            <ac:grpSpMk id="53" creationId="{0B755E57-A1D3-8381-DBE5-07FA027B8BFF}"/>
          </ac:grpSpMkLst>
        </pc:grpChg>
        <pc:grpChg chg="mod">
          <ac:chgData name="Abhishek Ojha" userId="253db238782fe597" providerId="LiveId" clId="{48F4AE56-B12B-4ED2-BA64-EE21170A5BFA}" dt="2023-06-23T06:23:02.112" v="3295" actId="571"/>
          <ac:grpSpMkLst>
            <pc:docMk/>
            <pc:sldMk cId="650187009" sldId="257"/>
            <ac:grpSpMk id="65" creationId="{AE1B920F-C911-B89A-9A0B-5A56B294DD07}"/>
          </ac:grpSpMkLst>
        </pc:grpChg>
        <pc:grpChg chg="add mod">
          <ac:chgData name="Abhishek Ojha" userId="253db238782fe597" providerId="LiveId" clId="{48F4AE56-B12B-4ED2-BA64-EE21170A5BFA}" dt="2023-06-23T06:23:02.112" v="3295" actId="571"/>
          <ac:grpSpMkLst>
            <pc:docMk/>
            <pc:sldMk cId="650187009" sldId="257"/>
            <ac:grpSpMk id="73" creationId="{20B379F0-5B33-8264-3EB5-175C4414B3F7}"/>
          </ac:grpSpMkLst>
        </pc:grpChg>
        <pc:grpChg chg="add del mod topLvl">
          <ac:chgData name="Abhishek Ojha" userId="253db238782fe597" providerId="LiveId" clId="{48F4AE56-B12B-4ED2-BA64-EE21170A5BFA}" dt="2023-06-23T06:41:47.087" v="3906" actId="165"/>
          <ac:grpSpMkLst>
            <pc:docMk/>
            <pc:sldMk cId="650187009" sldId="257"/>
            <ac:grpSpMk id="81" creationId="{08178C87-4056-9882-F08B-DF7E5812C124}"/>
          </ac:grpSpMkLst>
        </pc:grpChg>
        <pc:grpChg chg="add del mod">
          <ac:chgData name="Abhishek Ojha" userId="253db238782fe597" providerId="LiveId" clId="{48F4AE56-B12B-4ED2-BA64-EE21170A5BFA}" dt="2023-06-23T06:41:38.062" v="3905" actId="165"/>
          <ac:grpSpMkLst>
            <pc:docMk/>
            <pc:sldMk cId="650187009" sldId="257"/>
            <ac:grpSpMk id="84" creationId="{B4502CE4-B55B-88CF-24A0-15A65EF2B56C}"/>
          </ac:grpSpMkLst>
        </pc:grpChg>
        <pc:grpChg chg="add mod">
          <ac:chgData name="Abhishek Ojha" userId="253db238782fe597" providerId="LiveId" clId="{48F4AE56-B12B-4ED2-BA64-EE21170A5BFA}" dt="2023-06-27T05:34:11.052" v="6729" actId="571"/>
          <ac:grpSpMkLst>
            <pc:docMk/>
            <pc:sldMk cId="650187009" sldId="257"/>
            <ac:grpSpMk id="90" creationId="{20951AA7-1487-9DB3-8C2D-0D30208099CA}"/>
          </ac:grpSpMkLst>
        </pc:grpChg>
        <pc:graphicFrameChg chg="add mod">
          <ac:chgData name="Abhishek Ojha" userId="253db238782fe597" providerId="LiveId" clId="{48F4AE56-B12B-4ED2-BA64-EE21170A5BFA}" dt="2023-06-27T05:34:11.052" v="6729" actId="571"/>
          <ac:graphicFrameMkLst>
            <pc:docMk/>
            <pc:sldMk cId="650187009" sldId="257"/>
            <ac:graphicFrameMk id="2" creationId="{BFC4BE7C-E541-F44A-5E24-314BC5757DEC}"/>
          </ac:graphicFrameMkLst>
        </pc:graphicFrameChg>
        <pc:graphicFrameChg chg="add mod">
          <ac:chgData name="Abhishek Ojha" userId="253db238782fe597" providerId="LiveId" clId="{48F4AE56-B12B-4ED2-BA64-EE21170A5BFA}" dt="2023-06-27T05:34:11.052" v="6729" actId="571"/>
          <ac:graphicFrameMkLst>
            <pc:docMk/>
            <pc:sldMk cId="650187009" sldId="257"/>
            <ac:graphicFrameMk id="4" creationId="{569567DF-9A31-9601-76A7-17342BF4E3EA}"/>
          </ac:graphicFrameMkLst>
        </pc:graphicFrameChg>
        <pc:graphicFrameChg chg="add mod">
          <ac:chgData name="Abhishek Ojha" userId="253db238782fe597" providerId="LiveId" clId="{48F4AE56-B12B-4ED2-BA64-EE21170A5BFA}" dt="2023-06-23T05:00:15.162" v="196" actId="164"/>
          <ac:graphicFrameMkLst>
            <pc:docMk/>
            <pc:sldMk cId="650187009" sldId="257"/>
            <ac:graphicFrameMk id="5" creationId="{8864847E-2DD9-302E-DDE9-B041A2751099}"/>
          </ac:graphicFrameMkLst>
        </pc:graphicFrameChg>
        <pc:graphicFrameChg chg="add mod">
          <ac:chgData name="Abhishek Ojha" userId="253db238782fe597" providerId="LiveId" clId="{48F4AE56-B12B-4ED2-BA64-EE21170A5BFA}" dt="2023-06-27T05:34:11.052" v="6729" actId="571"/>
          <ac:graphicFrameMkLst>
            <pc:docMk/>
            <pc:sldMk cId="650187009" sldId="257"/>
            <ac:graphicFrameMk id="14" creationId="{61951753-18B1-D3A5-71A2-F58CBB3CB745}"/>
          </ac:graphicFrameMkLst>
        </pc:graphicFrameChg>
        <pc:graphicFrameChg chg="add mod">
          <ac:chgData name="Abhishek Ojha" userId="253db238782fe597" providerId="LiveId" clId="{48F4AE56-B12B-4ED2-BA64-EE21170A5BFA}" dt="2023-06-27T05:34:11.052" v="6729" actId="571"/>
          <ac:graphicFrameMkLst>
            <pc:docMk/>
            <pc:sldMk cId="650187009" sldId="257"/>
            <ac:graphicFrameMk id="15" creationId="{9DCDBFB5-5AD9-F56F-4A0D-9E038F4F2F57}"/>
          </ac:graphicFrameMkLst>
        </pc:graphicFrameChg>
        <pc:graphicFrameChg chg="mod">
          <ac:chgData name="Abhishek Ojha" userId="253db238782fe597" providerId="LiveId" clId="{48F4AE56-B12B-4ED2-BA64-EE21170A5BFA}" dt="2023-06-23T06:23:02.112" v="3295" actId="571"/>
          <ac:graphicFrameMkLst>
            <pc:docMk/>
            <pc:sldMk cId="650187009" sldId="257"/>
            <ac:graphicFrameMk id="54" creationId="{0E4968BC-AE13-F23E-267A-3D76BA4B16C0}"/>
          </ac:graphicFrameMkLst>
        </pc:graphicFrameChg>
        <pc:graphicFrameChg chg="mod">
          <ac:chgData name="Abhishek Ojha" userId="253db238782fe597" providerId="LiveId" clId="{48F4AE56-B12B-4ED2-BA64-EE21170A5BFA}" dt="2023-06-23T06:23:02.112" v="3295" actId="571"/>
          <ac:graphicFrameMkLst>
            <pc:docMk/>
            <pc:sldMk cId="650187009" sldId="257"/>
            <ac:graphicFrameMk id="74" creationId="{5930214E-0B9B-EE9E-8249-080424A7BA9E}"/>
          </ac:graphicFrameMkLst>
        </pc:graphicFrameChg>
      </pc:sldChg>
      <pc:sldChg chg="addSp delSp modSp new mod ord">
        <pc:chgData name="Abhishek Ojha" userId="253db238782fe597" providerId="LiveId" clId="{48F4AE56-B12B-4ED2-BA64-EE21170A5BFA}" dt="2023-06-28T06:25:08.979" v="7182"/>
        <pc:sldMkLst>
          <pc:docMk/>
          <pc:sldMk cId="3285560308" sldId="258"/>
        </pc:sldMkLst>
        <pc:spChg chg="del">
          <ac:chgData name="Abhishek Ojha" userId="253db238782fe597" providerId="LiveId" clId="{48F4AE56-B12B-4ED2-BA64-EE21170A5BFA}" dt="2023-06-23T06:46:27.032" v="4627" actId="478"/>
          <ac:spMkLst>
            <pc:docMk/>
            <pc:sldMk cId="3285560308" sldId="258"/>
            <ac:spMk id="2" creationId="{DFC09B2A-273A-C2F8-C46E-456B63EB2E4A}"/>
          </ac:spMkLst>
        </pc:spChg>
        <pc:spChg chg="del">
          <ac:chgData name="Abhishek Ojha" userId="253db238782fe597" providerId="LiveId" clId="{48F4AE56-B12B-4ED2-BA64-EE21170A5BFA}" dt="2023-06-23T06:46:27.032" v="4627" actId="478"/>
          <ac:spMkLst>
            <pc:docMk/>
            <pc:sldMk cId="3285560308" sldId="258"/>
            <ac:spMk id="3" creationId="{AF124518-5A90-1F54-2263-9A9427B5BEBC}"/>
          </ac:spMkLst>
        </pc:spChg>
        <pc:spChg chg="add mod">
          <ac:chgData name="Abhishek Ojha" userId="253db238782fe597" providerId="LiveId" clId="{48F4AE56-B12B-4ED2-BA64-EE21170A5BFA}" dt="2023-06-24T09:06:52.253" v="4963" actId="164"/>
          <ac:spMkLst>
            <pc:docMk/>
            <pc:sldMk cId="3285560308" sldId="258"/>
            <ac:spMk id="4" creationId="{1808E095-5066-DE87-928E-F529210DD0C9}"/>
          </ac:spMkLst>
        </pc:spChg>
        <pc:spChg chg="add mod">
          <ac:chgData name="Abhishek Ojha" userId="253db238782fe597" providerId="LiveId" clId="{48F4AE56-B12B-4ED2-BA64-EE21170A5BFA}" dt="2023-06-24T09:06:52.253" v="4963" actId="164"/>
          <ac:spMkLst>
            <pc:docMk/>
            <pc:sldMk cId="3285560308" sldId="258"/>
            <ac:spMk id="5" creationId="{AE3BE2C0-F646-BC41-0F77-E1DB717510B4}"/>
          </ac:spMkLst>
        </pc:spChg>
        <pc:spChg chg="add mod">
          <ac:chgData name="Abhishek Ojha" userId="253db238782fe597" providerId="LiveId" clId="{48F4AE56-B12B-4ED2-BA64-EE21170A5BFA}" dt="2023-06-24T09:06:52.253" v="4963" actId="164"/>
          <ac:spMkLst>
            <pc:docMk/>
            <pc:sldMk cId="3285560308" sldId="258"/>
            <ac:spMk id="6" creationId="{7681445F-97A8-3BB1-FBC5-05D779D55EFB}"/>
          </ac:spMkLst>
        </pc:spChg>
        <pc:spChg chg="add mod">
          <ac:chgData name="Abhishek Ojha" userId="253db238782fe597" providerId="LiveId" clId="{48F4AE56-B12B-4ED2-BA64-EE21170A5BFA}" dt="2023-06-24T09:06:52.253" v="4963" actId="164"/>
          <ac:spMkLst>
            <pc:docMk/>
            <pc:sldMk cId="3285560308" sldId="258"/>
            <ac:spMk id="7" creationId="{8F83E673-96FC-C0EB-4214-3CF6EE6BED48}"/>
          </ac:spMkLst>
        </pc:spChg>
        <pc:spChg chg="add mod">
          <ac:chgData name="Abhishek Ojha" userId="253db238782fe597" providerId="LiveId" clId="{48F4AE56-B12B-4ED2-BA64-EE21170A5BFA}" dt="2023-06-24T09:06:52.253" v="4963" actId="164"/>
          <ac:spMkLst>
            <pc:docMk/>
            <pc:sldMk cId="3285560308" sldId="258"/>
            <ac:spMk id="8" creationId="{14F39214-E378-C9D0-950E-1F38F4C07C69}"/>
          </ac:spMkLst>
        </pc:spChg>
        <pc:spChg chg="add mod">
          <ac:chgData name="Abhishek Ojha" userId="253db238782fe597" providerId="LiveId" clId="{48F4AE56-B12B-4ED2-BA64-EE21170A5BFA}" dt="2023-06-24T09:08:26.800" v="5029" actId="164"/>
          <ac:spMkLst>
            <pc:docMk/>
            <pc:sldMk cId="3285560308" sldId="258"/>
            <ac:spMk id="11" creationId="{5BFCB7A6-C261-5230-29D1-1D106690A1A9}"/>
          </ac:spMkLst>
        </pc:spChg>
        <pc:spChg chg="mod">
          <ac:chgData name="Abhishek Ojha" userId="253db238782fe597" providerId="LiveId" clId="{48F4AE56-B12B-4ED2-BA64-EE21170A5BFA}" dt="2023-06-26T07:34:07.254" v="6584" actId="1036"/>
          <ac:spMkLst>
            <pc:docMk/>
            <pc:sldMk cId="3285560308" sldId="258"/>
            <ac:spMk id="13" creationId="{0B621132-940C-2A28-B1B9-268F1665FE82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15" creationId="{AC691473-5EC6-2E29-C96D-14661F24FEBA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16" creationId="{E7C5542C-EDB3-EBE4-EE92-B2D253609CC0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17" creationId="{CD636F6E-10C4-E4C4-0D68-2E5318B0AF6A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18" creationId="{443AB5D8-443C-CED1-9378-85F9C13541AA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19" creationId="{3E46E3B8-1E86-1742-F8C4-5FB93FE62EB3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20" creationId="{DB506972-CD24-F4AD-3480-313E87ABA0B9}"/>
          </ac:spMkLst>
        </pc:spChg>
        <pc:spChg chg="add mod">
          <ac:chgData name="Abhishek Ojha" userId="253db238782fe597" providerId="LiveId" clId="{48F4AE56-B12B-4ED2-BA64-EE21170A5BFA}" dt="2023-06-24T09:21:26.008" v="5914" actId="1076"/>
          <ac:spMkLst>
            <pc:docMk/>
            <pc:sldMk cId="3285560308" sldId="258"/>
            <ac:spMk id="22" creationId="{DB64F0C2-85E0-99C6-FC59-96AFBB83CE2B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23" creationId="{AABDDD6A-A8FD-5819-F468-65DEA6E4A3EE}"/>
          </ac:spMkLst>
        </pc:spChg>
        <pc:spChg chg="add mod">
          <ac:chgData name="Abhishek Ojha" userId="253db238782fe597" providerId="LiveId" clId="{48F4AE56-B12B-4ED2-BA64-EE21170A5BFA}" dt="2023-06-27T05:51:01.657" v="7148" actId="20577"/>
          <ac:spMkLst>
            <pc:docMk/>
            <pc:sldMk cId="3285560308" sldId="258"/>
            <ac:spMk id="25" creationId="{6B9DDDE1-40E5-CF4F-2DC0-53D2F3C542FA}"/>
          </ac:spMkLst>
        </pc:spChg>
        <pc:spChg chg="mod">
          <ac:chgData name="Abhishek Ojha" userId="253db238782fe597" providerId="LiveId" clId="{48F4AE56-B12B-4ED2-BA64-EE21170A5BFA}" dt="2023-06-26T07:34:29.178" v="6613" actId="1036"/>
          <ac:spMkLst>
            <pc:docMk/>
            <pc:sldMk cId="3285560308" sldId="258"/>
            <ac:spMk id="26" creationId="{88F0CFF5-8304-7377-2CF1-F63938465144}"/>
          </ac:spMkLst>
        </pc:spChg>
        <pc:spChg chg="mod">
          <ac:chgData name="Abhishek Ojha" userId="253db238782fe597" providerId="LiveId" clId="{48F4AE56-B12B-4ED2-BA64-EE21170A5BFA}" dt="2023-06-26T07:35:03.925" v="6668" actId="1037"/>
          <ac:spMkLst>
            <pc:docMk/>
            <pc:sldMk cId="3285560308" sldId="258"/>
            <ac:spMk id="27" creationId="{790480EA-74ED-52E2-0CA3-DFF7BBD86751}"/>
          </ac:spMkLst>
        </pc:spChg>
        <pc:spChg chg="add del mod">
          <ac:chgData name="Abhishek Ojha" userId="253db238782fe597" providerId="LiveId" clId="{48F4AE56-B12B-4ED2-BA64-EE21170A5BFA}" dt="2023-06-27T05:50:11.847" v="7128" actId="478"/>
          <ac:spMkLst>
            <pc:docMk/>
            <pc:sldMk cId="3285560308" sldId="258"/>
            <ac:spMk id="28" creationId="{9E9499A0-53BF-72B2-F025-77072356CF5A}"/>
          </ac:spMkLst>
        </pc:spChg>
        <pc:spChg chg="add mod">
          <ac:chgData name="Abhishek Ojha" userId="253db238782fe597" providerId="LiveId" clId="{48F4AE56-B12B-4ED2-BA64-EE21170A5BFA}" dt="2023-06-27T05:39:24.459" v="6732" actId="571"/>
          <ac:spMkLst>
            <pc:docMk/>
            <pc:sldMk cId="3285560308" sldId="258"/>
            <ac:spMk id="29" creationId="{878E2D39-8254-1966-C26C-75CBE1F80846}"/>
          </ac:spMkLst>
        </pc:spChg>
        <pc:spChg chg="add mod">
          <ac:chgData name="Abhishek Ojha" userId="253db238782fe597" providerId="LiveId" clId="{48F4AE56-B12B-4ED2-BA64-EE21170A5BFA}" dt="2023-06-27T05:39:24.459" v="6732" actId="571"/>
          <ac:spMkLst>
            <pc:docMk/>
            <pc:sldMk cId="3285560308" sldId="258"/>
            <ac:spMk id="30" creationId="{767A9524-B6BB-D51C-1F44-993E49CA14FF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31" creationId="{8206462E-E718-230E-26BA-DFA430A9AB44}"/>
          </ac:spMkLst>
        </pc:spChg>
        <pc:spChg chg="add mod">
          <ac:chgData name="Abhishek Ojha" userId="253db238782fe597" providerId="LiveId" clId="{48F4AE56-B12B-4ED2-BA64-EE21170A5BFA}" dt="2023-06-27T05:39:32.783" v="6736" actId="571"/>
          <ac:spMkLst>
            <pc:docMk/>
            <pc:sldMk cId="3285560308" sldId="258"/>
            <ac:spMk id="31" creationId="{97DEB61A-696C-3215-0D55-2B8A34BD634B}"/>
          </ac:spMkLst>
        </pc:spChg>
        <pc:spChg chg="add mod">
          <ac:chgData name="Abhishek Ojha" userId="253db238782fe597" providerId="LiveId" clId="{48F4AE56-B12B-4ED2-BA64-EE21170A5BFA}" dt="2023-06-27T05:39:32.783" v="6736" actId="571"/>
          <ac:spMkLst>
            <pc:docMk/>
            <pc:sldMk cId="3285560308" sldId="258"/>
            <ac:spMk id="32" creationId="{F0986701-261F-27D5-DA69-711E1333ECDD}"/>
          </ac:spMkLst>
        </pc:spChg>
        <pc:spChg chg="add mod">
          <ac:chgData name="Abhishek Ojha" userId="253db238782fe597" providerId="LiveId" clId="{48F4AE56-B12B-4ED2-BA64-EE21170A5BFA}" dt="2023-06-27T05:39:32.783" v="6736" actId="571"/>
          <ac:spMkLst>
            <pc:docMk/>
            <pc:sldMk cId="3285560308" sldId="258"/>
            <ac:spMk id="33" creationId="{47E8D2B9-073D-7C08-9602-873CBECCD38F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33" creationId="{7A2429C5-69A6-8E45-56E7-CACEC03A5A71}"/>
          </ac:spMkLst>
        </pc:spChg>
        <pc:spChg chg="add mod">
          <ac:chgData name="Abhishek Ojha" userId="253db238782fe597" providerId="LiveId" clId="{48F4AE56-B12B-4ED2-BA64-EE21170A5BFA}" dt="2023-06-27T05:39:31.918" v="6735" actId="571"/>
          <ac:spMkLst>
            <pc:docMk/>
            <pc:sldMk cId="3285560308" sldId="258"/>
            <ac:spMk id="34" creationId="{637A1FAA-3CAF-D054-81E6-E90716110EC3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34" creationId="{EAE5A3B9-4E89-C47F-CE19-87F5A5724FC2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35" creationId="{B6D48079-E639-77A4-FA7F-618173DC1539}"/>
          </ac:spMkLst>
        </pc:spChg>
        <pc:spChg chg="add mod">
          <ac:chgData name="Abhishek Ojha" userId="253db238782fe597" providerId="LiveId" clId="{48F4AE56-B12B-4ED2-BA64-EE21170A5BFA}" dt="2023-06-27T05:39:31.918" v="6735" actId="571"/>
          <ac:spMkLst>
            <pc:docMk/>
            <pc:sldMk cId="3285560308" sldId="258"/>
            <ac:spMk id="35" creationId="{F50B06D6-2E5B-8DC8-97BA-1E0A50800F92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36" creationId="{9164428E-6A12-6E07-7838-4BF95389566B}"/>
          </ac:spMkLst>
        </pc:spChg>
        <pc:spChg chg="add mod">
          <ac:chgData name="Abhishek Ojha" userId="253db238782fe597" providerId="LiveId" clId="{48F4AE56-B12B-4ED2-BA64-EE21170A5BFA}" dt="2023-06-27T05:39:31.918" v="6735" actId="571"/>
          <ac:spMkLst>
            <pc:docMk/>
            <pc:sldMk cId="3285560308" sldId="258"/>
            <ac:spMk id="36" creationId="{E1DEFD5D-235A-D1C0-3013-E60852394803}"/>
          </ac:spMkLst>
        </pc:spChg>
        <pc:spChg chg="add mod">
          <ac:chgData name="Abhishek Ojha" userId="253db238782fe597" providerId="LiveId" clId="{48F4AE56-B12B-4ED2-BA64-EE21170A5BFA}" dt="2023-06-27T05:39:31.918" v="6735" actId="571"/>
          <ac:spMkLst>
            <pc:docMk/>
            <pc:sldMk cId="3285560308" sldId="258"/>
            <ac:spMk id="37" creationId="{8F0E1917-AF8D-8B22-EA5C-0A0DC8B8882D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37" creationId="{FD746796-B098-E38B-CF7B-313F70EA50DC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38" creationId="{FF38D9A2-9D41-52C6-579D-79007CCD201B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39" creationId="{98427908-CE39-4ACF-0CEE-E69884A2779E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40" creationId="{08F7FBBB-43F8-4463-A28C-5415810BCA5D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40" creationId="{36B8628C-D69A-8FA9-58B9-6CF630FC8D13}"/>
          </ac:spMkLst>
        </pc:spChg>
        <pc:spChg chg="add mod">
          <ac:chgData name="Abhishek Ojha" userId="253db238782fe597" providerId="LiveId" clId="{48F4AE56-B12B-4ED2-BA64-EE21170A5BFA}" dt="2023-06-27T05:39:38.763" v="6738" actId="571"/>
          <ac:spMkLst>
            <pc:docMk/>
            <pc:sldMk cId="3285560308" sldId="258"/>
            <ac:spMk id="41" creationId="{3314CDE1-4B47-7405-D368-9676347E1AF5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42" creationId="{F55AA708-0EEA-704C-FD39-2AC62DDCB95D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43" creationId="{2E6FB40B-9FBB-45D4-2AB9-0D8D0D7883C2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44" creationId="{22A9BC21-19B6-D262-218E-3DB4BA14B833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44" creationId="{4E4DC8DA-B521-D4F8-C82B-3BA9F98B502D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45" creationId="{01EFC80F-74CE-CCC0-1173-F04ACEB9EB7F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45" creationId="{6A50B398-69E3-5554-23FF-C9D00C966A94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46" creationId="{35531DCB-0D7A-8F27-A46B-67844B0BC040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46" creationId="{F9638215-218C-D5C5-7B8E-DBE449193A47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47" creationId="{77DB0D71-6755-878E-D9EA-34244758C395}"/>
          </ac:spMkLst>
        </pc:spChg>
        <pc:spChg chg="mod">
          <ac:chgData name="Abhishek Ojha" userId="253db238782fe597" providerId="LiveId" clId="{48F4AE56-B12B-4ED2-BA64-EE21170A5BFA}" dt="2023-06-26T07:35:48.018" v="6696" actId="571"/>
          <ac:spMkLst>
            <pc:docMk/>
            <pc:sldMk cId="3285560308" sldId="258"/>
            <ac:spMk id="47" creationId="{9D2A7641-7796-0456-4D86-F836FD7C397D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48" creationId="{EA9E0D8E-C637-6CFE-FF40-DC042938C906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49" creationId="{59C86967-7097-88C0-DB7B-BA6070DDC31D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50" creationId="{E3042180-5290-E769-425E-4AFC0602E8FA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51" creationId="{AFDCA911-4A1D-C313-F002-E355E876EB47}"/>
          </ac:spMkLst>
        </pc:spChg>
        <pc:spChg chg="mod">
          <ac:chgData name="Abhishek Ojha" userId="253db238782fe597" providerId="LiveId" clId="{48F4AE56-B12B-4ED2-BA64-EE21170A5BFA}" dt="2023-06-27T05:41:29.231" v="6740"/>
          <ac:spMkLst>
            <pc:docMk/>
            <pc:sldMk cId="3285560308" sldId="258"/>
            <ac:spMk id="52" creationId="{890F2DE0-38CD-708B-4B8A-080C6286BE3A}"/>
          </ac:spMkLst>
        </pc:spChg>
        <pc:grpChg chg="add del mod">
          <ac:chgData name="Abhishek Ojha" userId="253db238782fe597" providerId="LiveId" clId="{48F4AE56-B12B-4ED2-BA64-EE21170A5BFA}" dt="2023-06-27T05:50:08.101" v="7127" actId="478"/>
          <ac:grpSpMkLst>
            <pc:docMk/>
            <pc:sldMk cId="3285560308" sldId="258"/>
            <ac:grpSpMk id="2" creationId="{21B6A946-6500-BE53-AB4A-A7A9E5B78699}"/>
          </ac:grpSpMkLst>
        </pc:grpChg>
        <pc:grpChg chg="add mod">
          <ac:chgData name="Abhishek Ojha" userId="253db238782fe597" providerId="LiveId" clId="{48F4AE56-B12B-4ED2-BA64-EE21170A5BFA}" dt="2023-06-24T09:08:26.800" v="5029" actId="164"/>
          <ac:grpSpMkLst>
            <pc:docMk/>
            <pc:sldMk cId="3285560308" sldId="258"/>
            <ac:grpSpMk id="9" creationId="{496A3F53-201C-F1C4-BC44-416DFA831225}"/>
          </ac:grpSpMkLst>
        </pc:grpChg>
        <pc:grpChg chg="add mod">
          <ac:chgData name="Abhishek Ojha" userId="253db238782fe597" providerId="LiveId" clId="{48F4AE56-B12B-4ED2-BA64-EE21170A5BFA}" dt="2023-06-26T07:35:57.581" v="6725" actId="1036"/>
          <ac:grpSpMkLst>
            <pc:docMk/>
            <pc:sldMk cId="3285560308" sldId="258"/>
            <ac:grpSpMk id="12" creationId="{BEDA187F-99DF-4538-53C8-7CBF1FF02B32}"/>
          </ac:grpSpMkLst>
        </pc:grpChg>
        <pc:grpChg chg="add mod">
          <ac:chgData name="Abhishek Ojha" userId="253db238782fe597" providerId="LiveId" clId="{48F4AE56-B12B-4ED2-BA64-EE21170A5BFA}" dt="2023-06-27T05:39:38.763" v="6738" actId="571"/>
          <ac:grpSpMkLst>
            <pc:docMk/>
            <pc:sldMk cId="3285560308" sldId="258"/>
            <ac:grpSpMk id="21" creationId="{759E8CDD-827D-CF7A-63A4-5842C6CCB322}"/>
          </ac:grpSpMkLst>
        </pc:grpChg>
        <pc:grpChg chg="add mod">
          <ac:chgData name="Abhishek Ojha" userId="253db238782fe597" providerId="LiveId" clId="{48F4AE56-B12B-4ED2-BA64-EE21170A5BFA}" dt="2023-06-27T05:39:38.763" v="6738" actId="571"/>
          <ac:grpSpMkLst>
            <pc:docMk/>
            <pc:sldMk cId="3285560308" sldId="258"/>
            <ac:grpSpMk id="24" creationId="{01075C5F-843F-CBF6-74BA-C8A21433D34C}"/>
          </ac:grpSpMkLst>
        </pc:grpChg>
        <pc:grpChg chg="add mod">
          <ac:chgData name="Abhishek Ojha" userId="253db238782fe597" providerId="LiveId" clId="{48F4AE56-B12B-4ED2-BA64-EE21170A5BFA}" dt="2023-06-26T07:35:48.018" v="6696" actId="571"/>
          <ac:grpSpMkLst>
            <pc:docMk/>
            <pc:sldMk cId="3285560308" sldId="258"/>
            <ac:grpSpMk id="29" creationId="{DA7FA12D-83EE-0B2C-14D8-DA9D4A1EDEBD}"/>
          </ac:grpSpMkLst>
        </pc:grpChg>
        <pc:grpChg chg="mod">
          <ac:chgData name="Abhishek Ojha" userId="253db238782fe597" providerId="LiveId" clId="{48F4AE56-B12B-4ED2-BA64-EE21170A5BFA}" dt="2023-06-26T07:35:48.018" v="6696" actId="571"/>
          <ac:grpSpMkLst>
            <pc:docMk/>
            <pc:sldMk cId="3285560308" sldId="258"/>
            <ac:grpSpMk id="30" creationId="{B0601478-BB80-8D22-BE1C-93060953D68C}"/>
          </ac:grpSpMkLst>
        </pc:grpChg>
        <pc:grpChg chg="add mod">
          <ac:chgData name="Abhishek Ojha" userId="253db238782fe597" providerId="LiveId" clId="{48F4AE56-B12B-4ED2-BA64-EE21170A5BFA}" dt="2023-06-26T07:35:48.018" v="6696" actId="571"/>
          <ac:grpSpMkLst>
            <pc:docMk/>
            <pc:sldMk cId="3285560308" sldId="258"/>
            <ac:grpSpMk id="38" creationId="{19DFC1D9-868A-AB7E-DB1A-7BE6E89263E9}"/>
          </ac:grpSpMkLst>
        </pc:grpChg>
        <pc:grpChg chg="mod">
          <ac:chgData name="Abhishek Ojha" userId="253db238782fe597" providerId="LiveId" clId="{48F4AE56-B12B-4ED2-BA64-EE21170A5BFA}" dt="2023-06-26T07:35:48.018" v="6696" actId="571"/>
          <ac:grpSpMkLst>
            <pc:docMk/>
            <pc:sldMk cId="3285560308" sldId="258"/>
            <ac:grpSpMk id="39" creationId="{881B7090-4A5D-3715-396D-289DC6F0F5D1}"/>
          </ac:grpSpMkLst>
        </pc:grpChg>
        <pc:grpChg chg="add del mod">
          <ac:chgData name="Abhishek Ojha" userId="253db238782fe597" providerId="LiveId" clId="{48F4AE56-B12B-4ED2-BA64-EE21170A5BFA}" dt="2023-06-27T05:47:36.392" v="6882" actId="478"/>
          <ac:grpSpMkLst>
            <pc:docMk/>
            <pc:sldMk cId="3285560308" sldId="258"/>
            <ac:grpSpMk id="42" creationId="{0AE5C151-6729-EE03-A097-4E4FE5A3FF90}"/>
          </ac:grpSpMkLst>
        </pc:grpChg>
        <pc:graphicFrameChg chg="add del mod">
          <ac:chgData name="Abhishek Ojha" userId="253db238782fe597" providerId="LiveId" clId="{48F4AE56-B12B-4ED2-BA64-EE21170A5BFA}" dt="2023-06-24T09:01:32.447" v="4696" actId="478"/>
          <ac:graphicFrameMkLst>
            <pc:docMk/>
            <pc:sldMk cId="3285560308" sldId="258"/>
            <ac:graphicFrameMk id="2" creationId="{63DB9E4E-EACE-E6C9-11FB-C50EB513202D}"/>
          </ac:graphicFrameMkLst>
        </pc:graphicFrameChg>
        <pc:graphicFrameChg chg="add mod">
          <ac:chgData name="Abhishek Ojha" userId="253db238782fe597" providerId="LiveId" clId="{48F4AE56-B12B-4ED2-BA64-EE21170A5BFA}" dt="2023-06-24T09:06:52.253" v="4963" actId="164"/>
          <ac:graphicFrameMkLst>
            <pc:docMk/>
            <pc:sldMk cId="3285560308" sldId="258"/>
            <ac:graphicFrameMk id="3" creationId="{63DB9E4E-EACE-E6C9-11FB-C50EB513202D}"/>
          </ac:graphicFrameMkLst>
        </pc:graphicFrameChg>
        <pc:graphicFrameChg chg="add del mod">
          <ac:chgData name="Abhishek Ojha" userId="253db238782fe597" providerId="LiveId" clId="{48F4AE56-B12B-4ED2-BA64-EE21170A5BFA}" dt="2023-06-24T09:19:13.128" v="5500" actId="478"/>
          <ac:graphicFrameMkLst>
            <pc:docMk/>
            <pc:sldMk cId="3285560308" sldId="258"/>
            <ac:graphicFrameMk id="13" creationId="{90197EB3-1502-E3E7-970D-827030999B96}"/>
          </ac:graphicFrameMkLst>
        </pc:graphicFrameChg>
        <pc:graphicFrameChg chg="add mod">
          <ac:chgData name="Abhishek Ojha" userId="253db238782fe597" providerId="LiveId" clId="{48F4AE56-B12B-4ED2-BA64-EE21170A5BFA}" dt="2023-06-27T05:39:38.763" v="6738" actId="571"/>
          <ac:graphicFrameMkLst>
            <pc:docMk/>
            <pc:sldMk cId="3285560308" sldId="258"/>
            <ac:graphicFrameMk id="14" creationId="{90197EB3-1502-E3E7-970D-827030999B96}"/>
          </ac:graphicFrameMkLst>
        </pc:graphicFrameChg>
        <pc:graphicFrameChg chg="mod">
          <ac:chgData name="Abhishek Ojha" userId="253db238782fe597" providerId="LiveId" clId="{48F4AE56-B12B-4ED2-BA64-EE21170A5BFA}" dt="2023-06-26T07:35:48.018" v="6696" actId="571"/>
          <ac:graphicFrameMkLst>
            <pc:docMk/>
            <pc:sldMk cId="3285560308" sldId="258"/>
            <ac:graphicFrameMk id="32" creationId="{D5F31E83-002D-AB1E-7269-2551AAC6C57F}"/>
          </ac:graphicFrameMkLst>
        </pc:graphicFrameChg>
        <pc:graphicFrameChg chg="mod">
          <ac:chgData name="Abhishek Ojha" userId="253db238782fe597" providerId="LiveId" clId="{48F4AE56-B12B-4ED2-BA64-EE21170A5BFA}" dt="2023-06-26T07:35:48.018" v="6696" actId="571"/>
          <ac:graphicFrameMkLst>
            <pc:docMk/>
            <pc:sldMk cId="3285560308" sldId="258"/>
            <ac:graphicFrameMk id="41" creationId="{C18DF081-78C1-E018-6844-A3D10560846A}"/>
          </ac:graphicFrameMkLst>
        </pc:graphicFrameChg>
        <pc:graphicFrameChg chg="mod">
          <ac:chgData name="Abhishek Ojha" userId="253db238782fe597" providerId="LiveId" clId="{48F4AE56-B12B-4ED2-BA64-EE21170A5BFA}" dt="2023-06-27T05:41:29.231" v="6740"/>
          <ac:graphicFrameMkLst>
            <pc:docMk/>
            <pc:sldMk cId="3285560308" sldId="258"/>
            <ac:graphicFrameMk id="43" creationId="{5736C3B6-D6E7-24DF-8229-AC75CE3839CD}"/>
          </ac:graphicFrameMkLst>
        </pc:graphicFrameChg>
        <pc:picChg chg="mod">
          <ac:chgData name="Abhishek Ojha" userId="253db238782fe597" providerId="LiveId" clId="{48F4AE56-B12B-4ED2-BA64-EE21170A5BFA}" dt="2023-06-26T07:32:52.458" v="6394"/>
          <ac:picMkLst>
            <pc:docMk/>
            <pc:sldMk cId="3285560308" sldId="258"/>
            <ac:picMk id="10" creationId="{10DF0EC4-188D-E2B2-DEEC-519EC950015E}"/>
          </ac:picMkLst>
        </pc:picChg>
      </pc:sldChg>
      <pc:sldChg chg="addSp delSp modSp new mod ord">
        <pc:chgData name="Abhishek Ojha" userId="253db238782fe597" providerId="LiveId" clId="{48F4AE56-B12B-4ED2-BA64-EE21170A5BFA}" dt="2023-06-27T05:50:56.203" v="7146" actId="20577"/>
        <pc:sldMkLst>
          <pc:docMk/>
          <pc:sldMk cId="3884602200" sldId="259"/>
        </pc:sldMkLst>
        <pc:spChg chg="del">
          <ac:chgData name="Abhishek Ojha" userId="253db238782fe597" providerId="LiveId" clId="{48F4AE56-B12B-4ED2-BA64-EE21170A5BFA}" dt="2023-06-26T07:20:32.989" v="5971" actId="478"/>
          <ac:spMkLst>
            <pc:docMk/>
            <pc:sldMk cId="3884602200" sldId="259"/>
            <ac:spMk id="2" creationId="{9F5367AB-A139-F375-FDA0-5E163292DC83}"/>
          </ac:spMkLst>
        </pc:spChg>
        <pc:spChg chg="del">
          <ac:chgData name="Abhishek Ojha" userId="253db238782fe597" providerId="LiveId" clId="{48F4AE56-B12B-4ED2-BA64-EE21170A5BFA}" dt="2023-06-26T07:20:32.989" v="5971" actId="478"/>
          <ac:spMkLst>
            <pc:docMk/>
            <pc:sldMk cId="3884602200" sldId="259"/>
            <ac:spMk id="3" creationId="{13B155C0-3413-247C-D0B8-748418522895}"/>
          </ac:spMkLst>
        </pc:spChg>
        <pc:spChg chg="mod">
          <ac:chgData name="Abhishek Ojha" userId="253db238782fe597" providerId="LiveId" clId="{48F4AE56-B12B-4ED2-BA64-EE21170A5BFA}" dt="2023-06-27T05:49:41.791" v="7085" actId="14100"/>
          <ac:spMkLst>
            <pc:docMk/>
            <pc:sldMk cId="3884602200" sldId="259"/>
            <ac:spMk id="4" creationId="{0A301908-6B8F-1B0D-5E6D-B6B7C1044C71}"/>
          </ac:spMkLst>
        </pc:spChg>
        <pc:spChg chg="add mod">
          <ac:chgData name="Abhishek Ojha" userId="253db238782fe597" providerId="LiveId" clId="{48F4AE56-B12B-4ED2-BA64-EE21170A5BFA}" dt="2023-06-26T07:23:17.758" v="6243" actId="164"/>
          <ac:spMkLst>
            <pc:docMk/>
            <pc:sldMk cId="3884602200" sldId="259"/>
            <ac:spMk id="6" creationId="{148EB64A-98C9-98F0-84F5-77820C2D31C0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6" creationId="{1B28F190-6A75-9882-FC42-96B3039B1C15}"/>
          </ac:spMkLst>
        </pc:spChg>
        <pc:spChg chg="add mod">
          <ac:chgData name="Abhishek Ojha" userId="253db238782fe597" providerId="LiveId" clId="{48F4AE56-B12B-4ED2-BA64-EE21170A5BFA}" dt="2023-06-26T07:23:17.758" v="6243" actId="164"/>
          <ac:spMkLst>
            <pc:docMk/>
            <pc:sldMk cId="3884602200" sldId="259"/>
            <ac:spMk id="7" creationId="{58213564-21A8-398A-15D5-45A4458875F5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7" creationId="{5E4CF2BF-5FAF-685E-8EBA-BAEE95C059D7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8" creationId="{04A509DC-B165-F683-C24A-80E515858F4C}"/>
          </ac:spMkLst>
        </pc:spChg>
        <pc:spChg chg="add mod">
          <ac:chgData name="Abhishek Ojha" userId="253db238782fe597" providerId="LiveId" clId="{48F4AE56-B12B-4ED2-BA64-EE21170A5BFA}" dt="2023-06-26T07:23:17.758" v="6243" actId="164"/>
          <ac:spMkLst>
            <pc:docMk/>
            <pc:sldMk cId="3884602200" sldId="259"/>
            <ac:spMk id="8" creationId="{231777CC-DEF3-7AC3-17E3-FDF005290897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9" creationId="{9EC534AE-213C-3CE4-6567-0B4F43A04389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10" creationId="{7F4E1F8D-06DB-94F2-C781-BF8FE8175DB6}"/>
          </ac:spMkLst>
        </pc:spChg>
        <pc:spChg chg="add del mod">
          <ac:chgData name="Abhishek Ojha" userId="253db238782fe597" providerId="LiveId" clId="{48F4AE56-B12B-4ED2-BA64-EE21170A5BFA}" dt="2023-06-26T07:36:10.593" v="6726" actId="478"/>
          <ac:spMkLst>
            <pc:docMk/>
            <pc:sldMk cId="3884602200" sldId="259"/>
            <ac:spMk id="11" creationId="{50F4E4F6-A8DB-F449-F6F7-CFF96D9465A1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11" creationId="{A9810FE0-2FD8-A25D-BFF9-91C80213F8AF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12" creationId="{CAD1B4BF-8FC7-99FC-2EE6-21D58217DD24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13" creationId="{7F81B67D-3F83-066B-5851-5F81285B7B01}"/>
          </ac:spMkLst>
        </pc:spChg>
        <pc:spChg chg="mod">
          <ac:chgData name="Abhishek Ojha" userId="253db238782fe597" providerId="LiveId" clId="{48F4AE56-B12B-4ED2-BA64-EE21170A5BFA}" dt="2023-06-26T07:32:28.791" v="6362" actId="571"/>
          <ac:spMkLst>
            <pc:docMk/>
            <pc:sldMk cId="3884602200" sldId="259"/>
            <ac:spMk id="14" creationId="{45F63E42-BD64-7413-9858-074D614849C6}"/>
          </ac:spMkLst>
        </pc:spChg>
        <pc:spChg chg="mod">
          <ac:chgData name="Abhishek Ojha" userId="253db238782fe597" providerId="LiveId" clId="{48F4AE56-B12B-4ED2-BA64-EE21170A5BFA}" dt="2023-06-27T05:47:39.427" v="6883"/>
          <ac:spMkLst>
            <pc:docMk/>
            <pc:sldMk cId="3884602200" sldId="259"/>
            <ac:spMk id="14" creationId="{8E96A0F6-A9A1-99DF-77A5-D0E4BFAA0549}"/>
          </ac:spMkLst>
        </pc:spChg>
        <pc:spChg chg="mod">
          <ac:chgData name="Abhishek Ojha" userId="253db238782fe597" providerId="LiveId" clId="{48F4AE56-B12B-4ED2-BA64-EE21170A5BFA}" dt="2023-06-26T07:32:28.791" v="6362" actId="571"/>
          <ac:spMkLst>
            <pc:docMk/>
            <pc:sldMk cId="3884602200" sldId="259"/>
            <ac:spMk id="15" creationId="{B5FF81D7-8905-DFEC-1F21-676326ABD231}"/>
          </ac:spMkLst>
        </pc:spChg>
        <pc:spChg chg="mod">
          <ac:chgData name="Abhishek Ojha" userId="253db238782fe597" providerId="LiveId" clId="{48F4AE56-B12B-4ED2-BA64-EE21170A5BFA}" dt="2023-06-26T07:32:28.791" v="6362" actId="571"/>
          <ac:spMkLst>
            <pc:docMk/>
            <pc:sldMk cId="3884602200" sldId="259"/>
            <ac:spMk id="16" creationId="{7C18BFDE-5A6D-ACFF-9B7B-4D03C3836B71}"/>
          </ac:spMkLst>
        </pc:spChg>
        <pc:spChg chg="mod">
          <ac:chgData name="Abhishek Ojha" userId="253db238782fe597" providerId="LiveId" clId="{48F4AE56-B12B-4ED2-BA64-EE21170A5BFA}" dt="2023-06-27T05:49:13.115" v="6888"/>
          <ac:spMkLst>
            <pc:docMk/>
            <pc:sldMk cId="3884602200" sldId="259"/>
            <ac:spMk id="17" creationId="{EAA4BBD4-8A55-2798-80FC-D39064D247CE}"/>
          </ac:spMkLst>
        </pc:spChg>
        <pc:spChg chg="add del mod">
          <ac:chgData name="Abhishek Ojha" userId="253db238782fe597" providerId="LiveId" clId="{48F4AE56-B12B-4ED2-BA64-EE21170A5BFA}" dt="2023-06-26T07:32:34.952" v="6363" actId="478"/>
          <ac:spMkLst>
            <pc:docMk/>
            <pc:sldMk cId="3884602200" sldId="259"/>
            <ac:spMk id="17" creationId="{FF9F9909-586E-3B28-BD27-CE2D7BF993F9}"/>
          </ac:spMkLst>
        </pc:spChg>
        <pc:spChg chg="mod">
          <ac:chgData name="Abhishek Ojha" userId="253db238782fe597" providerId="LiveId" clId="{48F4AE56-B12B-4ED2-BA64-EE21170A5BFA}" dt="2023-06-27T05:49:13.115" v="6888"/>
          <ac:spMkLst>
            <pc:docMk/>
            <pc:sldMk cId="3884602200" sldId="259"/>
            <ac:spMk id="18" creationId="{58D1B680-CCDE-4529-5E44-5A7BCFB9F9DD}"/>
          </ac:spMkLst>
        </pc:spChg>
        <pc:spChg chg="mod">
          <ac:chgData name="Abhishek Ojha" userId="253db238782fe597" providerId="LiveId" clId="{48F4AE56-B12B-4ED2-BA64-EE21170A5BFA}" dt="2023-06-27T05:49:13.115" v="6888"/>
          <ac:spMkLst>
            <pc:docMk/>
            <pc:sldMk cId="3884602200" sldId="259"/>
            <ac:spMk id="19" creationId="{40B6B051-9744-009B-C70C-13AE98456456}"/>
          </ac:spMkLst>
        </pc:spChg>
        <pc:spChg chg="add mod">
          <ac:chgData name="Abhishek Ojha" userId="253db238782fe597" providerId="LiveId" clId="{48F4AE56-B12B-4ED2-BA64-EE21170A5BFA}" dt="2023-06-27T05:50:43.250" v="7142" actId="1036"/>
          <ac:spMkLst>
            <pc:docMk/>
            <pc:sldMk cId="3884602200" sldId="259"/>
            <ac:spMk id="20" creationId="{02ADB594-6E43-215D-1C08-67511A7A7B8F}"/>
          </ac:spMkLst>
        </pc:spChg>
        <pc:spChg chg="add mod">
          <ac:chgData name="Abhishek Ojha" userId="253db238782fe597" providerId="LiveId" clId="{48F4AE56-B12B-4ED2-BA64-EE21170A5BFA}" dt="2023-06-27T05:50:56.203" v="7146" actId="20577"/>
          <ac:spMkLst>
            <pc:docMk/>
            <pc:sldMk cId="3884602200" sldId="259"/>
            <ac:spMk id="21" creationId="{31285BE0-5D66-6B87-31BB-09CDD69DBA4B}"/>
          </ac:spMkLst>
        </pc:spChg>
        <pc:grpChg chg="add mod">
          <ac:chgData name="Abhishek Ojha" userId="253db238782fe597" providerId="LiveId" clId="{48F4AE56-B12B-4ED2-BA64-EE21170A5BFA}" dt="2023-06-27T05:50:43.250" v="7142" actId="1036"/>
          <ac:grpSpMkLst>
            <pc:docMk/>
            <pc:sldMk cId="3884602200" sldId="259"/>
            <ac:grpSpMk id="2" creationId="{EF46A310-6A49-8EF8-D8D9-170B48D2D5E3}"/>
          </ac:grpSpMkLst>
        </pc:grpChg>
        <pc:grpChg chg="mod">
          <ac:chgData name="Abhishek Ojha" userId="253db238782fe597" providerId="LiveId" clId="{48F4AE56-B12B-4ED2-BA64-EE21170A5BFA}" dt="2023-06-27T05:47:39.427" v="6883"/>
          <ac:grpSpMkLst>
            <pc:docMk/>
            <pc:sldMk cId="3884602200" sldId="259"/>
            <ac:grpSpMk id="3" creationId="{077B10F1-198D-F799-0B7B-4182158E8144}"/>
          </ac:grpSpMkLst>
        </pc:grpChg>
        <pc:grpChg chg="add del mod">
          <ac:chgData name="Abhishek Ojha" userId="253db238782fe597" providerId="LiveId" clId="{48F4AE56-B12B-4ED2-BA64-EE21170A5BFA}" dt="2023-06-26T07:36:10.593" v="6726" actId="478"/>
          <ac:grpSpMkLst>
            <pc:docMk/>
            <pc:sldMk cId="3884602200" sldId="259"/>
            <ac:grpSpMk id="9" creationId="{212DE92D-F785-E65C-690C-ACDBEF9285B2}"/>
          </ac:grpSpMkLst>
        </pc:grpChg>
        <pc:grpChg chg="add del mod">
          <ac:chgData name="Abhishek Ojha" userId="253db238782fe597" providerId="LiveId" clId="{48F4AE56-B12B-4ED2-BA64-EE21170A5BFA}" dt="2023-06-26T07:32:40.183" v="6393" actId="478"/>
          <ac:grpSpMkLst>
            <pc:docMk/>
            <pc:sldMk cId="3884602200" sldId="259"/>
            <ac:grpSpMk id="12" creationId="{F7BA9F5A-A228-FF35-2E04-6FD23C6F87FD}"/>
          </ac:grpSpMkLst>
        </pc:grpChg>
        <pc:grpChg chg="add mod">
          <ac:chgData name="Abhishek Ojha" userId="253db238782fe597" providerId="LiveId" clId="{48F4AE56-B12B-4ED2-BA64-EE21170A5BFA}" dt="2023-06-27T05:50:43.250" v="7142" actId="1036"/>
          <ac:grpSpMkLst>
            <pc:docMk/>
            <pc:sldMk cId="3884602200" sldId="259"/>
            <ac:grpSpMk id="15" creationId="{CF47992E-9BC2-A4CE-23D9-6FDA4C7B7001}"/>
          </ac:grpSpMkLst>
        </pc:grpChg>
        <pc:graphicFrameChg chg="mod">
          <ac:chgData name="Abhishek Ojha" userId="253db238782fe597" providerId="LiveId" clId="{48F4AE56-B12B-4ED2-BA64-EE21170A5BFA}" dt="2023-06-27T05:47:39.427" v="6883"/>
          <ac:graphicFrameMkLst>
            <pc:docMk/>
            <pc:sldMk cId="3884602200" sldId="259"/>
            <ac:graphicFrameMk id="5" creationId="{1DC72466-AB82-0949-BB3E-10C1732D1F8B}"/>
          </ac:graphicFrameMkLst>
        </pc:graphicFrameChg>
        <pc:picChg chg="add mod modCrop">
          <ac:chgData name="Abhishek Ojha" userId="253db238782fe597" providerId="LiveId" clId="{48F4AE56-B12B-4ED2-BA64-EE21170A5BFA}" dt="2023-06-26T07:23:17.758" v="6243" actId="164"/>
          <ac:picMkLst>
            <pc:docMk/>
            <pc:sldMk cId="3884602200" sldId="259"/>
            <ac:picMk id="5" creationId="{712DFC58-FEDC-275D-EFD4-E777B3623195}"/>
          </ac:picMkLst>
        </pc:picChg>
        <pc:picChg chg="mod">
          <ac:chgData name="Abhishek Ojha" userId="253db238782fe597" providerId="LiveId" clId="{48F4AE56-B12B-4ED2-BA64-EE21170A5BFA}" dt="2023-06-26T07:32:28.791" v="6362" actId="571"/>
          <ac:picMkLst>
            <pc:docMk/>
            <pc:sldMk cId="3884602200" sldId="259"/>
            <ac:picMk id="13" creationId="{4C5C4C75-44F1-6EC0-EC8D-77E2A6958677}"/>
          </ac:picMkLst>
        </pc:picChg>
        <pc:picChg chg="mod">
          <ac:chgData name="Abhishek Ojha" userId="253db238782fe597" providerId="LiveId" clId="{48F4AE56-B12B-4ED2-BA64-EE21170A5BFA}" dt="2023-06-27T05:49:13.115" v="6888"/>
          <ac:picMkLst>
            <pc:docMk/>
            <pc:sldMk cId="3884602200" sldId="259"/>
            <ac:picMk id="16" creationId="{5A0E0F7E-D9DF-3886-0372-8CE009559DEF}"/>
          </ac:picMkLst>
        </pc:picChg>
      </pc:sldChg>
      <pc:sldChg chg="new del">
        <pc:chgData name="Abhishek Ojha" userId="253db238782fe597" providerId="LiveId" clId="{48F4AE56-B12B-4ED2-BA64-EE21170A5BFA}" dt="2023-06-28T06:22:34.110" v="7151" actId="47"/>
        <pc:sldMkLst>
          <pc:docMk/>
          <pc:sldMk cId="3505108568" sldId="260"/>
        </pc:sldMkLst>
      </pc:sldChg>
      <pc:sldChg chg="modSp add mod">
        <pc:chgData name="Abhishek Ojha" userId="253db238782fe597" providerId="LiveId" clId="{48F4AE56-B12B-4ED2-BA64-EE21170A5BFA}" dt="2023-06-28T06:24:28.630" v="7180" actId="1037"/>
        <pc:sldMkLst>
          <pc:docMk/>
          <pc:sldMk cId="4282372917" sldId="261"/>
        </pc:sldMkLst>
        <pc:grpChg chg="mod">
          <ac:chgData name="Abhishek Ojha" userId="253db238782fe597" providerId="LiveId" clId="{48F4AE56-B12B-4ED2-BA64-EE21170A5BFA}" dt="2023-06-28T06:24:19.702" v="7172" actId="1037"/>
          <ac:grpSpMkLst>
            <pc:docMk/>
            <pc:sldMk cId="4282372917" sldId="261"/>
            <ac:grpSpMk id="66" creationId="{861A86D8-DBA1-BECB-366B-0CAADF2B068C}"/>
          </ac:grpSpMkLst>
        </pc:grpChg>
        <pc:grpChg chg="mod">
          <ac:chgData name="Abhishek Ojha" userId="253db238782fe597" providerId="LiveId" clId="{48F4AE56-B12B-4ED2-BA64-EE21170A5BFA}" dt="2023-06-28T06:24:19.702" v="7172" actId="1037"/>
          <ac:grpSpMkLst>
            <pc:docMk/>
            <pc:sldMk cId="4282372917" sldId="261"/>
            <ac:grpSpMk id="67" creationId="{107E1A74-8F20-59EE-E5F4-7703BA772324}"/>
          </ac:grpSpMkLst>
        </pc:grpChg>
        <pc:grpChg chg="mod">
          <ac:chgData name="Abhishek Ojha" userId="253db238782fe597" providerId="LiveId" clId="{48F4AE56-B12B-4ED2-BA64-EE21170A5BFA}" dt="2023-06-28T06:24:28.630" v="7180" actId="1037"/>
          <ac:grpSpMkLst>
            <pc:docMk/>
            <pc:sldMk cId="4282372917" sldId="261"/>
            <ac:grpSpMk id="68" creationId="{9BD6D402-64DA-E534-6591-40D28BB4177C}"/>
          </ac:grpSpMkLst>
        </pc:grpChg>
      </pc:sldChg>
    </pc:docChg>
  </pc:docChgLst>
  <pc:docChgLst>
    <pc:chgData name="Abhishek Ojha" userId="253db238782fe597" providerId="LiveId" clId="{6723AD2A-5C58-4FA3-9B43-1A8EDE86CB1F}"/>
    <pc:docChg chg="modSld">
      <pc:chgData name="Abhishek Ojha" userId="253db238782fe597" providerId="LiveId" clId="{6723AD2A-5C58-4FA3-9B43-1A8EDE86CB1F}" dt="2023-11-16T07:26:27.569" v="31" actId="14100"/>
      <pc:docMkLst>
        <pc:docMk/>
      </pc:docMkLst>
      <pc:sldChg chg="modSp mod">
        <pc:chgData name="Abhishek Ojha" userId="253db238782fe597" providerId="LiveId" clId="{6723AD2A-5C58-4FA3-9B43-1A8EDE86CB1F}" dt="2023-11-16T07:25:15.332" v="13" actId="20577"/>
        <pc:sldMkLst>
          <pc:docMk/>
          <pc:sldMk cId="40692274" sldId="262"/>
        </pc:sldMkLst>
        <pc:spChg chg="mod">
          <ac:chgData name="Abhishek Ojha" userId="253db238782fe597" providerId="LiveId" clId="{6723AD2A-5C58-4FA3-9B43-1A8EDE86CB1F}" dt="2023-11-16T07:25:15.332" v="13" actId="20577"/>
          <ac:spMkLst>
            <pc:docMk/>
            <pc:sldMk cId="40692274" sldId="262"/>
            <ac:spMk id="15" creationId="{31E331E6-8C16-387F-AA37-298BAD4FB558}"/>
          </ac:spMkLst>
        </pc:spChg>
        <pc:spChg chg="mod">
          <ac:chgData name="Abhishek Ojha" userId="253db238782fe597" providerId="LiveId" clId="{6723AD2A-5C58-4FA3-9B43-1A8EDE86CB1F}" dt="2023-11-16T07:25:09.599" v="6" actId="20577"/>
          <ac:spMkLst>
            <pc:docMk/>
            <pc:sldMk cId="40692274" sldId="262"/>
            <ac:spMk id="16" creationId="{CF94531A-54A0-12AB-4E9C-667F5D424710}"/>
          </ac:spMkLst>
        </pc:spChg>
      </pc:sldChg>
      <pc:sldChg chg="modSp mod">
        <pc:chgData name="Abhishek Ojha" userId="253db238782fe597" providerId="LiveId" clId="{6723AD2A-5C58-4FA3-9B43-1A8EDE86CB1F}" dt="2023-11-16T07:26:27.569" v="31" actId="14100"/>
        <pc:sldMkLst>
          <pc:docMk/>
          <pc:sldMk cId="3032515962" sldId="263"/>
        </pc:sldMkLst>
        <pc:spChg chg="mod">
          <ac:chgData name="Abhishek Ojha" userId="253db238782fe597" providerId="LiveId" clId="{6723AD2A-5C58-4FA3-9B43-1A8EDE86CB1F}" dt="2023-11-16T07:26:27.569" v="31" actId="14100"/>
          <ac:spMkLst>
            <pc:docMk/>
            <pc:sldMk cId="3032515962" sldId="263"/>
            <ac:spMk id="32" creationId="{A07BDC32-E395-BE8F-A236-3362508E131E}"/>
          </ac:spMkLst>
        </pc:spChg>
        <pc:spChg chg="mod">
          <ac:chgData name="Abhishek Ojha" userId="253db238782fe597" providerId="LiveId" clId="{6723AD2A-5C58-4FA3-9B43-1A8EDE86CB1F}" dt="2023-11-16T07:26:16.181" v="27" actId="20577"/>
          <ac:spMkLst>
            <pc:docMk/>
            <pc:sldMk cId="3032515962" sldId="263"/>
            <ac:spMk id="33" creationId="{C0D5771D-8833-ED6B-4468-E4D0D36A06DD}"/>
          </ac:spMkLst>
        </pc:spChg>
      </pc:sldChg>
    </pc:docChg>
  </pc:docChgLst>
  <pc:docChgLst>
    <pc:chgData name="Abhishek Ojha" userId="253db238782fe597" providerId="LiveId" clId="{D4B71B3C-82C3-4CFF-9195-37B9DF6E30CD}"/>
    <pc:docChg chg="custSel modSld">
      <pc:chgData name="Abhishek Ojha" userId="253db238782fe597" providerId="LiveId" clId="{D4B71B3C-82C3-4CFF-9195-37B9DF6E30CD}" dt="2023-11-17T06:16:39.186" v="13" actId="114"/>
      <pc:docMkLst>
        <pc:docMk/>
      </pc:docMkLst>
      <pc:sldChg chg="delSp modSp mod">
        <pc:chgData name="Abhishek Ojha" userId="253db238782fe597" providerId="LiveId" clId="{D4B71B3C-82C3-4CFF-9195-37B9DF6E30CD}" dt="2023-11-17T06:16:39.186" v="13" actId="114"/>
        <pc:sldMkLst>
          <pc:docMk/>
          <pc:sldMk cId="3285560308" sldId="258"/>
        </pc:sldMkLst>
        <pc:spChg chg="mod">
          <ac:chgData name="Abhishek Ojha" userId="253db238782fe597" providerId="LiveId" clId="{D4B71B3C-82C3-4CFF-9195-37B9DF6E30CD}" dt="2023-11-17T06:16:39.186" v="13" actId="114"/>
          <ac:spMkLst>
            <pc:docMk/>
            <pc:sldMk cId="3285560308" sldId="258"/>
            <ac:spMk id="8" creationId="{14F39214-E378-C9D0-950E-1F38F4C07C69}"/>
          </ac:spMkLst>
        </pc:spChg>
        <pc:spChg chg="del topLvl">
          <ac:chgData name="Abhishek Ojha" userId="253db238782fe597" providerId="LiveId" clId="{D4B71B3C-82C3-4CFF-9195-37B9DF6E30CD}" dt="2023-11-17T06:16:07.052" v="0" actId="478"/>
          <ac:spMkLst>
            <pc:docMk/>
            <pc:sldMk cId="3285560308" sldId="258"/>
            <ac:spMk id="11" creationId="{5BFCB7A6-C261-5230-29D1-1D106690A1A9}"/>
          </ac:spMkLst>
        </pc:spChg>
        <pc:spChg chg="mod">
          <ac:chgData name="Abhishek Ojha" userId="253db238782fe597" providerId="LiveId" clId="{D4B71B3C-82C3-4CFF-9195-37B9DF6E30CD}" dt="2023-11-17T06:16:17.576" v="5" actId="20577"/>
          <ac:spMkLst>
            <pc:docMk/>
            <pc:sldMk cId="3285560308" sldId="258"/>
            <ac:spMk id="25" creationId="{6B9DDDE1-40E5-CF4F-2DC0-53D2F3C542FA}"/>
          </ac:spMkLst>
        </pc:spChg>
        <pc:grpChg chg="mod topLvl">
          <ac:chgData name="Abhishek Ojha" userId="253db238782fe597" providerId="LiveId" clId="{D4B71B3C-82C3-4CFF-9195-37B9DF6E30CD}" dt="2023-11-17T06:16:12.065" v="1" actId="1076"/>
          <ac:grpSpMkLst>
            <pc:docMk/>
            <pc:sldMk cId="3285560308" sldId="258"/>
            <ac:grpSpMk id="9" creationId="{496A3F53-201C-F1C4-BC44-416DFA831225}"/>
          </ac:grpSpMkLst>
        </pc:grpChg>
        <pc:grpChg chg="del">
          <ac:chgData name="Abhishek Ojha" userId="253db238782fe597" providerId="LiveId" clId="{D4B71B3C-82C3-4CFF-9195-37B9DF6E30CD}" dt="2023-11-17T06:16:07.052" v="0" actId="478"/>
          <ac:grpSpMkLst>
            <pc:docMk/>
            <pc:sldMk cId="3285560308" sldId="258"/>
            <ac:grpSpMk id="12" creationId="{BEDA187F-99DF-4538-53C8-7CBF1FF02B32}"/>
          </ac:grpSpMkLst>
        </pc:grpChg>
      </pc:sldChg>
    </pc:docChg>
  </pc:docChgLst>
  <pc:docChgLst>
    <pc:chgData name="Abhishek Ojha" userId="253db238782fe597" providerId="LiveId" clId="{9A7D80B0-52E2-4BBE-90CC-17B349DDE009}"/>
    <pc:docChg chg="delSld modSld sldOrd">
      <pc:chgData name="Abhishek Ojha" userId="253db238782fe597" providerId="LiveId" clId="{9A7D80B0-52E2-4BBE-90CC-17B349DDE009}" dt="2023-11-17T04:01:23.269" v="14" actId="47"/>
      <pc:docMkLst>
        <pc:docMk/>
      </pc:docMkLst>
      <pc:sldChg chg="modSp mod">
        <pc:chgData name="Abhishek Ojha" userId="253db238782fe597" providerId="LiveId" clId="{9A7D80B0-52E2-4BBE-90CC-17B349DDE009}" dt="2023-11-17T04:01:09.569" v="5" actId="20577"/>
        <pc:sldMkLst>
          <pc:docMk/>
          <pc:sldMk cId="3285560308" sldId="258"/>
        </pc:sldMkLst>
        <pc:spChg chg="mod">
          <ac:chgData name="Abhishek Ojha" userId="253db238782fe597" providerId="LiveId" clId="{9A7D80B0-52E2-4BBE-90CC-17B349DDE009}" dt="2023-11-17T04:01:09.569" v="5" actId="20577"/>
          <ac:spMkLst>
            <pc:docMk/>
            <pc:sldMk cId="3285560308" sldId="258"/>
            <ac:spMk id="25" creationId="{6B9DDDE1-40E5-CF4F-2DC0-53D2F3C542FA}"/>
          </ac:spMkLst>
        </pc:spChg>
      </pc:sldChg>
      <pc:sldChg chg="del">
        <pc:chgData name="Abhishek Ojha" userId="253db238782fe597" providerId="LiveId" clId="{9A7D80B0-52E2-4BBE-90CC-17B349DDE009}" dt="2023-11-17T04:01:21.958" v="10" actId="47"/>
        <pc:sldMkLst>
          <pc:docMk/>
          <pc:sldMk cId="3884602200" sldId="259"/>
        </pc:sldMkLst>
      </pc:sldChg>
      <pc:sldChg chg="del">
        <pc:chgData name="Abhishek Ojha" userId="253db238782fe597" providerId="LiveId" clId="{9A7D80B0-52E2-4BBE-90CC-17B349DDE009}" dt="2023-11-17T04:01:22.289" v="11" actId="47"/>
        <pc:sldMkLst>
          <pc:docMk/>
          <pc:sldMk cId="4282372917" sldId="261"/>
        </pc:sldMkLst>
      </pc:sldChg>
      <pc:sldChg chg="del">
        <pc:chgData name="Abhishek Ojha" userId="253db238782fe597" providerId="LiveId" clId="{9A7D80B0-52E2-4BBE-90CC-17B349DDE009}" dt="2023-11-17T04:01:21.381" v="8" actId="47"/>
        <pc:sldMkLst>
          <pc:docMk/>
          <pc:sldMk cId="40692274" sldId="262"/>
        </pc:sldMkLst>
      </pc:sldChg>
      <pc:sldChg chg="del">
        <pc:chgData name="Abhishek Ojha" userId="253db238782fe597" providerId="LiveId" clId="{9A7D80B0-52E2-4BBE-90CC-17B349DDE009}" dt="2023-11-17T04:01:21.661" v="9" actId="47"/>
        <pc:sldMkLst>
          <pc:docMk/>
          <pc:sldMk cId="3032515962" sldId="263"/>
        </pc:sldMkLst>
      </pc:sldChg>
      <pc:sldChg chg="del">
        <pc:chgData name="Abhishek Ojha" userId="253db238782fe597" providerId="LiveId" clId="{9A7D80B0-52E2-4BBE-90CC-17B349DDE009}" dt="2023-11-17T04:01:22.570" v="12" actId="47"/>
        <pc:sldMkLst>
          <pc:docMk/>
          <pc:sldMk cId="3325828966" sldId="266"/>
        </pc:sldMkLst>
      </pc:sldChg>
      <pc:sldChg chg="del">
        <pc:chgData name="Abhishek Ojha" userId="253db238782fe597" providerId="LiveId" clId="{9A7D80B0-52E2-4BBE-90CC-17B349DDE009}" dt="2023-11-17T04:01:22.878" v="13" actId="47"/>
        <pc:sldMkLst>
          <pc:docMk/>
          <pc:sldMk cId="3886029422" sldId="267"/>
        </pc:sldMkLst>
      </pc:sldChg>
      <pc:sldChg chg="del">
        <pc:chgData name="Abhishek Ojha" userId="253db238782fe597" providerId="LiveId" clId="{9A7D80B0-52E2-4BBE-90CC-17B349DDE009}" dt="2023-11-17T04:01:23.269" v="14" actId="47"/>
        <pc:sldMkLst>
          <pc:docMk/>
          <pc:sldMk cId="4221896893" sldId="268"/>
        </pc:sldMkLst>
      </pc:sldChg>
      <pc:sldChg chg="del ord">
        <pc:chgData name="Abhishek Ojha" userId="253db238782fe597" providerId="LiveId" clId="{9A7D80B0-52E2-4BBE-90CC-17B349DDE009}" dt="2023-11-17T04:01:21.096" v="7" actId="47"/>
        <pc:sldMkLst>
          <pc:docMk/>
          <pc:sldMk cId="3689660141" sldId="269"/>
        </pc:sldMkLst>
      </pc:sldChg>
    </pc:docChg>
  </pc:docChgLst>
  <pc:docChgLst>
    <pc:chgData name="Abhishek Ojha" userId="253db238782fe597" providerId="LiveId" clId="{54C23F7F-20B4-4EB5-92C1-67A002F5E826}"/>
    <pc:docChg chg="custSel modSld">
      <pc:chgData name="Abhishek Ojha" userId="253db238782fe597" providerId="LiveId" clId="{54C23F7F-20B4-4EB5-92C1-67A002F5E826}" dt="2023-11-17T04:02:17.373" v="0" actId="478"/>
      <pc:docMkLst>
        <pc:docMk/>
      </pc:docMkLst>
      <pc:sldChg chg="delSp mod">
        <pc:chgData name="Abhishek Ojha" userId="253db238782fe597" providerId="LiveId" clId="{54C23F7F-20B4-4EB5-92C1-67A002F5E826}" dt="2023-11-17T04:02:17.373" v="0" actId="478"/>
        <pc:sldMkLst>
          <pc:docMk/>
          <pc:sldMk cId="3285560308" sldId="258"/>
        </pc:sldMkLst>
        <pc:spChg chg="del">
          <ac:chgData name="Abhishek Ojha" userId="253db238782fe597" providerId="LiveId" clId="{54C23F7F-20B4-4EB5-92C1-67A002F5E826}" dt="2023-11-17T04:02:17.373" v="0" actId="478"/>
          <ac:spMkLst>
            <pc:docMk/>
            <pc:sldMk cId="3285560308" sldId="258"/>
            <ac:spMk id="22" creationId="{DB64F0C2-85E0-99C6-FC59-96AFBB83CE2B}"/>
          </ac:spMkLst>
        </pc:spChg>
        <pc:grpChg chg="del">
          <ac:chgData name="Abhishek Ojha" userId="253db238782fe597" providerId="LiveId" clId="{54C23F7F-20B4-4EB5-92C1-67A002F5E826}" dt="2023-11-17T04:02:17.373" v="0" actId="478"/>
          <ac:grpSpMkLst>
            <pc:docMk/>
            <pc:sldMk cId="3285560308" sldId="258"/>
            <ac:grpSpMk id="24" creationId="{01075C5F-843F-CBF6-74BA-C8A21433D34C}"/>
          </ac:grpSpMkLst>
        </pc:grpChg>
      </pc:sldChg>
    </pc:docChg>
  </pc:docChgLst>
  <pc:docChgLst>
    <pc:chgData name="Abhishek Ojha" userId="253db238782fe597" providerId="LiveId" clId="{D78D3E2C-8E82-4946-8FE6-3E884FAE925F}"/>
    <pc:docChg chg="undo custSel addSld delSld modSld sldOrd">
      <pc:chgData name="Abhishek Ojha" userId="253db238782fe597" providerId="LiveId" clId="{D78D3E2C-8E82-4946-8FE6-3E884FAE925F}" dt="2023-07-28T10:51:25.540" v="7910" actId="478"/>
      <pc:docMkLst>
        <pc:docMk/>
      </pc:docMkLst>
      <pc:sldChg chg="delSp modSp del mod">
        <pc:chgData name="Abhishek Ojha" userId="253db238782fe597" providerId="LiveId" clId="{D78D3E2C-8E82-4946-8FE6-3E884FAE925F}" dt="2023-07-14T04:07:53.661" v="586" actId="47"/>
        <pc:sldMkLst>
          <pc:docMk/>
          <pc:sldMk cId="650187009" sldId="257"/>
        </pc:sldMkLst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" creationId="{BC45CECE-37F1-8C92-D29E-70EC0C6927D8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7" creationId="{372EDBA7-5ABE-6228-B73B-E3DE28453AE1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10" creationId="{773B9B0D-7234-D247-10AD-957F23402087}"/>
          </ac:spMkLst>
        </pc:spChg>
        <pc:spChg chg="mod topLvl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17" creationId="{B89637B7-4329-C1D5-EA76-88889A0CD539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18" creationId="{D4314901-9957-E965-7EAC-F319E634FFCC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1" creationId="{FF65A728-239D-EAD1-CBC6-8FE50D4EBBE4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3" creationId="{A599F222-B1F3-2B74-EB66-111FEBD2AB40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4" creationId="{79FB70ED-848C-1AFB-6D1F-3BEB160DFE7C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5" creationId="{3F10FE84-ECCE-8C70-CBF4-FF32ADEC3E50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6" creationId="{2B6F9BB7-A89E-84EF-B7AD-0FB2D5914950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7" creationId="{C6EFB81B-66F2-AF6D-7ABE-1AB9EFC95729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8" creationId="{B2D48EF4-3AAA-D748-14BB-2EA705741071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29" creationId="{2DA32B13-3261-EEAD-7A11-EE6C4636BC22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0" creationId="{7DB0B694-63B4-59EA-1541-405657816BAB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1" creationId="{E0730C8F-8251-C566-45EA-CA42EBE64745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2" creationId="{3671A01A-E727-32B3-8822-799AEF2E7F28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3" creationId="{47CCD645-6997-2F40-E184-8D86F66FD4C5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6" creationId="{4189FBE8-B2EA-78FC-1992-1849DB0462D8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7" creationId="{78D506DA-548D-924D-693A-E2C5BB3E7E46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8" creationId="{D01DE944-82DE-B7E0-365D-8CC5E99338C1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39" creationId="{5C12DB1C-0DF8-286C-E2CB-33E399896524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46" creationId="{5AD058D2-3F3D-27A5-B843-655889DD2D24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47" creationId="{E986F9FF-EA42-CEBB-42F9-0782D5741A91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48" creationId="{73107E53-8558-6A06-80DB-290B9CD41185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49" creationId="{EA7ED44F-AF13-6F99-D0A8-2E3B69689F1B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50" creationId="{5C1DF496-46E9-44BE-7BE7-BC471B516BB5}"/>
          </ac:spMkLst>
        </pc:spChg>
        <pc:spChg chg="mod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51" creationId="{F4148F60-9276-D3EC-5BA0-E281BD13D152}"/>
          </ac:spMkLst>
        </pc:spChg>
        <pc:spChg chg="mod topLvl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86" creationId="{50C09425-11EF-7776-478A-7D6BF50AF2C1}"/>
          </ac:spMkLst>
        </pc:spChg>
        <pc:spChg chg="mod topLvl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87" creationId="{928A4726-5A5C-DBD1-2EC6-232A51737176}"/>
          </ac:spMkLst>
        </pc:spChg>
        <pc:spChg chg="mod topLvl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88" creationId="{3BCFF66B-358B-4847-1746-9A49C48AB6CC}"/>
          </ac:spMkLst>
        </pc:spChg>
        <pc:spChg chg="mod topLvl">
          <ac:chgData name="Abhishek Ojha" userId="253db238782fe597" providerId="LiveId" clId="{D78D3E2C-8E82-4946-8FE6-3E884FAE925F}" dt="2023-07-12T10:50:52.879" v="5" actId="165"/>
          <ac:spMkLst>
            <pc:docMk/>
            <pc:sldMk cId="650187009" sldId="257"/>
            <ac:spMk id="89" creationId="{08607674-80D8-9CCD-976F-12094A699A91}"/>
          </ac:spMkLst>
        </pc:spChg>
        <pc:grpChg chg="mod topLvl">
          <ac:chgData name="Abhishek Ojha" userId="253db238782fe597" providerId="LiveId" clId="{D78D3E2C-8E82-4946-8FE6-3E884FAE925F}" dt="2023-07-12T10:50:57.229" v="6" actId="1076"/>
          <ac:grpSpMkLst>
            <pc:docMk/>
            <pc:sldMk cId="650187009" sldId="257"/>
            <ac:grpSpMk id="12" creationId="{96939A7E-03EE-E8CC-297A-B2D0DC1C1ADD}"/>
          </ac:grpSpMkLst>
        </pc:grpChg>
        <pc:grpChg chg="mod">
          <ac:chgData name="Abhishek Ojha" userId="253db238782fe597" providerId="LiveId" clId="{D78D3E2C-8E82-4946-8FE6-3E884FAE925F}" dt="2023-07-12T10:50:52.879" v="5" actId="165"/>
          <ac:grpSpMkLst>
            <pc:docMk/>
            <pc:sldMk cId="650187009" sldId="257"/>
            <ac:grpSpMk id="40" creationId="{E66DEC0D-414C-D2F6-8ED3-1FD6ADE9F982}"/>
          </ac:grpSpMkLst>
        </pc:grpChg>
        <pc:grpChg chg="mod topLvl">
          <ac:chgData name="Abhishek Ojha" userId="253db238782fe597" providerId="LiveId" clId="{D78D3E2C-8E82-4946-8FE6-3E884FAE925F}" dt="2023-07-14T03:08:51.751" v="418" actId="1076"/>
          <ac:grpSpMkLst>
            <pc:docMk/>
            <pc:sldMk cId="650187009" sldId="257"/>
            <ac:grpSpMk id="41" creationId="{DBF6E14E-872E-074C-F6AD-E7249F513A83}"/>
          </ac:grpSpMkLst>
        </pc:grpChg>
        <pc:grpChg chg="mod topLvl">
          <ac:chgData name="Abhishek Ojha" userId="253db238782fe597" providerId="LiveId" clId="{D78D3E2C-8E82-4946-8FE6-3E884FAE925F}" dt="2023-07-13T10:53:17.503" v="287" actId="1076"/>
          <ac:grpSpMkLst>
            <pc:docMk/>
            <pc:sldMk cId="650187009" sldId="257"/>
            <ac:grpSpMk id="52" creationId="{F5633127-17DA-730C-DF6C-3EE61FEEF949}"/>
          </ac:grpSpMkLst>
        </pc:grpChg>
        <pc:grpChg chg="del">
          <ac:chgData name="Abhishek Ojha" userId="253db238782fe597" providerId="LiveId" clId="{D78D3E2C-8E82-4946-8FE6-3E884FAE925F}" dt="2023-07-12T10:50:52.879" v="5" actId="165"/>
          <ac:grpSpMkLst>
            <pc:docMk/>
            <pc:sldMk cId="650187009" sldId="257"/>
            <ac:grpSpMk id="90" creationId="{20951AA7-1487-9DB3-8C2D-0D30208099CA}"/>
          </ac:grpSpMkLst>
        </pc:grpChg>
        <pc:graphicFrameChg chg="mod">
          <ac:chgData name="Abhishek Ojha" userId="253db238782fe597" providerId="LiveId" clId="{D78D3E2C-8E82-4946-8FE6-3E884FAE925F}" dt="2023-07-12T10:50:52.879" v="5" actId="165"/>
          <ac:graphicFrameMkLst>
            <pc:docMk/>
            <pc:sldMk cId="650187009" sldId="257"/>
            <ac:graphicFrameMk id="2" creationId="{BFC4BE7C-E541-F44A-5E24-314BC5757DEC}"/>
          </ac:graphicFrameMkLst>
        </pc:graphicFrameChg>
        <pc:graphicFrameChg chg="mod">
          <ac:chgData name="Abhishek Ojha" userId="253db238782fe597" providerId="LiveId" clId="{D78D3E2C-8E82-4946-8FE6-3E884FAE925F}" dt="2023-07-12T10:50:52.879" v="5" actId="165"/>
          <ac:graphicFrameMkLst>
            <pc:docMk/>
            <pc:sldMk cId="650187009" sldId="257"/>
            <ac:graphicFrameMk id="4" creationId="{569567DF-9A31-9601-76A7-17342BF4E3EA}"/>
          </ac:graphicFrameMkLst>
        </pc:graphicFrameChg>
        <pc:graphicFrameChg chg="mod">
          <ac:chgData name="Abhishek Ojha" userId="253db238782fe597" providerId="LiveId" clId="{D78D3E2C-8E82-4946-8FE6-3E884FAE925F}" dt="2023-07-12T10:50:52.879" v="5" actId="165"/>
          <ac:graphicFrameMkLst>
            <pc:docMk/>
            <pc:sldMk cId="650187009" sldId="257"/>
            <ac:graphicFrameMk id="14" creationId="{61951753-18B1-D3A5-71A2-F58CBB3CB745}"/>
          </ac:graphicFrameMkLst>
        </pc:graphicFrameChg>
        <pc:graphicFrameChg chg="mod">
          <ac:chgData name="Abhishek Ojha" userId="253db238782fe597" providerId="LiveId" clId="{D78D3E2C-8E82-4946-8FE6-3E884FAE925F}" dt="2023-07-12T10:50:52.879" v="5" actId="165"/>
          <ac:graphicFrameMkLst>
            <pc:docMk/>
            <pc:sldMk cId="650187009" sldId="257"/>
            <ac:graphicFrameMk id="15" creationId="{9DCDBFB5-5AD9-F56F-4A0D-9E038F4F2F57}"/>
          </ac:graphicFrameMkLst>
        </pc:graphicFrameChg>
      </pc:sldChg>
      <pc:sldChg chg="addSp delSp modSp mod ord">
        <pc:chgData name="Abhishek Ojha" userId="253db238782fe597" providerId="LiveId" clId="{D78D3E2C-8E82-4946-8FE6-3E884FAE925F}" dt="2023-07-14T09:20:44.007" v="1286"/>
        <pc:sldMkLst>
          <pc:docMk/>
          <pc:sldMk cId="3285560308" sldId="258"/>
        </pc:sldMkLst>
        <pc:spChg chg="add del mod">
          <ac:chgData name="Abhishek Ojha" userId="253db238782fe597" providerId="LiveId" clId="{D78D3E2C-8E82-4946-8FE6-3E884FAE925F}" dt="2023-07-14T05:03:45.762" v="589" actId="478"/>
          <ac:spMkLst>
            <pc:docMk/>
            <pc:sldMk cId="3285560308" sldId="258"/>
            <ac:spMk id="10" creationId="{30584475-FE26-A1C3-1DF5-6787934C8DEE}"/>
          </ac:spMkLst>
        </pc:spChg>
        <pc:grpChg chg="mod">
          <ac:chgData name="Abhishek Ojha" userId="253db238782fe597" providerId="LiveId" clId="{D78D3E2C-8E82-4946-8FE6-3E884FAE925F}" dt="2023-07-14T07:10:35.043" v="592" actId="1076"/>
          <ac:grpSpMkLst>
            <pc:docMk/>
            <pc:sldMk cId="3285560308" sldId="258"/>
            <ac:grpSpMk id="12" creationId="{BEDA187F-99DF-4538-53C8-7CBF1FF02B32}"/>
          </ac:grpSpMkLst>
        </pc:grpChg>
      </pc:sldChg>
      <pc:sldChg chg="addSp delSp modSp mod">
        <pc:chgData name="Abhishek Ojha" userId="253db238782fe597" providerId="LiveId" clId="{D78D3E2C-8E82-4946-8FE6-3E884FAE925F}" dt="2023-07-19T07:07:45.270" v="4502" actId="478"/>
        <pc:sldMkLst>
          <pc:docMk/>
          <pc:sldMk cId="3884602200" sldId="259"/>
        </pc:sldMkLst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4" creationId="{E14422EA-2B15-A430-5E91-E388EB140125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5" creationId="{3874CF46-0791-FF8E-740C-64C7073905B5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6" creationId="{CFB8172D-3AF6-0218-A622-43554779E0D3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7" creationId="{D65C5D4B-1A57-17F3-F5B9-E9174AA66C87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8" creationId="{6E3635E8-7ED2-95FE-0785-39F1D220512B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9" creationId="{8E04DEB2-55B6-2410-4F05-D0D422FA2FA8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10" creationId="{28B3F236-5778-047E-8F7D-4355A67224A7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11" creationId="{41DBD3AE-73BE-CF7A-BCDE-8E923B5EC61E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12" creationId="{9168618B-9FCC-403E-86E2-DF8EF1C65703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13" creationId="{D514D285-B591-14F8-0390-160481DC3250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14" creationId="{7C5E55F0-2DC2-A56A-0916-4E2591BD56AC}"/>
          </ac:spMkLst>
        </pc:spChg>
        <pc:spChg chg="mod">
          <ac:chgData name="Abhishek Ojha" userId="253db238782fe597" providerId="LiveId" clId="{D78D3E2C-8E82-4946-8FE6-3E884FAE925F}" dt="2023-07-14T09:20:25.054" v="1281" actId="1076"/>
          <ac:spMkLst>
            <pc:docMk/>
            <pc:sldMk cId="3884602200" sldId="259"/>
            <ac:spMk id="20" creationId="{02ADB594-6E43-215D-1C08-67511A7A7B8F}"/>
          </ac:spMkLst>
        </pc:spChg>
        <pc:spChg chg="del mod">
          <ac:chgData name="Abhishek Ojha" userId="253db238782fe597" providerId="LiveId" clId="{D78D3E2C-8E82-4946-8FE6-3E884FAE925F}" dt="2023-07-14T09:03:19.715" v="1099" actId="478"/>
          <ac:spMkLst>
            <pc:docMk/>
            <pc:sldMk cId="3884602200" sldId="259"/>
            <ac:spMk id="21" creationId="{31285BE0-5D66-6B87-31BB-09CDD69DBA4B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1" creationId="{584C727F-80AD-277D-B8DF-ED69291832DD}"/>
          </ac:spMkLst>
        </pc:spChg>
        <pc:spChg chg="add mod">
          <ac:chgData name="Abhishek Ojha" userId="253db238782fe597" providerId="LiveId" clId="{D78D3E2C-8E82-4946-8FE6-3E884FAE925F}" dt="2023-07-14T09:20:35.595" v="1284" actId="20577"/>
          <ac:spMkLst>
            <pc:docMk/>
            <pc:sldMk cId="3884602200" sldId="259"/>
            <ac:spMk id="22" creationId="{4837559D-FF70-409B-3B4D-B63E7D119C27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3" creationId="{665B3319-42F5-2D96-4D66-C7B8957B6045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4" creationId="{8FD81596-3188-24F2-14CD-0BD248886BBC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5" creationId="{17EC1B12-EB49-6859-3160-61C258CC047F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6" creationId="{61E62B28-8578-F12F-4C3E-E70D0047E295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7" creationId="{BEB5BFE9-5410-57D9-A2B7-FFBC0B953C0A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8" creationId="{D8BE02CC-78A4-3520-722E-2588D0A3F950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29" creationId="{DD8E1DEA-2E38-85BC-5A93-D340091D5976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30" creationId="{5FBD19BA-5BE3-1D92-4E42-4E023EC9BF12}"/>
          </ac:spMkLst>
        </pc:spChg>
        <pc:spChg chg="mod">
          <ac:chgData name="Abhishek Ojha" userId="253db238782fe597" providerId="LiveId" clId="{D78D3E2C-8E82-4946-8FE6-3E884FAE925F}" dt="2023-07-17T10:59:08.555" v="1290"/>
          <ac:spMkLst>
            <pc:docMk/>
            <pc:sldMk cId="3884602200" sldId="259"/>
            <ac:spMk id="31" creationId="{529C518A-3413-43EA-0C84-B71EBA6800EB}"/>
          </ac:spMkLst>
        </pc:spChg>
        <pc:grpChg chg="add del mod">
          <ac:chgData name="Abhishek Ojha" userId="253db238782fe597" providerId="LiveId" clId="{D78D3E2C-8E82-4946-8FE6-3E884FAE925F}" dt="2023-07-19T07:07:45.270" v="4502" actId="478"/>
          <ac:grpSpMkLst>
            <pc:docMk/>
            <pc:sldMk cId="3884602200" sldId="259"/>
            <ac:grpSpMk id="2" creationId="{92944EF7-9301-99B4-A9ED-F9D0DAB098C3}"/>
          </ac:grpSpMkLst>
        </pc:grpChg>
        <pc:grpChg chg="del">
          <ac:chgData name="Abhishek Ojha" userId="253db238782fe597" providerId="LiveId" clId="{D78D3E2C-8E82-4946-8FE6-3E884FAE925F}" dt="2023-07-14T09:03:16.379" v="1098" actId="478"/>
          <ac:grpSpMkLst>
            <pc:docMk/>
            <pc:sldMk cId="3884602200" sldId="259"/>
            <ac:grpSpMk id="2" creationId="{EF46A310-6A49-8EF8-D8D9-170B48D2D5E3}"/>
          </ac:grpSpMkLst>
        </pc:grpChg>
        <pc:grpChg chg="mod">
          <ac:chgData name="Abhishek Ojha" userId="253db238782fe597" providerId="LiveId" clId="{D78D3E2C-8E82-4946-8FE6-3E884FAE925F}" dt="2023-07-14T09:20:25.054" v="1281" actId="1076"/>
          <ac:grpSpMkLst>
            <pc:docMk/>
            <pc:sldMk cId="3884602200" sldId="259"/>
            <ac:grpSpMk id="15" creationId="{CF47992E-9BC2-A4CE-23D9-6FDA4C7B7001}"/>
          </ac:grpSpMkLst>
        </pc:grpChg>
        <pc:picChg chg="mod">
          <ac:chgData name="Abhishek Ojha" userId="253db238782fe597" providerId="LiveId" clId="{D78D3E2C-8E82-4946-8FE6-3E884FAE925F}" dt="2023-07-17T10:59:08.555" v="1290"/>
          <ac:picMkLst>
            <pc:docMk/>
            <pc:sldMk cId="3884602200" sldId="259"/>
            <ac:picMk id="3" creationId="{7D9C1424-6A37-46AF-3B81-F789C06B424D}"/>
          </ac:picMkLst>
        </pc:picChg>
      </pc:sldChg>
      <pc:sldChg chg="modSp mod">
        <pc:chgData name="Abhishek Ojha" userId="253db238782fe597" providerId="LiveId" clId="{D78D3E2C-8E82-4946-8FE6-3E884FAE925F}" dt="2023-07-28T10:18:31.768" v="7872" actId="20577"/>
        <pc:sldMkLst>
          <pc:docMk/>
          <pc:sldMk cId="4282372917" sldId="261"/>
        </pc:sldMkLst>
        <pc:spChg chg="mod">
          <ac:chgData name="Abhishek Ojha" userId="253db238782fe597" providerId="LiveId" clId="{D78D3E2C-8E82-4946-8FE6-3E884FAE925F}" dt="2023-07-28T10:18:31.768" v="7872" actId="20577"/>
          <ac:spMkLst>
            <pc:docMk/>
            <pc:sldMk cId="4282372917" sldId="261"/>
            <ac:spMk id="2" creationId="{1EF4EDA3-1FB8-4495-BF25-3ED5E7A4F42C}"/>
          </ac:spMkLst>
        </pc:spChg>
      </pc:sldChg>
      <pc:sldChg chg="addSp delSp modSp new mod ord">
        <pc:chgData name="Abhishek Ojha" userId="253db238782fe597" providerId="LiveId" clId="{D78D3E2C-8E82-4946-8FE6-3E884FAE925F}" dt="2023-07-28T09:52:31.042" v="7870" actId="1035"/>
        <pc:sldMkLst>
          <pc:docMk/>
          <pc:sldMk cId="40692274" sldId="262"/>
        </pc:sldMkLst>
        <pc:spChg chg="del">
          <ac:chgData name="Abhishek Ojha" userId="253db238782fe597" providerId="LiveId" clId="{D78D3E2C-8E82-4946-8FE6-3E884FAE925F}" dt="2023-07-12T10:51:03.674" v="7" actId="478"/>
          <ac:spMkLst>
            <pc:docMk/>
            <pc:sldMk cId="40692274" sldId="262"/>
            <ac:spMk id="2" creationId="{26F11B36-628D-B3C6-3994-A0A8652A0294}"/>
          </ac:spMkLst>
        </pc:spChg>
        <pc:spChg chg="del">
          <ac:chgData name="Abhishek Ojha" userId="253db238782fe597" providerId="LiveId" clId="{D78D3E2C-8E82-4946-8FE6-3E884FAE925F}" dt="2023-07-12T10:51:03.674" v="7" actId="478"/>
          <ac:spMkLst>
            <pc:docMk/>
            <pc:sldMk cId="40692274" sldId="262"/>
            <ac:spMk id="3" creationId="{3AC9C852-E989-8DD2-3E69-0240AF4379E0}"/>
          </ac:spMkLst>
        </pc:spChg>
        <pc:spChg chg="mod">
          <ac:chgData name="Abhishek Ojha" userId="253db238782fe597" providerId="LiveId" clId="{D78D3E2C-8E82-4946-8FE6-3E884FAE925F}" dt="2023-07-12T10:51:04.743" v="8"/>
          <ac:spMkLst>
            <pc:docMk/>
            <pc:sldMk cId="40692274" sldId="262"/>
            <ac:spMk id="6" creationId="{9F772773-42DA-4840-CACE-3E0CDE7896DC}"/>
          </ac:spMkLst>
        </pc:spChg>
        <pc:spChg chg="mod">
          <ac:chgData name="Abhishek Ojha" userId="253db238782fe597" providerId="LiveId" clId="{D78D3E2C-8E82-4946-8FE6-3E884FAE925F}" dt="2023-07-12T10:51:04.743" v="8"/>
          <ac:spMkLst>
            <pc:docMk/>
            <pc:sldMk cId="40692274" sldId="262"/>
            <ac:spMk id="7" creationId="{E0BBEF6A-CD4F-F518-0044-CE62EBF164EB}"/>
          </ac:spMkLst>
        </pc:spChg>
        <pc:spChg chg="add mod">
          <ac:chgData name="Abhishek Ojha" userId="253db238782fe597" providerId="LiveId" clId="{D78D3E2C-8E82-4946-8FE6-3E884FAE925F}" dt="2023-07-13T10:41:40.133" v="199" actId="1076"/>
          <ac:spMkLst>
            <pc:docMk/>
            <pc:sldMk cId="40692274" sldId="262"/>
            <ac:spMk id="8" creationId="{08D2E9E2-AF8A-A0BF-F09C-BDF06273D455}"/>
          </ac:spMkLst>
        </pc:spChg>
        <pc:spChg chg="mod">
          <ac:chgData name="Abhishek Ojha" userId="253db238782fe597" providerId="LiveId" clId="{D78D3E2C-8E82-4946-8FE6-3E884FAE925F}" dt="2023-07-13T10:41:07.835" v="103"/>
          <ac:spMkLst>
            <pc:docMk/>
            <pc:sldMk cId="40692274" sldId="262"/>
            <ac:spMk id="9" creationId="{A653410D-6709-84A2-CF40-C95B5D8F61F7}"/>
          </ac:spMkLst>
        </pc:spChg>
        <pc:spChg chg="mod">
          <ac:chgData name="Abhishek Ojha" userId="253db238782fe597" providerId="LiveId" clId="{D78D3E2C-8E82-4946-8FE6-3E884FAE925F}" dt="2023-07-28T09:52:31.042" v="7870" actId="1035"/>
          <ac:spMkLst>
            <pc:docMk/>
            <pc:sldMk cId="40692274" sldId="262"/>
            <ac:spMk id="10" creationId="{A69B4776-9266-D91C-CAEE-6FDFA9A54A5F}"/>
          </ac:spMkLst>
        </pc:spChg>
        <pc:spChg chg="add mod">
          <ac:chgData name="Abhishek Ojha" userId="253db238782fe597" providerId="LiveId" clId="{D78D3E2C-8E82-4946-8FE6-3E884FAE925F}" dt="2023-07-13T10:42:01.514" v="286" actId="20577"/>
          <ac:spMkLst>
            <pc:docMk/>
            <pc:sldMk cId="40692274" sldId="262"/>
            <ac:spMk id="11" creationId="{6E64CB6D-9956-DF22-39FF-0A52096E6738}"/>
          </ac:spMkLst>
        </pc:spChg>
        <pc:spChg chg="mod">
          <ac:chgData name="Abhishek Ojha" userId="253db238782fe597" providerId="LiveId" clId="{D78D3E2C-8E82-4946-8FE6-3E884FAE925F}" dt="2023-07-13T10:53:25.505" v="288"/>
          <ac:spMkLst>
            <pc:docMk/>
            <pc:sldMk cId="40692274" sldId="262"/>
            <ac:spMk id="14" creationId="{369A1CD9-AA6F-87A0-4049-4ED73FD7D632}"/>
          </ac:spMkLst>
        </pc:spChg>
        <pc:spChg chg="mod">
          <ac:chgData name="Abhishek Ojha" userId="253db238782fe597" providerId="LiveId" clId="{D78D3E2C-8E82-4946-8FE6-3E884FAE925F}" dt="2023-07-13T10:53:25.505" v="288"/>
          <ac:spMkLst>
            <pc:docMk/>
            <pc:sldMk cId="40692274" sldId="262"/>
            <ac:spMk id="15" creationId="{31E331E6-8C16-387F-AA37-298BAD4FB558}"/>
          </ac:spMkLst>
        </pc:spChg>
        <pc:spChg chg="mod">
          <ac:chgData name="Abhishek Ojha" userId="253db238782fe597" providerId="LiveId" clId="{D78D3E2C-8E82-4946-8FE6-3E884FAE925F}" dt="2023-07-13T10:53:25.505" v="288"/>
          <ac:spMkLst>
            <pc:docMk/>
            <pc:sldMk cId="40692274" sldId="262"/>
            <ac:spMk id="16" creationId="{CF94531A-54A0-12AB-4E9C-667F5D424710}"/>
          </ac:spMkLst>
        </pc:spChg>
        <pc:spChg chg="mod">
          <ac:chgData name="Abhishek Ojha" userId="253db238782fe597" providerId="LiveId" clId="{D78D3E2C-8E82-4946-8FE6-3E884FAE925F}" dt="2023-07-13T10:53:25.505" v="288"/>
          <ac:spMkLst>
            <pc:docMk/>
            <pc:sldMk cId="40692274" sldId="262"/>
            <ac:spMk id="17" creationId="{D6C07F26-5CBB-CCF5-F9DB-70E0BADF7F34}"/>
          </ac:spMkLst>
        </pc:spChg>
        <pc:spChg chg="mod">
          <ac:chgData name="Abhishek Ojha" userId="253db238782fe597" providerId="LiveId" clId="{D78D3E2C-8E82-4946-8FE6-3E884FAE925F}" dt="2023-07-13T10:53:25.505" v="288"/>
          <ac:spMkLst>
            <pc:docMk/>
            <pc:sldMk cId="40692274" sldId="262"/>
            <ac:spMk id="18" creationId="{C579BE6A-1711-890B-0E9F-86649E9ECF55}"/>
          </ac:spMkLst>
        </pc:spChg>
        <pc:spChg chg="mod">
          <ac:chgData name="Abhishek Ojha" userId="253db238782fe597" providerId="LiveId" clId="{D78D3E2C-8E82-4946-8FE6-3E884FAE925F}" dt="2023-07-13T10:53:25.505" v="288"/>
          <ac:spMkLst>
            <pc:docMk/>
            <pc:sldMk cId="40692274" sldId="262"/>
            <ac:spMk id="19" creationId="{062AA9D3-EAA1-CA5D-3077-B41B98071FC4}"/>
          </ac:spMkLst>
        </pc:spChg>
        <pc:spChg chg="add mod">
          <ac:chgData name="Abhishek Ojha" userId="253db238782fe597" providerId="LiveId" clId="{D78D3E2C-8E82-4946-8FE6-3E884FAE925F}" dt="2023-07-13T10:54:09.969" v="417" actId="20577"/>
          <ac:spMkLst>
            <pc:docMk/>
            <pc:sldMk cId="40692274" sldId="262"/>
            <ac:spMk id="20" creationId="{5958642F-3832-91DD-0E24-A6C7B2A33E70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23" creationId="{F1F33D34-12CB-6E47-1FBB-3D8DA18D8C34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24" creationId="{9FB5368F-B66A-E7DA-78F0-BE67C002BB26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25" creationId="{CD006BAD-0E70-4796-9E1D-2B018F688BA7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26" creationId="{E959C4DB-9BCA-C6C9-679B-75C612C2706E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27" creationId="{4FC84EB7-DB66-1560-778D-CB6A6113BC06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28" creationId="{E58657B3-CD77-B3B6-62F2-DF7CF49BDC57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29" creationId="{F4B6A8BC-C4EB-078C-983F-0D96F09A1D0E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30" creationId="{FC365F20-E791-CD56-BE54-DA6E43FD35EC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31" creationId="{02A64F0F-027B-71CC-981E-1CDDBE7135A5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32" creationId="{85159F78-58A1-307C-0113-68A105E7C213}"/>
          </ac:spMkLst>
        </pc:spChg>
        <pc:spChg chg="mod">
          <ac:chgData name="Abhishek Ojha" userId="253db238782fe597" providerId="LiveId" clId="{D78D3E2C-8E82-4946-8FE6-3E884FAE925F}" dt="2023-07-21T09:57:44.100" v="4542" actId="1038"/>
          <ac:spMkLst>
            <pc:docMk/>
            <pc:sldMk cId="40692274" sldId="262"/>
            <ac:spMk id="34" creationId="{3CA247C6-88C1-6BDA-78A6-D7565C7BA0EC}"/>
          </ac:spMkLst>
        </pc:spChg>
        <pc:spChg chg="mod">
          <ac:chgData name="Abhishek Ojha" userId="253db238782fe597" providerId="LiveId" clId="{D78D3E2C-8E82-4946-8FE6-3E884FAE925F}" dt="2023-07-21T09:57:59.092" v="4565" actId="1038"/>
          <ac:spMkLst>
            <pc:docMk/>
            <pc:sldMk cId="40692274" sldId="262"/>
            <ac:spMk id="35" creationId="{B650552A-A5FB-1606-55CC-EF7B0770B457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36" creationId="{DB4CB847-8EDD-68A8-7741-F4FE1E1F2867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37" creationId="{8872BC66-8385-CB29-EFB7-1812AE1C339C}"/>
          </ac:spMkLst>
        </pc:spChg>
        <pc:spChg chg="del mod">
          <ac:chgData name="Abhishek Ojha" userId="253db238782fe597" providerId="LiveId" clId="{D78D3E2C-8E82-4946-8FE6-3E884FAE925F}" dt="2023-07-21T09:57:30.694" v="4522" actId="478"/>
          <ac:spMkLst>
            <pc:docMk/>
            <pc:sldMk cId="40692274" sldId="262"/>
            <ac:spMk id="39" creationId="{D42E554E-EFE1-10A1-716C-0E7EBF5BA998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40" creationId="{EC5CE099-272B-47A4-BB70-A89FA8A6806E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41" creationId="{9DB4B6AB-DAFB-818E-1F19-438D29D008F0}"/>
          </ac:spMkLst>
        </pc:spChg>
        <pc:spChg chg="mod">
          <ac:chgData name="Abhishek Ojha" userId="253db238782fe597" providerId="LiveId" clId="{D78D3E2C-8E82-4946-8FE6-3E884FAE925F}" dt="2023-07-14T03:08:56.451" v="419"/>
          <ac:spMkLst>
            <pc:docMk/>
            <pc:sldMk cId="40692274" sldId="262"/>
            <ac:spMk id="42" creationId="{F8AE26AA-93D1-9F02-1609-5FCAE2AFF128}"/>
          </ac:spMkLst>
        </pc:spChg>
        <pc:spChg chg="add mod">
          <ac:chgData name="Abhishek Ojha" userId="253db238782fe597" providerId="LiveId" clId="{D78D3E2C-8E82-4946-8FE6-3E884FAE925F}" dt="2023-07-14T03:09:22.293" v="585" actId="20577"/>
          <ac:spMkLst>
            <pc:docMk/>
            <pc:sldMk cId="40692274" sldId="262"/>
            <ac:spMk id="43" creationId="{EA96C94F-164C-9B83-17D4-7DB16B751436}"/>
          </ac:spMkLst>
        </pc:spChg>
        <pc:grpChg chg="add mod">
          <ac:chgData name="Abhishek Ojha" userId="253db238782fe597" providerId="LiveId" clId="{D78D3E2C-8E82-4946-8FE6-3E884FAE925F}" dt="2023-07-13T10:53:42.843" v="309" actId="1035"/>
          <ac:grpSpMkLst>
            <pc:docMk/>
            <pc:sldMk cId="40692274" sldId="262"/>
            <ac:grpSpMk id="2" creationId="{F6050DFF-52AC-F59E-3B2B-012C38D14AF2}"/>
          </ac:grpSpMkLst>
        </pc:grpChg>
        <pc:grpChg chg="add mod">
          <ac:chgData name="Abhishek Ojha" userId="253db238782fe597" providerId="LiveId" clId="{D78D3E2C-8E82-4946-8FE6-3E884FAE925F}" dt="2023-07-13T10:53:42.843" v="309" actId="1035"/>
          <ac:grpSpMkLst>
            <pc:docMk/>
            <pc:sldMk cId="40692274" sldId="262"/>
            <ac:grpSpMk id="4" creationId="{E36EBC1D-847C-6151-60E7-C4BC38BF2BED}"/>
          </ac:grpSpMkLst>
        </pc:grpChg>
        <pc:grpChg chg="add mod">
          <ac:chgData name="Abhishek Ojha" userId="253db238782fe597" providerId="LiveId" clId="{D78D3E2C-8E82-4946-8FE6-3E884FAE925F}" dt="2023-07-13T10:53:25.505" v="288"/>
          <ac:grpSpMkLst>
            <pc:docMk/>
            <pc:sldMk cId="40692274" sldId="262"/>
            <ac:grpSpMk id="12" creationId="{754CA771-2692-EFE0-E8A4-697AE14D92CF}"/>
          </ac:grpSpMkLst>
        </pc:grpChg>
        <pc:grpChg chg="add mod">
          <ac:chgData name="Abhishek Ojha" userId="253db238782fe597" providerId="LiveId" clId="{D78D3E2C-8E82-4946-8FE6-3E884FAE925F}" dt="2023-07-14T03:09:02.091" v="456" actId="1037"/>
          <ac:grpSpMkLst>
            <pc:docMk/>
            <pc:sldMk cId="40692274" sldId="262"/>
            <ac:grpSpMk id="21" creationId="{E80ABE14-5DF9-7E65-E1B9-777A49F89321}"/>
          </ac:grpSpMkLst>
        </pc:grpChg>
        <pc:grpChg chg="mod">
          <ac:chgData name="Abhishek Ojha" userId="253db238782fe597" providerId="LiveId" clId="{D78D3E2C-8E82-4946-8FE6-3E884FAE925F}" dt="2023-07-14T03:08:56.451" v="419"/>
          <ac:grpSpMkLst>
            <pc:docMk/>
            <pc:sldMk cId="40692274" sldId="262"/>
            <ac:grpSpMk id="33" creationId="{707C1ABE-52B6-BDA7-1410-B89640B8F5D5}"/>
          </ac:grpSpMkLst>
        </pc:grpChg>
        <pc:graphicFrameChg chg="mod">
          <ac:chgData name="Abhishek Ojha" userId="253db238782fe597" providerId="LiveId" clId="{D78D3E2C-8E82-4946-8FE6-3E884FAE925F}" dt="2023-07-13T10:41:07.835" v="103"/>
          <ac:graphicFrameMkLst>
            <pc:docMk/>
            <pc:sldMk cId="40692274" sldId="262"/>
            <ac:graphicFrameMk id="3" creationId="{D5F2EAEA-BBCF-B82F-7B02-A79B4CF745D7}"/>
          </ac:graphicFrameMkLst>
        </pc:graphicFrameChg>
        <pc:graphicFrameChg chg="mod">
          <ac:chgData name="Abhishek Ojha" userId="253db238782fe597" providerId="LiveId" clId="{D78D3E2C-8E82-4946-8FE6-3E884FAE925F}" dt="2023-07-12T10:51:04.743" v="8"/>
          <ac:graphicFrameMkLst>
            <pc:docMk/>
            <pc:sldMk cId="40692274" sldId="262"/>
            <ac:graphicFrameMk id="5" creationId="{30503605-5EDF-9750-2D9A-1632E997F56E}"/>
          </ac:graphicFrameMkLst>
        </pc:graphicFrameChg>
        <pc:graphicFrameChg chg="mod">
          <ac:chgData name="Abhishek Ojha" userId="253db238782fe597" providerId="LiveId" clId="{D78D3E2C-8E82-4946-8FE6-3E884FAE925F}" dt="2023-07-13T10:53:25.505" v="288"/>
          <ac:graphicFrameMkLst>
            <pc:docMk/>
            <pc:sldMk cId="40692274" sldId="262"/>
            <ac:graphicFrameMk id="13" creationId="{2764570E-0700-611B-7AA8-007FC5FA1CE5}"/>
          </ac:graphicFrameMkLst>
        </pc:graphicFrameChg>
        <pc:graphicFrameChg chg="mod">
          <ac:chgData name="Abhishek Ojha" userId="253db238782fe597" providerId="LiveId" clId="{D78D3E2C-8E82-4946-8FE6-3E884FAE925F}" dt="2023-07-14T03:08:56.451" v="419"/>
          <ac:graphicFrameMkLst>
            <pc:docMk/>
            <pc:sldMk cId="40692274" sldId="262"/>
            <ac:graphicFrameMk id="22" creationId="{767B38CB-8CFA-9CA2-706C-28A319FF9F35}"/>
          </ac:graphicFrameMkLst>
        </pc:graphicFrameChg>
        <pc:graphicFrameChg chg="mod">
          <ac:chgData name="Abhishek Ojha" userId="253db238782fe597" providerId="LiveId" clId="{D78D3E2C-8E82-4946-8FE6-3E884FAE925F}" dt="2023-07-14T03:08:56.451" v="419"/>
          <ac:graphicFrameMkLst>
            <pc:docMk/>
            <pc:sldMk cId="40692274" sldId="262"/>
            <ac:graphicFrameMk id="38" creationId="{7D45E51F-7C6A-1CB8-F25D-433190A076AD}"/>
          </ac:graphicFrameMkLst>
        </pc:graphicFrameChg>
      </pc:sldChg>
      <pc:sldChg chg="addSp delSp modSp new mod">
        <pc:chgData name="Abhishek Ojha" userId="253db238782fe597" providerId="LiveId" clId="{D78D3E2C-8E82-4946-8FE6-3E884FAE925F}" dt="2023-07-14T09:13:30.102" v="1280" actId="20577"/>
        <pc:sldMkLst>
          <pc:docMk/>
          <pc:sldMk cId="3032515962" sldId="263"/>
        </pc:sldMkLst>
        <pc:spChg chg="del">
          <ac:chgData name="Abhishek Ojha" userId="253db238782fe597" providerId="LiveId" clId="{D78D3E2C-8E82-4946-8FE6-3E884FAE925F}" dt="2023-07-14T07:10:31.021" v="591" actId="478"/>
          <ac:spMkLst>
            <pc:docMk/>
            <pc:sldMk cId="3032515962" sldId="263"/>
            <ac:spMk id="2" creationId="{E1B41D5D-BBA7-EFFA-1428-C07C13C21FC4}"/>
          </ac:spMkLst>
        </pc:spChg>
        <pc:spChg chg="del">
          <ac:chgData name="Abhishek Ojha" userId="253db238782fe597" providerId="LiveId" clId="{D78D3E2C-8E82-4946-8FE6-3E884FAE925F}" dt="2023-07-14T07:10:31.021" v="591" actId="478"/>
          <ac:spMkLst>
            <pc:docMk/>
            <pc:sldMk cId="3032515962" sldId="263"/>
            <ac:spMk id="3" creationId="{9853FA12-5147-66FB-D251-47F8FC9E8739}"/>
          </ac:spMkLst>
        </pc:spChg>
        <pc:spChg chg="mod">
          <ac:chgData name="Abhishek Ojha" userId="253db238782fe597" providerId="LiveId" clId="{D78D3E2C-8E82-4946-8FE6-3E884FAE925F}" dt="2023-07-14T07:10:40.078" v="593"/>
          <ac:spMkLst>
            <pc:docMk/>
            <pc:sldMk cId="3032515962" sldId="263"/>
            <ac:spMk id="6" creationId="{A25CDAD9-D5E1-0DEA-9511-234C2F955896}"/>
          </ac:spMkLst>
        </pc:spChg>
        <pc:spChg chg="mod">
          <ac:chgData name="Abhishek Ojha" userId="253db238782fe597" providerId="LiveId" clId="{D78D3E2C-8E82-4946-8FE6-3E884FAE925F}" dt="2023-07-14T07:10:40.078" v="593"/>
          <ac:spMkLst>
            <pc:docMk/>
            <pc:sldMk cId="3032515962" sldId="263"/>
            <ac:spMk id="8" creationId="{D3F137E9-9741-0CED-ABFC-6166C6A697B2}"/>
          </ac:spMkLst>
        </pc:spChg>
        <pc:spChg chg="mod">
          <ac:chgData name="Abhishek Ojha" userId="253db238782fe597" providerId="LiveId" clId="{D78D3E2C-8E82-4946-8FE6-3E884FAE925F}" dt="2023-07-14T07:10:40.078" v="593"/>
          <ac:spMkLst>
            <pc:docMk/>
            <pc:sldMk cId="3032515962" sldId="263"/>
            <ac:spMk id="9" creationId="{11D55267-BA7D-390C-09E4-9EC5D9D68D29}"/>
          </ac:spMkLst>
        </pc:spChg>
        <pc:spChg chg="mod">
          <ac:chgData name="Abhishek Ojha" userId="253db238782fe597" providerId="LiveId" clId="{D78D3E2C-8E82-4946-8FE6-3E884FAE925F}" dt="2023-07-14T07:10:40.078" v="593"/>
          <ac:spMkLst>
            <pc:docMk/>
            <pc:sldMk cId="3032515962" sldId="263"/>
            <ac:spMk id="10" creationId="{01029589-E412-07C3-1009-483243FFA5C1}"/>
          </ac:spMkLst>
        </pc:spChg>
        <pc:spChg chg="mod">
          <ac:chgData name="Abhishek Ojha" userId="253db238782fe597" providerId="LiveId" clId="{D78D3E2C-8E82-4946-8FE6-3E884FAE925F}" dt="2023-07-14T07:10:40.078" v="593"/>
          <ac:spMkLst>
            <pc:docMk/>
            <pc:sldMk cId="3032515962" sldId="263"/>
            <ac:spMk id="11" creationId="{32E691CE-CECE-35AD-3925-F745EEF665DE}"/>
          </ac:spMkLst>
        </pc:spChg>
        <pc:spChg chg="mod">
          <ac:chgData name="Abhishek Ojha" userId="253db238782fe597" providerId="LiveId" clId="{D78D3E2C-8E82-4946-8FE6-3E884FAE925F}" dt="2023-07-14T07:10:40.078" v="593"/>
          <ac:spMkLst>
            <pc:docMk/>
            <pc:sldMk cId="3032515962" sldId="263"/>
            <ac:spMk id="12" creationId="{11184F4C-30C7-42BB-9A4E-8E213B8D0760}"/>
          </ac:spMkLst>
        </pc:spChg>
        <pc:spChg chg="add mod">
          <ac:chgData name="Abhishek Ojha" userId="253db238782fe597" providerId="LiveId" clId="{D78D3E2C-8E82-4946-8FE6-3E884FAE925F}" dt="2023-07-14T07:11:11.889" v="708" actId="20577"/>
          <ac:spMkLst>
            <pc:docMk/>
            <pc:sldMk cId="3032515962" sldId="263"/>
            <ac:spMk id="13" creationId="{D5880BE5-12FF-8FE3-AE81-79C355B9CE28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16" creationId="{49B091B4-0A94-A2BF-BC1A-2C9078CD8393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18" creationId="{9ACE15A9-32CE-E437-D79A-102C083A64E7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19" creationId="{60DDB89F-4E73-CC73-7A9C-7582B5F360C6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20" creationId="{3B042C71-B534-1661-9A08-7CAE2F704454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21" creationId="{E5EF26BB-FF95-EDC3-4C28-3DD45451379C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22" creationId="{B6D101C2-0CFC-F908-7926-9B2528D3FA3E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23" creationId="{190B8CB6-45FB-AC96-2F67-73B4CF31FFCC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24" creationId="{48A0B43E-0C4E-0C05-4DA2-1A4501AADB19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25" creationId="{4D051129-90EB-BEA4-0DC4-87E9D2310F73}"/>
          </ac:spMkLst>
        </pc:spChg>
        <pc:spChg chg="mod">
          <ac:chgData name="Abhishek Ojha" userId="253db238782fe597" providerId="LiveId" clId="{D78D3E2C-8E82-4946-8FE6-3E884FAE925F}" dt="2023-07-14T08:21:59.448" v="709"/>
          <ac:spMkLst>
            <pc:docMk/>
            <pc:sldMk cId="3032515962" sldId="263"/>
            <ac:spMk id="26" creationId="{01223B3C-DCAE-CEFE-37FC-472434756E30}"/>
          </ac:spMkLst>
        </pc:spChg>
        <pc:spChg chg="mod">
          <ac:chgData name="Abhishek Ojha" userId="253db238782fe597" providerId="LiveId" clId="{D78D3E2C-8E82-4946-8FE6-3E884FAE925F}" dt="2023-07-14T09:02:36.552" v="1080" actId="571"/>
          <ac:spMkLst>
            <pc:docMk/>
            <pc:sldMk cId="3032515962" sldId="263"/>
            <ac:spMk id="29" creationId="{B5E0F6A9-E464-9BFA-B5EA-0991C0346C01}"/>
          </ac:spMkLst>
        </pc:spChg>
        <pc:spChg chg="mod">
          <ac:chgData name="Abhishek Ojha" userId="253db238782fe597" providerId="LiveId" clId="{D78D3E2C-8E82-4946-8FE6-3E884FAE925F}" dt="2023-07-14T09:02:36.552" v="1080" actId="571"/>
          <ac:spMkLst>
            <pc:docMk/>
            <pc:sldMk cId="3032515962" sldId="263"/>
            <ac:spMk id="31" creationId="{BBBD9FB2-E166-476E-6B86-52F525951280}"/>
          </ac:spMkLst>
        </pc:spChg>
        <pc:spChg chg="mod">
          <ac:chgData name="Abhishek Ojha" userId="253db238782fe597" providerId="LiveId" clId="{D78D3E2C-8E82-4946-8FE6-3E884FAE925F}" dt="2023-07-14T09:02:36.552" v="1080" actId="571"/>
          <ac:spMkLst>
            <pc:docMk/>
            <pc:sldMk cId="3032515962" sldId="263"/>
            <ac:spMk id="32" creationId="{A07BDC32-E395-BE8F-A236-3362508E131E}"/>
          </ac:spMkLst>
        </pc:spChg>
        <pc:spChg chg="mod">
          <ac:chgData name="Abhishek Ojha" userId="253db238782fe597" providerId="LiveId" clId="{D78D3E2C-8E82-4946-8FE6-3E884FAE925F}" dt="2023-07-14T09:02:36.552" v="1080" actId="571"/>
          <ac:spMkLst>
            <pc:docMk/>
            <pc:sldMk cId="3032515962" sldId="263"/>
            <ac:spMk id="33" creationId="{C0D5771D-8833-ED6B-4468-E4D0D36A06DD}"/>
          </ac:spMkLst>
        </pc:spChg>
        <pc:spChg chg="mod">
          <ac:chgData name="Abhishek Ojha" userId="253db238782fe597" providerId="LiveId" clId="{D78D3E2C-8E82-4946-8FE6-3E884FAE925F}" dt="2023-07-14T09:02:36.552" v="1080" actId="571"/>
          <ac:spMkLst>
            <pc:docMk/>
            <pc:sldMk cId="3032515962" sldId="263"/>
            <ac:spMk id="34" creationId="{B7806CF5-1284-B3FB-7152-709BCB5EE3AD}"/>
          </ac:spMkLst>
        </pc:spChg>
        <pc:spChg chg="mod">
          <ac:chgData name="Abhishek Ojha" userId="253db238782fe597" providerId="LiveId" clId="{D78D3E2C-8E82-4946-8FE6-3E884FAE925F}" dt="2023-07-14T09:02:45.849" v="1093" actId="1037"/>
          <ac:spMkLst>
            <pc:docMk/>
            <pc:sldMk cId="3032515962" sldId="263"/>
            <ac:spMk id="35" creationId="{8E1A93B9-62E3-35CD-5F78-A702CBEC57B7}"/>
          </ac:spMkLst>
        </pc:spChg>
        <pc:spChg chg="mod">
          <ac:chgData name="Abhishek Ojha" userId="253db238782fe597" providerId="LiveId" clId="{D78D3E2C-8E82-4946-8FE6-3E884FAE925F}" dt="2023-07-14T09:02:45.849" v="1093" actId="1037"/>
          <ac:spMkLst>
            <pc:docMk/>
            <pc:sldMk cId="3032515962" sldId="263"/>
            <ac:spMk id="36" creationId="{4330EB3F-2041-F8F8-96A8-AABF022A14E6}"/>
          </ac:spMkLst>
        </pc:spChg>
        <pc:spChg chg="mod">
          <ac:chgData name="Abhishek Ojha" userId="253db238782fe597" providerId="LiveId" clId="{D78D3E2C-8E82-4946-8FE6-3E884FAE925F}" dt="2023-07-14T09:02:45.849" v="1093" actId="1037"/>
          <ac:spMkLst>
            <pc:docMk/>
            <pc:sldMk cId="3032515962" sldId="263"/>
            <ac:spMk id="37" creationId="{7B976DCC-446B-7405-5299-8373095B0764}"/>
          </ac:spMkLst>
        </pc:spChg>
        <pc:spChg chg="mod">
          <ac:chgData name="Abhishek Ojha" userId="253db238782fe597" providerId="LiveId" clId="{D78D3E2C-8E82-4946-8FE6-3E884FAE925F}" dt="2023-07-14T09:02:45.849" v="1093" actId="1037"/>
          <ac:spMkLst>
            <pc:docMk/>
            <pc:sldMk cId="3032515962" sldId="263"/>
            <ac:spMk id="38" creationId="{12908D70-26C6-98D0-89CA-59FCA6D63E5B}"/>
          </ac:spMkLst>
        </pc:spChg>
        <pc:spChg chg="mod">
          <ac:chgData name="Abhishek Ojha" userId="253db238782fe597" providerId="LiveId" clId="{D78D3E2C-8E82-4946-8FE6-3E884FAE925F}" dt="2023-07-14T09:02:45.849" v="1093" actId="1037"/>
          <ac:spMkLst>
            <pc:docMk/>
            <pc:sldMk cId="3032515962" sldId="263"/>
            <ac:spMk id="39" creationId="{FA15720A-BB48-A055-FBD5-178535B62FED}"/>
          </ac:spMkLst>
        </pc:spChg>
        <pc:spChg chg="add mod">
          <ac:chgData name="Abhishek Ojha" userId="253db238782fe597" providerId="LiveId" clId="{D78D3E2C-8E82-4946-8FE6-3E884FAE925F}" dt="2023-07-14T09:02:36.552" v="1080" actId="571"/>
          <ac:spMkLst>
            <pc:docMk/>
            <pc:sldMk cId="3032515962" sldId="263"/>
            <ac:spMk id="40" creationId="{BB3AC6F1-680E-21DE-2B13-8F2B04AB9064}"/>
          </ac:spMkLst>
        </pc:spChg>
        <pc:spChg chg="add mod">
          <ac:chgData name="Abhishek Ojha" userId="253db238782fe597" providerId="LiveId" clId="{D78D3E2C-8E82-4946-8FE6-3E884FAE925F}" dt="2023-07-14T09:02:36.552" v="1080" actId="571"/>
          <ac:spMkLst>
            <pc:docMk/>
            <pc:sldMk cId="3032515962" sldId="263"/>
            <ac:spMk id="41" creationId="{3595A637-3CCB-F413-5029-8E0926E6C5DA}"/>
          </ac:spMkLst>
        </pc:spChg>
        <pc:spChg chg="add del mod">
          <ac:chgData name="Abhishek Ojha" userId="253db238782fe597" providerId="LiveId" clId="{D78D3E2C-8E82-4946-8FE6-3E884FAE925F}" dt="2023-07-14T09:10:01.849" v="1100" actId="478"/>
          <ac:spMkLst>
            <pc:docMk/>
            <pc:sldMk cId="3032515962" sldId="263"/>
            <ac:spMk id="42" creationId="{42C2CC48-9AED-36D2-171A-417E4912134C}"/>
          </ac:spMkLst>
        </pc:spChg>
        <pc:spChg chg="mod">
          <ac:chgData name="Abhishek Ojha" userId="253db238782fe597" providerId="LiveId" clId="{D78D3E2C-8E82-4946-8FE6-3E884FAE925F}" dt="2023-07-14T09:12:59.595" v="1102"/>
          <ac:spMkLst>
            <pc:docMk/>
            <pc:sldMk cId="3032515962" sldId="263"/>
            <ac:spMk id="45" creationId="{A5DAEFA1-D967-2A3E-A750-50A78A6F2169}"/>
          </ac:spMkLst>
        </pc:spChg>
        <pc:spChg chg="mod">
          <ac:chgData name="Abhishek Ojha" userId="253db238782fe597" providerId="LiveId" clId="{D78D3E2C-8E82-4946-8FE6-3E884FAE925F}" dt="2023-07-14T09:12:59.595" v="1102"/>
          <ac:spMkLst>
            <pc:docMk/>
            <pc:sldMk cId="3032515962" sldId="263"/>
            <ac:spMk id="47" creationId="{BB05B8AD-F8C6-5DD7-BE89-9BE3B98E4544}"/>
          </ac:spMkLst>
        </pc:spChg>
        <pc:spChg chg="mod">
          <ac:chgData name="Abhishek Ojha" userId="253db238782fe597" providerId="LiveId" clId="{D78D3E2C-8E82-4946-8FE6-3E884FAE925F}" dt="2023-07-14T09:12:59.595" v="1102"/>
          <ac:spMkLst>
            <pc:docMk/>
            <pc:sldMk cId="3032515962" sldId="263"/>
            <ac:spMk id="48" creationId="{85B2D2EB-7A69-2E12-2F71-F41B8D88C503}"/>
          </ac:spMkLst>
        </pc:spChg>
        <pc:spChg chg="mod">
          <ac:chgData name="Abhishek Ojha" userId="253db238782fe597" providerId="LiveId" clId="{D78D3E2C-8E82-4946-8FE6-3E884FAE925F}" dt="2023-07-14T09:12:59.595" v="1102"/>
          <ac:spMkLst>
            <pc:docMk/>
            <pc:sldMk cId="3032515962" sldId="263"/>
            <ac:spMk id="49" creationId="{7E524FD3-54FE-2AC7-51EE-7F7C79C2BF81}"/>
          </ac:spMkLst>
        </pc:spChg>
        <pc:spChg chg="mod">
          <ac:chgData name="Abhishek Ojha" userId="253db238782fe597" providerId="LiveId" clId="{D78D3E2C-8E82-4946-8FE6-3E884FAE925F}" dt="2023-07-14T09:12:59.595" v="1102"/>
          <ac:spMkLst>
            <pc:docMk/>
            <pc:sldMk cId="3032515962" sldId="263"/>
            <ac:spMk id="50" creationId="{70565704-9A5B-5305-9C3A-FB604324ECD4}"/>
          </ac:spMkLst>
        </pc:spChg>
        <pc:spChg chg="mod">
          <ac:chgData name="Abhishek Ojha" userId="253db238782fe597" providerId="LiveId" clId="{D78D3E2C-8E82-4946-8FE6-3E884FAE925F}" dt="2023-07-14T09:12:59.595" v="1102"/>
          <ac:spMkLst>
            <pc:docMk/>
            <pc:sldMk cId="3032515962" sldId="263"/>
            <ac:spMk id="51" creationId="{32D92463-9D0E-EDE5-D8DE-0B84D4BF4D70}"/>
          </ac:spMkLst>
        </pc:spChg>
        <pc:spChg chg="mod">
          <ac:chgData name="Abhishek Ojha" userId="253db238782fe597" providerId="LiveId" clId="{D78D3E2C-8E82-4946-8FE6-3E884FAE925F}" dt="2023-07-14T09:12:59.595" v="1102"/>
          <ac:spMkLst>
            <pc:docMk/>
            <pc:sldMk cId="3032515962" sldId="263"/>
            <ac:spMk id="52" creationId="{55EC5C30-C2F1-E583-A746-777BE7294914}"/>
          </ac:spMkLst>
        </pc:spChg>
        <pc:spChg chg="add mod">
          <ac:chgData name="Abhishek Ojha" userId="253db238782fe597" providerId="LiveId" clId="{D78D3E2C-8E82-4946-8FE6-3E884FAE925F}" dt="2023-07-14T09:13:30.102" v="1280" actId="20577"/>
          <ac:spMkLst>
            <pc:docMk/>
            <pc:sldMk cId="3032515962" sldId="263"/>
            <ac:spMk id="53" creationId="{DEEDACB6-5FF1-5777-2AA5-99E41F49EABD}"/>
          </ac:spMkLst>
        </pc:spChg>
        <pc:grpChg chg="add del mod">
          <ac:chgData name="Abhishek Ojha" userId="253db238782fe597" providerId="LiveId" clId="{D78D3E2C-8E82-4946-8FE6-3E884FAE925F}" dt="2023-07-14T09:10:03.637" v="1101" actId="478"/>
          <ac:grpSpMkLst>
            <pc:docMk/>
            <pc:sldMk cId="3032515962" sldId="263"/>
            <ac:grpSpMk id="4" creationId="{CF34DD43-4084-B2F2-F76A-419ED0ECA6D6}"/>
          </ac:grpSpMkLst>
        </pc:grpChg>
        <pc:grpChg chg="mod">
          <ac:chgData name="Abhishek Ojha" userId="253db238782fe597" providerId="LiveId" clId="{D78D3E2C-8E82-4946-8FE6-3E884FAE925F}" dt="2023-07-14T07:10:40.078" v="593"/>
          <ac:grpSpMkLst>
            <pc:docMk/>
            <pc:sldMk cId="3032515962" sldId="263"/>
            <ac:grpSpMk id="5" creationId="{2EFCDEFF-CEA9-A158-D009-C9FAA1AD262F}"/>
          </ac:grpSpMkLst>
        </pc:grpChg>
        <pc:grpChg chg="add del mod">
          <ac:chgData name="Abhishek Ojha" userId="253db238782fe597" providerId="LiveId" clId="{D78D3E2C-8E82-4946-8FE6-3E884FAE925F}" dt="2023-07-14T08:22:22.350" v="849" actId="478"/>
          <ac:grpSpMkLst>
            <pc:docMk/>
            <pc:sldMk cId="3032515962" sldId="263"/>
            <ac:grpSpMk id="14" creationId="{797EBC89-997A-EDBA-C257-B1FA1767E87D}"/>
          </ac:grpSpMkLst>
        </pc:grpChg>
        <pc:grpChg chg="mod">
          <ac:chgData name="Abhishek Ojha" userId="253db238782fe597" providerId="LiveId" clId="{D78D3E2C-8E82-4946-8FE6-3E884FAE925F}" dt="2023-07-14T08:21:59.448" v="709"/>
          <ac:grpSpMkLst>
            <pc:docMk/>
            <pc:sldMk cId="3032515962" sldId="263"/>
            <ac:grpSpMk id="15" creationId="{8C2CE29C-116E-C120-3FFA-6184AC3222F4}"/>
          </ac:grpSpMkLst>
        </pc:grpChg>
        <pc:grpChg chg="add mod">
          <ac:chgData name="Abhishek Ojha" userId="253db238782fe597" providerId="LiveId" clId="{D78D3E2C-8E82-4946-8FE6-3E884FAE925F}" dt="2023-07-14T09:02:36.552" v="1080" actId="571"/>
          <ac:grpSpMkLst>
            <pc:docMk/>
            <pc:sldMk cId="3032515962" sldId="263"/>
            <ac:grpSpMk id="27" creationId="{034E83D2-5C6A-D414-9D7E-D01174FA0CF9}"/>
          </ac:grpSpMkLst>
        </pc:grpChg>
        <pc:grpChg chg="mod">
          <ac:chgData name="Abhishek Ojha" userId="253db238782fe597" providerId="LiveId" clId="{D78D3E2C-8E82-4946-8FE6-3E884FAE925F}" dt="2023-07-14T09:02:36.552" v="1080" actId="571"/>
          <ac:grpSpMkLst>
            <pc:docMk/>
            <pc:sldMk cId="3032515962" sldId="263"/>
            <ac:grpSpMk id="28" creationId="{DCBA8382-50E7-29A8-F9EC-6D3A4F0F408C}"/>
          </ac:grpSpMkLst>
        </pc:grpChg>
        <pc:grpChg chg="add mod">
          <ac:chgData name="Abhishek Ojha" userId="253db238782fe597" providerId="LiveId" clId="{D78D3E2C-8E82-4946-8FE6-3E884FAE925F}" dt="2023-07-14T09:13:08.200" v="1129" actId="1038"/>
          <ac:grpSpMkLst>
            <pc:docMk/>
            <pc:sldMk cId="3032515962" sldId="263"/>
            <ac:grpSpMk id="43" creationId="{70AD3004-F117-D67E-89FA-8AEC30599BF8}"/>
          </ac:grpSpMkLst>
        </pc:grpChg>
        <pc:grpChg chg="mod">
          <ac:chgData name="Abhishek Ojha" userId="253db238782fe597" providerId="LiveId" clId="{D78D3E2C-8E82-4946-8FE6-3E884FAE925F}" dt="2023-07-14T09:12:59.595" v="1102"/>
          <ac:grpSpMkLst>
            <pc:docMk/>
            <pc:sldMk cId="3032515962" sldId="263"/>
            <ac:grpSpMk id="44" creationId="{B92E3AC6-4D47-8191-D36D-B17265981D70}"/>
          </ac:grpSpMkLst>
        </pc:grpChg>
        <pc:graphicFrameChg chg="mod">
          <ac:chgData name="Abhishek Ojha" userId="253db238782fe597" providerId="LiveId" clId="{D78D3E2C-8E82-4946-8FE6-3E884FAE925F}" dt="2023-07-14T08:59:38.017" v="852"/>
          <ac:graphicFrameMkLst>
            <pc:docMk/>
            <pc:sldMk cId="3032515962" sldId="263"/>
            <ac:graphicFrameMk id="7" creationId="{4B38B625-ECDA-AD96-24A3-1A5322D0CDC8}"/>
          </ac:graphicFrameMkLst>
        </pc:graphicFrameChg>
        <pc:graphicFrameChg chg="mod">
          <ac:chgData name="Abhishek Ojha" userId="253db238782fe597" providerId="LiveId" clId="{D78D3E2C-8E82-4946-8FE6-3E884FAE925F}" dt="2023-07-14T08:21:59.448" v="709"/>
          <ac:graphicFrameMkLst>
            <pc:docMk/>
            <pc:sldMk cId="3032515962" sldId="263"/>
            <ac:graphicFrameMk id="17" creationId="{D761F793-B532-ED70-A1EE-298B4AF6AFD3}"/>
          </ac:graphicFrameMkLst>
        </pc:graphicFrameChg>
        <pc:graphicFrameChg chg="mod">
          <ac:chgData name="Abhishek Ojha" userId="253db238782fe597" providerId="LiveId" clId="{D78D3E2C-8E82-4946-8FE6-3E884FAE925F}" dt="2023-07-14T09:02:36.552" v="1080" actId="571"/>
          <ac:graphicFrameMkLst>
            <pc:docMk/>
            <pc:sldMk cId="3032515962" sldId="263"/>
            <ac:graphicFrameMk id="30" creationId="{AECF7FB2-2479-0744-3482-1F461942F59C}"/>
          </ac:graphicFrameMkLst>
        </pc:graphicFrameChg>
        <pc:graphicFrameChg chg="mod">
          <ac:chgData name="Abhishek Ojha" userId="253db238782fe597" providerId="LiveId" clId="{D78D3E2C-8E82-4946-8FE6-3E884FAE925F}" dt="2023-07-14T09:12:59.595" v="1102"/>
          <ac:graphicFrameMkLst>
            <pc:docMk/>
            <pc:sldMk cId="3032515962" sldId="263"/>
            <ac:graphicFrameMk id="46" creationId="{56F353DD-1644-B6A2-B5F1-793AA1221A42}"/>
          </ac:graphicFrameMkLst>
        </pc:graphicFrameChg>
      </pc:sldChg>
      <pc:sldChg chg="addSp delSp modSp new del mod">
        <pc:chgData name="Abhishek Ojha" userId="253db238782fe597" providerId="LiveId" clId="{D78D3E2C-8E82-4946-8FE6-3E884FAE925F}" dt="2023-07-19T06:24:09.819" v="4414" actId="47"/>
        <pc:sldMkLst>
          <pc:docMk/>
          <pc:sldMk cId="3203479096" sldId="264"/>
        </pc:sldMkLst>
        <pc:spChg chg="del">
          <ac:chgData name="Abhishek Ojha" userId="253db238782fe597" providerId="LiveId" clId="{D78D3E2C-8E82-4946-8FE6-3E884FAE925F}" dt="2023-07-17T06:35:18.702" v="1288" actId="478"/>
          <ac:spMkLst>
            <pc:docMk/>
            <pc:sldMk cId="3203479096" sldId="264"/>
            <ac:spMk id="2" creationId="{3CB34DDB-AD4D-273C-0148-8946BB5D17D0}"/>
          </ac:spMkLst>
        </pc:spChg>
        <pc:spChg chg="add mod">
          <ac:chgData name="Abhishek Ojha" userId="253db238782fe597" providerId="LiveId" clId="{D78D3E2C-8E82-4946-8FE6-3E884FAE925F}" dt="2023-07-18T09:36:48.628" v="1420" actId="1076"/>
          <ac:spMkLst>
            <pc:docMk/>
            <pc:sldMk cId="3203479096" sldId="264"/>
            <ac:spMk id="3" creationId="{3CD2C8A4-BAF0-A348-2F8F-CD60C6D7FC15}"/>
          </ac:spMkLst>
        </pc:spChg>
        <pc:spChg chg="del">
          <ac:chgData name="Abhishek Ojha" userId="253db238782fe597" providerId="LiveId" clId="{D78D3E2C-8E82-4946-8FE6-3E884FAE925F}" dt="2023-07-17T06:35:18.702" v="1288" actId="478"/>
          <ac:spMkLst>
            <pc:docMk/>
            <pc:sldMk cId="3203479096" sldId="264"/>
            <ac:spMk id="3" creationId="{D7DA4786-6866-3719-9112-2876F4697F00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6" creationId="{3454A1FF-2E84-E361-6A4F-1F6174F8E183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7" creationId="{69EBDED8-5170-E4A5-3EF8-9638A3496F55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8" creationId="{D9A5C0A3-73F9-E98D-ADEF-8F50EACA4689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9" creationId="{ABD654C8-970A-058D-AC03-AE119968F075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0" creationId="{012C6845-547D-537C-EC17-46DB46343C91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1" creationId="{CD51BDF2-0279-4CFE-4D04-9C75CB1BD8A4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2" creationId="{48207165-07D7-C7C8-58E6-F8A24FF6CDD7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3" creationId="{A6A31FD2-4ADF-2DD0-DECA-C74D4B8F4497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4" creationId="{63802F43-3617-14A4-2B9E-E1115361A2C8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5" creationId="{B33A633C-E3C6-8266-E884-E5C053EAD9E0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6" creationId="{60EED037-6EB4-B598-7974-61B1EB92E29E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7" creationId="{A7490E4E-C745-77DC-2C2B-F8C7BD303B39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8" creationId="{9E1BF2D1-0C7B-51EC-B6BF-5193FEC3C446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19" creationId="{5B03E388-42AD-E3E2-AA0E-38D4B395DE02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20" creationId="{1A8E6150-E609-60DF-6918-7BA55CEBC954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21" creationId="{F50DDA29-3D5D-4ADE-0C37-7EB1F40E46CD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22" creationId="{E008C45A-38C9-EAE8-8554-9F452BE66298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23" creationId="{C4E97C39-ADD8-8618-778B-CA1F4C955476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24" creationId="{AE8070B7-8A54-FBDE-CCFD-66B288A6D4AE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25" creationId="{60C2F05A-173B-8FF6-A7A2-9CFA56AE3469}"/>
          </ac:spMkLst>
        </pc:spChg>
        <pc:spChg chg="mod">
          <ac:chgData name="Abhishek Ojha" userId="253db238782fe597" providerId="LiveId" clId="{D78D3E2C-8E82-4946-8FE6-3E884FAE925F}" dt="2023-07-17T06:35:19.514" v="1289"/>
          <ac:spMkLst>
            <pc:docMk/>
            <pc:sldMk cId="3203479096" sldId="264"/>
            <ac:spMk id="26" creationId="{17B5E2BB-9968-4200-9FE8-ACE3F2BA69A3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28" creationId="{6DADA4C7-B478-53BF-0D11-F3770176EB12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29" creationId="{F2C0E00D-C43F-BB17-4BD7-6D0DBA82590C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0" creationId="{60024A64-7EFE-9F17-3371-2B4FA9D3AE52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1" creationId="{848C42DB-031F-B0E0-B9C0-7A89AB391E54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2" creationId="{938AD541-073F-78B1-40E5-7ABFA2C767C1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3" creationId="{6E917A1F-EBC0-4A2B-65A0-CA6E23D51633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4" creationId="{78801C89-682B-694A-B422-BFB5D54B6DA5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5" creationId="{A9A4E2AB-9920-DD86-FA30-1A6A5D8FA7B8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6" creationId="{58406EDA-F9DE-1900-CF10-A49598A11CFE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7" creationId="{1B616981-C43C-4CBB-C164-CD7906BEA474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8" creationId="{3F9AA7AA-7EF7-0271-3FDB-E693C5B6A55A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39" creationId="{96DEA951-4558-3C78-1D91-C86202F2C5EB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0" creationId="{657ED283-FCD1-8E02-CF90-B10C082E9FC9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1" creationId="{08C5A1E2-5E72-A1AD-CEBC-B7F2F804D60C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2" creationId="{010A5E80-9AE6-5EAC-291B-A240A137C62D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3" creationId="{A1060C4C-DA68-C742-EC67-DA908183DCD4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4" creationId="{3D9DEE23-7FBF-44FC-94F3-5FFA42844C29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5" creationId="{C84D99B6-4BC1-A835-57C3-E20FEDF66FCD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6" creationId="{C10C6C63-5936-5BAF-505C-C814C6663363}"/>
          </ac:spMkLst>
        </pc:spChg>
        <pc:spChg chg="add mod">
          <ac:chgData name="Abhishek Ojha" userId="253db238782fe597" providerId="LiveId" clId="{D78D3E2C-8E82-4946-8FE6-3E884FAE925F}" dt="2023-07-19T06:14:47.705" v="3859" actId="164"/>
          <ac:spMkLst>
            <pc:docMk/>
            <pc:sldMk cId="3203479096" sldId="264"/>
            <ac:spMk id="47" creationId="{91F0D114-5A57-79CE-C0EC-E5955B822551}"/>
          </ac:spMkLst>
        </pc:spChg>
        <pc:spChg chg="add del mod">
          <ac:chgData name="Abhishek Ojha" userId="253db238782fe597" providerId="LiveId" clId="{D78D3E2C-8E82-4946-8FE6-3E884FAE925F}" dt="2023-07-19T06:15:02.486" v="3866" actId="478"/>
          <ac:spMkLst>
            <pc:docMk/>
            <pc:sldMk cId="3203479096" sldId="264"/>
            <ac:spMk id="55" creationId="{7873F9AA-0455-D38D-C841-554E081799B8}"/>
          </ac:spMkLst>
        </pc:spChg>
        <pc:spChg chg="mod">
          <ac:chgData name="Abhishek Ojha" userId="253db238782fe597" providerId="LiveId" clId="{D78D3E2C-8E82-4946-8FE6-3E884FAE925F}" dt="2023-07-19T06:19:07.013" v="4116"/>
          <ac:spMkLst>
            <pc:docMk/>
            <pc:sldMk cId="3203479096" sldId="264"/>
            <ac:spMk id="57" creationId="{CA9BA7B3-B9FB-3E28-A7B9-2868F46F152C}"/>
          </ac:spMkLst>
        </pc:spChg>
        <pc:spChg chg="mod">
          <ac:chgData name="Abhishek Ojha" userId="253db238782fe597" providerId="LiveId" clId="{D78D3E2C-8E82-4946-8FE6-3E884FAE925F}" dt="2023-07-19T06:19:07.013" v="4116"/>
          <ac:spMkLst>
            <pc:docMk/>
            <pc:sldMk cId="3203479096" sldId="264"/>
            <ac:spMk id="58" creationId="{3FBB2AC2-E1D4-A55F-AAC2-19C66765ADBF}"/>
          </ac:spMkLst>
        </pc:spChg>
        <pc:spChg chg="mod">
          <ac:chgData name="Abhishek Ojha" userId="253db238782fe597" providerId="LiveId" clId="{D78D3E2C-8E82-4946-8FE6-3E884FAE925F}" dt="2023-07-19T06:19:07.013" v="4116"/>
          <ac:spMkLst>
            <pc:docMk/>
            <pc:sldMk cId="3203479096" sldId="264"/>
            <ac:spMk id="59" creationId="{C7EE1869-5919-7B46-700B-A4D0C22DC5EF}"/>
          </ac:spMkLst>
        </pc:spChg>
        <pc:spChg chg="mod">
          <ac:chgData name="Abhishek Ojha" userId="253db238782fe597" providerId="LiveId" clId="{D78D3E2C-8E82-4946-8FE6-3E884FAE925F}" dt="2023-07-19T06:19:07.013" v="4116"/>
          <ac:spMkLst>
            <pc:docMk/>
            <pc:sldMk cId="3203479096" sldId="264"/>
            <ac:spMk id="60" creationId="{828754EC-3B1C-AB37-54BE-79D13F4C270D}"/>
          </ac:spMkLst>
        </pc:spChg>
        <pc:spChg chg="mod">
          <ac:chgData name="Abhishek Ojha" userId="253db238782fe597" providerId="LiveId" clId="{D78D3E2C-8E82-4946-8FE6-3E884FAE925F}" dt="2023-07-19T06:19:07.013" v="4116"/>
          <ac:spMkLst>
            <pc:docMk/>
            <pc:sldMk cId="3203479096" sldId="264"/>
            <ac:spMk id="61" creationId="{05CB7FF9-0793-6665-0BDD-BE5A6B5FC821}"/>
          </ac:spMkLst>
        </pc:spChg>
        <pc:spChg chg="mod">
          <ac:chgData name="Abhishek Ojha" userId="253db238782fe597" providerId="LiveId" clId="{D78D3E2C-8E82-4946-8FE6-3E884FAE925F}" dt="2023-07-19T06:19:07.013" v="4116"/>
          <ac:spMkLst>
            <pc:docMk/>
            <pc:sldMk cId="3203479096" sldId="264"/>
            <ac:spMk id="62" creationId="{64FB941D-FB7E-158D-B11B-E1FA5A05E304}"/>
          </ac:spMkLst>
        </pc:spChg>
        <pc:grpChg chg="add del mod">
          <ac:chgData name="Abhishek Ojha" userId="253db238782fe597" providerId="LiveId" clId="{D78D3E2C-8E82-4946-8FE6-3E884FAE925F}" dt="2023-07-19T06:20:31.256" v="4333" actId="478"/>
          <ac:grpSpMkLst>
            <pc:docMk/>
            <pc:sldMk cId="3203479096" sldId="264"/>
            <ac:grpSpMk id="4" creationId="{B63E3B9F-92A8-79AC-31E6-788ED47D77E4}"/>
          </ac:grpSpMkLst>
        </pc:grpChg>
        <pc:grpChg chg="add mod">
          <ac:chgData name="Abhishek Ojha" userId="253db238782fe597" providerId="LiveId" clId="{D78D3E2C-8E82-4946-8FE6-3E884FAE925F}" dt="2023-07-19T06:20:21.748" v="4331" actId="164"/>
          <ac:grpSpMkLst>
            <pc:docMk/>
            <pc:sldMk cId="3203479096" sldId="264"/>
            <ac:grpSpMk id="54" creationId="{2A247FAF-E397-569D-4A41-64A8E86CBF90}"/>
          </ac:grpSpMkLst>
        </pc:grpChg>
        <pc:grpChg chg="add mod">
          <ac:chgData name="Abhishek Ojha" userId="253db238782fe597" providerId="LiveId" clId="{D78D3E2C-8E82-4946-8FE6-3E884FAE925F}" dt="2023-07-19T06:20:21.748" v="4331" actId="164"/>
          <ac:grpSpMkLst>
            <pc:docMk/>
            <pc:sldMk cId="3203479096" sldId="264"/>
            <ac:grpSpMk id="56" creationId="{A2419C44-209F-4F3F-A5C1-48AEF948E30C}"/>
          </ac:grpSpMkLst>
        </pc:grpChg>
        <pc:grpChg chg="add mod">
          <ac:chgData name="Abhishek Ojha" userId="253db238782fe597" providerId="LiveId" clId="{D78D3E2C-8E82-4946-8FE6-3E884FAE925F}" dt="2023-07-19T06:20:21.748" v="4331" actId="164"/>
          <ac:grpSpMkLst>
            <pc:docMk/>
            <pc:sldMk cId="3203479096" sldId="264"/>
            <ac:grpSpMk id="63" creationId="{FD2649CF-AC56-08D5-B7A8-FA1185BF0B1E}"/>
          </ac:grpSpMkLst>
        </pc:grpChg>
        <pc:picChg chg="add mod modCrop">
          <ac:chgData name="Abhishek Ojha" userId="253db238782fe597" providerId="LiveId" clId="{D78D3E2C-8E82-4946-8FE6-3E884FAE925F}" dt="2023-07-19T06:14:47.705" v="3859" actId="164"/>
          <ac:picMkLst>
            <pc:docMk/>
            <pc:sldMk cId="3203479096" sldId="264"/>
            <ac:picMk id="2" creationId="{1EDDAC5B-9B09-BD84-7269-69DBCD8CF763}"/>
          </ac:picMkLst>
        </pc:picChg>
        <pc:picChg chg="mod">
          <ac:chgData name="Abhishek Ojha" userId="253db238782fe597" providerId="LiveId" clId="{D78D3E2C-8E82-4946-8FE6-3E884FAE925F}" dt="2023-07-17T06:35:19.514" v="1289"/>
          <ac:picMkLst>
            <pc:docMk/>
            <pc:sldMk cId="3203479096" sldId="264"/>
            <ac:picMk id="5" creationId="{42466559-03D3-D4D7-ACC6-560727E41F84}"/>
          </ac:picMkLst>
        </pc:picChg>
        <pc:picChg chg="add del mod">
          <ac:chgData name="Abhishek Ojha" userId="253db238782fe597" providerId="LiveId" clId="{D78D3E2C-8E82-4946-8FE6-3E884FAE925F}" dt="2023-07-19T06:20:25.017" v="4332" actId="478"/>
          <ac:picMkLst>
            <pc:docMk/>
            <pc:sldMk cId="3203479096" sldId="264"/>
            <ac:picMk id="27" creationId="{8E5CD23F-C7F6-4881-FC34-4D395E72DE1E}"/>
          </ac:picMkLst>
        </pc:picChg>
        <pc:cxnChg chg="add del mod">
          <ac:chgData name="Abhishek Ojha" userId="253db238782fe597" providerId="LiveId" clId="{D78D3E2C-8E82-4946-8FE6-3E884FAE925F}" dt="2023-07-19T06:11:15.343" v="3650" actId="478"/>
          <ac:cxnSpMkLst>
            <pc:docMk/>
            <pc:sldMk cId="3203479096" sldId="264"/>
            <ac:cxnSpMk id="49" creationId="{1A065C08-DAAC-8BFB-69B1-396242E31011}"/>
          </ac:cxnSpMkLst>
        </pc:cxnChg>
        <pc:cxnChg chg="add del mod">
          <ac:chgData name="Abhishek Ojha" userId="253db238782fe597" providerId="LiveId" clId="{D78D3E2C-8E82-4946-8FE6-3E884FAE925F}" dt="2023-07-19T06:12:47.627" v="3754" actId="478"/>
          <ac:cxnSpMkLst>
            <pc:docMk/>
            <pc:sldMk cId="3203479096" sldId="264"/>
            <ac:cxnSpMk id="53" creationId="{562BFF9E-69C3-236A-C046-3238F7CAA889}"/>
          </ac:cxnSpMkLst>
        </pc:cxnChg>
      </pc:sldChg>
      <pc:sldChg chg="addSp delSp modSp new del mod ord">
        <pc:chgData name="Abhishek Ojha" userId="253db238782fe597" providerId="LiveId" clId="{D78D3E2C-8E82-4946-8FE6-3E884FAE925F}" dt="2023-07-19T06:24:20.524" v="4415" actId="47"/>
        <pc:sldMkLst>
          <pc:docMk/>
          <pc:sldMk cId="4195358371" sldId="265"/>
        </pc:sldMkLst>
        <pc:spChg chg="del">
          <ac:chgData name="Abhishek Ojha" userId="253db238782fe597" providerId="LiveId" clId="{D78D3E2C-8E82-4946-8FE6-3E884FAE925F}" dt="2023-07-18T10:31:43.021" v="1422" actId="478"/>
          <ac:spMkLst>
            <pc:docMk/>
            <pc:sldMk cId="4195358371" sldId="265"/>
            <ac:spMk id="2" creationId="{08F8172E-3203-F078-F3D7-BF7C8B4787CA}"/>
          </ac:spMkLst>
        </pc:spChg>
        <pc:spChg chg="del">
          <ac:chgData name="Abhishek Ojha" userId="253db238782fe597" providerId="LiveId" clId="{D78D3E2C-8E82-4946-8FE6-3E884FAE925F}" dt="2023-07-18T10:31:43.021" v="1422" actId="478"/>
          <ac:spMkLst>
            <pc:docMk/>
            <pc:sldMk cId="4195358371" sldId="265"/>
            <ac:spMk id="3" creationId="{8E80BB5D-3D07-81EA-64F7-2043BB85696E}"/>
          </ac:spMkLst>
        </pc:spChg>
        <pc:spChg chg="add mod">
          <ac:chgData name="Abhishek Ojha" userId="253db238782fe597" providerId="LiveId" clId="{D78D3E2C-8E82-4946-8FE6-3E884FAE925F}" dt="2023-07-19T04:25:14.835" v="2023" actId="1076"/>
          <ac:spMkLst>
            <pc:docMk/>
            <pc:sldMk cId="4195358371" sldId="265"/>
            <ac:spMk id="7" creationId="{1FC81D07-9748-70E6-F8F6-A159B27E954F}"/>
          </ac:spMkLst>
        </pc:spChg>
        <pc:spChg chg="add mod">
          <ac:chgData name="Abhishek Ojha" userId="253db238782fe597" providerId="LiveId" clId="{D78D3E2C-8E82-4946-8FE6-3E884FAE925F}" dt="2023-07-18T10:46:21.140" v="1666" actId="1037"/>
          <ac:spMkLst>
            <pc:docMk/>
            <pc:sldMk cId="4195358371" sldId="265"/>
            <ac:spMk id="8" creationId="{35D349EB-068C-1F65-966C-7A5D7AF01A9A}"/>
          </ac:spMkLst>
        </pc:spChg>
        <pc:spChg chg="add mod">
          <ac:chgData name="Abhishek Ojha" userId="253db238782fe597" providerId="LiveId" clId="{D78D3E2C-8E82-4946-8FE6-3E884FAE925F}" dt="2023-07-18T10:46:37.637" v="1695" actId="1037"/>
          <ac:spMkLst>
            <pc:docMk/>
            <pc:sldMk cId="4195358371" sldId="265"/>
            <ac:spMk id="9" creationId="{3F4321D7-C75A-6A9D-089B-82EE0905D225}"/>
          </ac:spMkLst>
        </pc:spChg>
        <pc:spChg chg="add mod">
          <ac:chgData name="Abhishek Ojha" userId="253db238782fe597" providerId="LiveId" clId="{D78D3E2C-8E82-4946-8FE6-3E884FAE925F}" dt="2023-07-18T10:46:27.891" v="1677" actId="1035"/>
          <ac:spMkLst>
            <pc:docMk/>
            <pc:sldMk cId="4195358371" sldId="265"/>
            <ac:spMk id="10" creationId="{98F73A8D-4F25-F2A5-D8B8-DE7DC3F87170}"/>
          </ac:spMkLst>
        </pc:spChg>
        <pc:spChg chg="add mod">
          <ac:chgData name="Abhishek Ojha" userId="253db238782fe597" providerId="LiveId" clId="{D78D3E2C-8E82-4946-8FE6-3E884FAE925F}" dt="2023-07-19T04:25:18.544" v="2024" actId="1076"/>
          <ac:spMkLst>
            <pc:docMk/>
            <pc:sldMk cId="4195358371" sldId="265"/>
            <ac:spMk id="11" creationId="{AD6DBB23-3A02-EB47-6472-94B7933C8203}"/>
          </ac:spMkLst>
        </pc:spChg>
        <pc:spChg chg="add mod">
          <ac:chgData name="Abhishek Ojha" userId="253db238782fe597" providerId="LiveId" clId="{D78D3E2C-8E82-4946-8FE6-3E884FAE925F}" dt="2023-07-18T10:34:12.549" v="1462" actId="1076"/>
          <ac:spMkLst>
            <pc:docMk/>
            <pc:sldMk cId="4195358371" sldId="265"/>
            <ac:spMk id="13" creationId="{C5628781-64A1-7CFF-167F-8291BEF131DA}"/>
          </ac:spMkLst>
        </pc:spChg>
        <pc:spChg chg="add mod">
          <ac:chgData name="Abhishek Ojha" userId="253db238782fe597" providerId="LiveId" clId="{D78D3E2C-8E82-4946-8FE6-3E884FAE925F}" dt="2023-07-18T10:35:28.491" v="1476" actId="20577"/>
          <ac:spMkLst>
            <pc:docMk/>
            <pc:sldMk cId="4195358371" sldId="265"/>
            <ac:spMk id="16" creationId="{47426B51-D5B8-403E-9574-6A76060E5467}"/>
          </ac:spMkLst>
        </pc:spChg>
        <pc:spChg chg="add mod">
          <ac:chgData name="Abhishek Ojha" userId="253db238782fe597" providerId="LiveId" clId="{D78D3E2C-8E82-4946-8FE6-3E884FAE925F}" dt="2023-07-18T10:47:00.041" v="1715" actId="1036"/>
          <ac:spMkLst>
            <pc:docMk/>
            <pc:sldMk cId="4195358371" sldId="265"/>
            <ac:spMk id="17" creationId="{7A99F772-5F61-278B-B61A-726BE5E370BD}"/>
          </ac:spMkLst>
        </pc:spChg>
        <pc:spChg chg="add mod">
          <ac:chgData name="Abhishek Ojha" userId="253db238782fe597" providerId="LiveId" clId="{D78D3E2C-8E82-4946-8FE6-3E884FAE925F}" dt="2023-07-18T10:47:10.382" v="1737" actId="1038"/>
          <ac:spMkLst>
            <pc:docMk/>
            <pc:sldMk cId="4195358371" sldId="265"/>
            <ac:spMk id="18" creationId="{A1D4A727-BA58-3BAD-C9DD-72ABE5962D59}"/>
          </ac:spMkLst>
        </pc:spChg>
        <pc:spChg chg="add mod">
          <ac:chgData name="Abhishek Ojha" userId="253db238782fe597" providerId="LiveId" clId="{D78D3E2C-8E82-4946-8FE6-3E884FAE925F}" dt="2023-07-18T10:47:18.047" v="1759" actId="1038"/>
          <ac:spMkLst>
            <pc:docMk/>
            <pc:sldMk cId="4195358371" sldId="265"/>
            <ac:spMk id="19" creationId="{8DC4745D-F269-1B94-44C4-53FDC00ED680}"/>
          </ac:spMkLst>
        </pc:spChg>
        <pc:spChg chg="add mod">
          <ac:chgData name="Abhishek Ojha" userId="253db238782fe597" providerId="LiveId" clId="{D78D3E2C-8E82-4946-8FE6-3E884FAE925F}" dt="2023-07-18T10:48:25.999" v="1827" actId="208"/>
          <ac:spMkLst>
            <pc:docMk/>
            <pc:sldMk cId="4195358371" sldId="265"/>
            <ac:spMk id="20" creationId="{B75A5D46-0E28-6457-1CB9-2947C8E218D6}"/>
          </ac:spMkLst>
        </pc:spChg>
        <pc:spChg chg="add mod">
          <ac:chgData name="Abhishek Ojha" userId="253db238782fe597" providerId="LiveId" clId="{D78D3E2C-8E82-4946-8FE6-3E884FAE925F}" dt="2023-07-18T10:49:16.622" v="1829" actId="208"/>
          <ac:spMkLst>
            <pc:docMk/>
            <pc:sldMk cId="4195358371" sldId="265"/>
            <ac:spMk id="21" creationId="{CE695C44-3DF1-B4AB-D9A9-EB249CEFA275}"/>
          </ac:spMkLst>
        </pc:spChg>
        <pc:spChg chg="add mod">
          <ac:chgData name="Abhishek Ojha" userId="253db238782fe597" providerId="LiveId" clId="{D78D3E2C-8E82-4946-8FE6-3E884FAE925F}" dt="2023-07-18T10:49:34.637" v="1831" actId="208"/>
          <ac:spMkLst>
            <pc:docMk/>
            <pc:sldMk cId="4195358371" sldId="265"/>
            <ac:spMk id="22" creationId="{B2B83725-A1B4-E266-D8CF-E47A594A3D53}"/>
          </ac:spMkLst>
        </pc:spChg>
        <pc:spChg chg="add mod">
          <ac:chgData name="Abhishek Ojha" userId="253db238782fe597" providerId="LiveId" clId="{D78D3E2C-8E82-4946-8FE6-3E884FAE925F}" dt="2023-07-18T10:49:45.552" v="1833" actId="1076"/>
          <ac:spMkLst>
            <pc:docMk/>
            <pc:sldMk cId="4195358371" sldId="265"/>
            <ac:spMk id="23" creationId="{90B441DB-BF8C-6BBA-C6AD-00FF387921D3}"/>
          </ac:spMkLst>
        </pc:spChg>
        <pc:spChg chg="add mod">
          <ac:chgData name="Abhishek Ojha" userId="253db238782fe597" providerId="LiveId" clId="{D78D3E2C-8E82-4946-8FE6-3E884FAE925F}" dt="2023-07-19T05:55:55.172" v="2097" actId="1076"/>
          <ac:spMkLst>
            <pc:docMk/>
            <pc:sldMk cId="4195358371" sldId="265"/>
            <ac:spMk id="24" creationId="{ACBC9D59-1D0B-E061-0169-A38434F770B2}"/>
          </ac:spMkLst>
        </pc:spChg>
        <pc:spChg chg="add mod">
          <ac:chgData name="Abhishek Ojha" userId="253db238782fe597" providerId="LiveId" clId="{D78D3E2C-8E82-4946-8FE6-3E884FAE925F}" dt="2023-07-18T10:50:07.544" v="1950" actId="1076"/>
          <ac:spMkLst>
            <pc:docMk/>
            <pc:sldMk cId="4195358371" sldId="265"/>
            <ac:spMk id="25" creationId="{62CE33F4-527E-33B1-9DEC-E8DC7DDD9CEE}"/>
          </ac:spMkLst>
        </pc:spChg>
        <pc:picChg chg="add mod modCrop">
          <ac:chgData name="Abhishek Ojha" userId="253db238782fe597" providerId="LiveId" clId="{D78D3E2C-8E82-4946-8FE6-3E884FAE925F}" dt="2023-07-19T04:26:24.920" v="2029" actId="732"/>
          <ac:picMkLst>
            <pc:docMk/>
            <pc:sldMk cId="4195358371" sldId="265"/>
            <ac:picMk id="5" creationId="{91D86CA0-5D8F-748E-6AA0-BAAD349DAA6F}"/>
          </ac:picMkLst>
        </pc:picChg>
        <pc:picChg chg="add mod">
          <ac:chgData name="Abhishek Ojha" userId="253db238782fe597" providerId="LiveId" clId="{D78D3E2C-8E82-4946-8FE6-3E884FAE925F}" dt="2023-07-18T10:35:05.327" v="1466" actId="1076"/>
          <ac:picMkLst>
            <pc:docMk/>
            <pc:sldMk cId="4195358371" sldId="265"/>
            <ac:picMk id="15" creationId="{A6661FD1-CEF0-D30F-3672-A9880BD8D441}"/>
          </ac:picMkLst>
        </pc:picChg>
      </pc:sldChg>
      <pc:sldChg chg="addSp delSp modSp new mod ord">
        <pc:chgData name="Abhishek Ojha" userId="253db238782fe597" providerId="LiveId" clId="{D78D3E2C-8E82-4946-8FE6-3E884FAE925F}" dt="2023-07-28T10:34:14.607" v="7902" actId="1076"/>
        <pc:sldMkLst>
          <pc:docMk/>
          <pc:sldMk cId="3325828966" sldId="266"/>
        </pc:sldMkLst>
        <pc:spChg chg="del">
          <ac:chgData name="Abhishek Ojha" userId="253db238782fe597" providerId="LiveId" clId="{D78D3E2C-8E82-4946-8FE6-3E884FAE925F}" dt="2023-07-18T10:37:11.697" v="1485" actId="478"/>
          <ac:spMkLst>
            <pc:docMk/>
            <pc:sldMk cId="3325828966" sldId="266"/>
            <ac:spMk id="2" creationId="{CBA99852-D653-8E99-9205-9047F0DB5CAD}"/>
          </ac:spMkLst>
        </pc:spChg>
        <pc:spChg chg="add mod">
          <ac:chgData name="Abhishek Ojha" userId="253db238782fe597" providerId="LiveId" clId="{D78D3E2C-8E82-4946-8FE6-3E884FAE925F}" dt="2023-07-28T10:34:14.607" v="7902" actId="1076"/>
          <ac:spMkLst>
            <pc:docMk/>
            <pc:sldMk cId="3325828966" sldId="266"/>
            <ac:spMk id="2" creationId="{DEC42570-6FB0-0DAC-5720-FFA65205C8B6}"/>
          </ac:spMkLst>
        </pc:spChg>
        <pc:spChg chg="del">
          <ac:chgData name="Abhishek Ojha" userId="253db238782fe597" providerId="LiveId" clId="{D78D3E2C-8E82-4946-8FE6-3E884FAE925F}" dt="2023-07-18T10:37:11.697" v="1485" actId="478"/>
          <ac:spMkLst>
            <pc:docMk/>
            <pc:sldMk cId="3325828966" sldId="266"/>
            <ac:spMk id="3" creationId="{46D9CF50-F897-A793-8D30-F7785FC33D57}"/>
          </ac:spMkLst>
        </pc:spChg>
        <pc:spChg chg="add del mod">
          <ac:chgData name="Abhishek Ojha" userId="253db238782fe597" providerId="LiveId" clId="{D78D3E2C-8E82-4946-8FE6-3E884FAE925F}" dt="2023-07-19T04:43:15.967" v="2030" actId="478"/>
          <ac:spMkLst>
            <pc:docMk/>
            <pc:sldMk cId="3325828966" sldId="266"/>
            <ac:spMk id="5" creationId="{ED04A625-A499-33B7-A66D-149439653EF0}"/>
          </ac:spMkLst>
        </pc:spChg>
        <pc:spChg chg="add del mod">
          <ac:chgData name="Abhishek Ojha" userId="253db238782fe597" providerId="LiveId" clId="{D78D3E2C-8E82-4946-8FE6-3E884FAE925F}" dt="2023-07-19T04:43:18.886" v="2031" actId="478"/>
          <ac:spMkLst>
            <pc:docMk/>
            <pc:sldMk cId="3325828966" sldId="266"/>
            <ac:spMk id="6" creationId="{E0914E10-C5B0-3381-C44F-5806AE8C0ABC}"/>
          </ac:spMkLst>
        </pc:spChg>
        <pc:spChg chg="add del mod">
          <ac:chgData name="Abhishek Ojha" userId="253db238782fe597" providerId="LiveId" clId="{D78D3E2C-8E82-4946-8FE6-3E884FAE925F}" dt="2023-07-19T07:03:17.103" v="4501" actId="478"/>
          <ac:spMkLst>
            <pc:docMk/>
            <pc:sldMk cId="3325828966" sldId="266"/>
            <ac:spMk id="7" creationId="{A1742811-D771-5AFC-D853-125D03BAEBA4}"/>
          </ac:spMkLst>
        </pc:spChg>
        <pc:spChg chg="add del mod">
          <ac:chgData name="Abhishek Ojha" userId="253db238782fe597" providerId="LiveId" clId="{D78D3E2C-8E82-4946-8FE6-3E884FAE925F}" dt="2023-07-19T06:22:23.388" v="4413" actId="478"/>
          <ac:spMkLst>
            <pc:docMk/>
            <pc:sldMk cId="3325828966" sldId="266"/>
            <ac:spMk id="8" creationId="{1BC77CAD-9BFF-2A9F-AD38-406E199C71CB}"/>
          </ac:spMkLst>
        </pc:spChg>
        <pc:spChg chg="add del mod">
          <ac:chgData name="Abhishek Ojha" userId="253db238782fe597" providerId="LiveId" clId="{D78D3E2C-8E82-4946-8FE6-3E884FAE925F}" dt="2023-07-19T06:20:46.468" v="4335" actId="478"/>
          <ac:spMkLst>
            <pc:docMk/>
            <pc:sldMk cId="3325828966" sldId="266"/>
            <ac:spMk id="9" creationId="{6211CE50-63C7-725A-4979-2802B7865A2A}"/>
          </ac:spMkLst>
        </pc:spChg>
        <pc:spChg chg="add del mod">
          <ac:chgData name="Abhishek Ojha" userId="253db238782fe597" providerId="LiveId" clId="{D78D3E2C-8E82-4946-8FE6-3E884FAE925F}" dt="2023-07-19T06:20:46.468" v="4335" actId="478"/>
          <ac:spMkLst>
            <pc:docMk/>
            <pc:sldMk cId="3325828966" sldId="266"/>
            <ac:spMk id="10" creationId="{5045FCD9-902E-F189-59D9-C32B90E24344}"/>
          </ac:spMkLst>
        </pc:spChg>
        <pc:spChg chg="add del mod">
          <ac:chgData name="Abhishek Ojha" userId="253db238782fe597" providerId="LiveId" clId="{D78D3E2C-8E82-4946-8FE6-3E884FAE925F}" dt="2023-07-19T06:20:46.468" v="4335" actId="478"/>
          <ac:spMkLst>
            <pc:docMk/>
            <pc:sldMk cId="3325828966" sldId="266"/>
            <ac:spMk id="11" creationId="{CD496F8D-5646-C6D4-2DE7-9586F8F03425}"/>
          </ac:spMkLst>
        </pc:spChg>
        <pc:spChg chg="add mod">
          <ac:chgData name="Abhishek Ojha" userId="253db238782fe597" providerId="LiveId" clId="{D78D3E2C-8E82-4946-8FE6-3E884FAE925F}" dt="2023-07-19T06:19:00.390" v="4115" actId="164"/>
          <ac:spMkLst>
            <pc:docMk/>
            <pc:sldMk cId="3325828966" sldId="266"/>
            <ac:spMk id="12" creationId="{8F980DEB-611A-D997-87FC-D0D5162F54CC}"/>
          </ac:spMkLst>
        </pc:spChg>
        <pc:spChg chg="add mod">
          <ac:chgData name="Abhishek Ojha" userId="253db238782fe597" providerId="LiveId" clId="{D78D3E2C-8E82-4946-8FE6-3E884FAE925F}" dt="2023-07-19T06:19:00.390" v="4115" actId="164"/>
          <ac:spMkLst>
            <pc:docMk/>
            <pc:sldMk cId="3325828966" sldId="266"/>
            <ac:spMk id="13" creationId="{F5B040A4-0669-2EDC-25AD-15DC198C4D86}"/>
          </ac:spMkLst>
        </pc:spChg>
        <pc:spChg chg="add mod">
          <ac:chgData name="Abhishek Ojha" userId="253db238782fe597" providerId="LiveId" clId="{D78D3E2C-8E82-4946-8FE6-3E884FAE925F}" dt="2023-07-19T06:19:00.390" v="4115" actId="164"/>
          <ac:spMkLst>
            <pc:docMk/>
            <pc:sldMk cId="3325828966" sldId="266"/>
            <ac:spMk id="14" creationId="{E6546BE5-67C8-71A9-689A-BB6D9D5615CB}"/>
          </ac:spMkLst>
        </pc:spChg>
        <pc:spChg chg="add mod">
          <ac:chgData name="Abhishek Ojha" userId="253db238782fe597" providerId="LiveId" clId="{D78D3E2C-8E82-4946-8FE6-3E884FAE925F}" dt="2023-07-19T06:19:00.390" v="4115" actId="164"/>
          <ac:spMkLst>
            <pc:docMk/>
            <pc:sldMk cId="3325828966" sldId="266"/>
            <ac:spMk id="15" creationId="{5B0F9FAD-17EC-F503-0369-CE7181AA0645}"/>
          </ac:spMkLst>
        </pc:spChg>
        <pc:spChg chg="add mod">
          <ac:chgData name="Abhishek Ojha" userId="253db238782fe597" providerId="LiveId" clId="{D78D3E2C-8E82-4946-8FE6-3E884FAE925F}" dt="2023-07-19T06:19:00.390" v="4115" actId="164"/>
          <ac:spMkLst>
            <pc:docMk/>
            <pc:sldMk cId="3325828966" sldId="266"/>
            <ac:spMk id="16" creationId="{D25E2C4C-DA50-53F0-4B0E-6C2FFADA2765}"/>
          </ac:spMkLst>
        </pc:spChg>
        <pc:spChg chg="add mod">
          <ac:chgData name="Abhishek Ojha" userId="253db238782fe597" providerId="LiveId" clId="{D78D3E2C-8E82-4946-8FE6-3E884FAE925F}" dt="2023-07-19T06:19:00.390" v="4115" actId="164"/>
          <ac:spMkLst>
            <pc:docMk/>
            <pc:sldMk cId="3325828966" sldId="266"/>
            <ac:spMk id="17" creationId="{06005ACF-23BB-95F3-871F-CE99361DC5FF}"/>
          </ac:spMkLst>
        </pc:spChg>
        <pc:spChg chg="add del">
          <ac:chgData name="Abhishek Ojha" userId="253db238782fe597" providerId="LiveId" clId="{D78D3E2C-8E82-4946-8FE6-3E884FAE925F}" dt="2023-07-19T06:15:29.068" v="3868" actId="478"/>
          <ac:spMkLst>
            <pc:docMk/>
            <pc:sldMk cId="3325828966" sldId="266"/>
            <ac:spMk id="18" creationId="{30B1524A-32D5-D200-0B3F-68C50AA33556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25" creationId="{74CED611-68DC-F674-4249-E2DD400D6FE1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26" creationId="{9C83D69C-27D8-A2D9-5699-9C58FD5A0217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27" creationId="{AB258518-8A65-1A0A-D9E1-3C99624D8307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28" creationId="{6DA1C77E-A9EA-4D16-9818-E431806DDABC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29" creationId="{9FDA79E7-FE6A-91E7-23B4-132E23357B1F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0" creationId="{8FD388B9-D44E-0398-3760-2C1D34A46B59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2" creationId="{2FA61315-5CE5-0DA4-CBBF-3B012D587F98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3" creationId="{8FF077FB-A37B-BD4E-489A-2A13644CED47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4" creationId="{1FAD38AC-B397-0832-8DA1-97DD690D0EAF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5" creationId="{B1B08C81-9AE5-1F5E-B79A-B0716524FF53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6" creationId="{C2A57FAE-8018-DBFE-5ED7-327A88319EAC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7" creationId="{271C0078-E80D-0312-2D4A-8BA60FE220E3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8" creationId="{A849E574-793B-2531-144A-83D1EE5C8C8C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39" creationId="{E6D8AFD1-82E5-F4D2-DA32-EDA48BD8C070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0" creationId="{786C5A63-ACF0-8D89-2203-D62D33C56CBB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1" creationId="{C218A73F-9690-28A9-5B3B-04E802483ECF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2" creationId="{4F3B4E90-C107-F7A8-3D4C-E6C4053E1F07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3" creationId="{15A132C8-B83F-A985-A038-C1FDFBCE82D6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4" creationId="{C844EBD8-9533-465E-4862-8289517E9302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5" creationId="{DA18A53F-8D28-3626-1F67-EE25418F4C3C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6" creationId="{D22A5CE9-6603-AB16-1D5D-E68DA7672EF7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7" creationId="{5C3A07D2-1204-51CE-B472-7A79F6B7FED4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8" creationId="{A782A185-5441-F8FE-A38B-CDEC9398A46E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49" creationId="{526FE412-C303-BB6C-F78C-13F78279C227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50" creationId="{B5693C8B-DEF3-2B40-2ACD-3F30E19414FE}"/>
          </ac:spMkLst>
        </pc:spChg>
        <pc:spChg chg="mod">
          <ac:chgData name="Abhishek Ojha" userId="253db238782fe597" providerId="LiveId" clId="{D78D3E2C-8E82-4946-8FE6-3E884FAE925F}" dt="2023-07-19T06:20:47.850" v="4336"/>
          <ac:spMkLst>
            <pc:docMk/>
            <pc:sldMk cId="3325828966" sldId="266"/>
            <ac:spMk id="51" creationId="{6D1260FE-FB83-7BB5-8C53-E356C1D44AF0}"/>
          </ac:spMkLst>
        </pc:spChg>
        <pc:spChg chg="add mod">
          <ac:chgData name="Abhishek Ojha" userId="253db238782fe597" providerId="LiveId" clId="{D78D3E2C-8E82-4946-8FE6-3E884FAE925F}" dt="2023-07-28T10:30:37.856" v="7898" actId="1076"/>
          <ac:spMkLst>
            <pc:docMk/>
            <pc:sldMk cId="3325828966" sldId="266"/>
            <ac:spMk id="52" creationId="{3FFB359A-F56E-637A-3ACA-D9EC4E2B86F0}"/>
          </ac:spMkLst>
        </pc:spChg>
        <pc:grpChg chg="add del mod">
          <ac:chgData name="Abhishek Ojha" userId="253db238782fe597" providerId="LiveId" clId="{D78D3E2C-8E82-4946-8FE6-3E884FAE925F}" dt="2023-07-19T06:20:55.334" v="4338" actId="478"/>
          <ac:grpSpMkLst>
            <pc:docMk/>
            <pc:sldMk cId="3325828966" sldId="266"/>
            <ac:grpSpMk id="21" creationId="{D22C6D2E-A005-3A23-2DE5-65ED3576F75D}"/>
          </ac:grpSpMkLst>
        </pc:grpChg>
        <pc:grpChg chg="add mod">
          <ac:chgData name="Abhishek Ojha" userId="253db238782fe597" providerId="LiveId" clId="{D78D3E2C-8E82-4946-8FE6-3E884FAE925F}" dt="2023-07-28T10:30:34.287" v="7897" actId="1036"/>
          <ac:grpSpMkLst>
            <pc:docMk/>
            <pc:sldMk cId="3325828966" sldId="266"/>
            <ac:grpSpMk id="22" creationId="{C1D05ED7-0D3D-7E76-E911-02304B310D90}"/>
          </ac:grpSpMkLst>
        </pc:grpChg>
        <pc:grpChg chg="mod">
          <ac:chgData name="Abhishek Ojha" userId="253db238782fe597" providerId="LiveId" clId="{D78D3E2C-8E82-4946-8FE6-3E884FAE925F}" dt="2023-07-19T06:20:47.850" v="4336"/>
          <ac:grpSpMkLst>
            <pc:docMk/>
            <pc:sldMk cId="3325828966" sldId="266"/>
            <ac:grpSpMk id="23" creationId="{DC82321A-7BFF-51FC-EAE4-C85272DA2B96}"/>
          </ac:grpSpMkLst>
        </pc:grpChg>
        <pc:grpChg chg="mod">
          <ac:chgData name="Abhishek Ojha" userId="253db238782fe597" providerId="LiveId" clId="{D78D3E2C-8E82-4946-8FE6-3E884FAE925F}" dt="2023-07-19T06:20:47.850" v="4336"/>
          <ac:grpSpMkLst>
            <pc:docMk/>
            <pc:sldMk cId="3325828966" sldId="266"/>
            <ac:grpSpMk id="24" creationId="{91E359FE-893E-F413-9B33-A192B819BA28}"/>
          </ac:grpSpMkLst>
        </pc:grpChg>
        <pc:picChg chg="add del mod modCrop">
          <ac:chgData name="Abhishek Ojha" userId="253db238782fe597" providerId="LiveId" clId="{D78D3E2C-8E82-4946-8FE6-3E884FAE925F}" dt="2023-07-19T06:20:43.028" v="4334" actId="478"/>
          <ac:picMkLst>
            <pc:docMk/>
            <pc:sldMk cId="3325828966" sldId="266"/>
            <ac:picMk id="3" creationId="{018A8118-83E1-7229-23BE-DC0E96F0ED5C}"/>
          </ac:picMkLst>
        </pc:picChg>
        <pc:picChg chg="mod">
          <ac:chgData name="Abhishek Ojha" userId="253db238782fe597" providerId="LiveId" clId="{D78D3E2C-8E82-4946-8FE6-3E884FAE925F}" dt="2023-07-19T06:20:47.850" v="4336"/>
          <ac:picMkLst>
            <pc:docMk/>
            <pc:sldMk cId="3325828966" sldId="266"/>
            <ac:picMk id="31" creationId="{2C2C4BCA-E411-0325-3262-694F848378A7}"/>
          </ac:picMkLst>
        </pc:picChg>
        <pc:cxnChg chg="add del mod">
          <ac:chgData name="Abhishek Ojha" userId="253db238782fe597" providerId="LiveId" clId="{D78D3E2C-8E82-4946-8FE6-3E884FAE925F}" dt="2023-07-19T06:17:30.672" v="3957" actId="478"/>
          <ac:cxnSpMkLst>
            <pc:docMk/>
            <pc:sldMk cId="3325828966" sldId="266"/>
            <ac:cxnSpMk id="20" creationId="{D3AE8B9F-599C-9B0B-DE5C-3DF4C1DCDF5C}"/>
          </ac:cxnSpMkLst>
        </pc:cxnChg>
      </pc:sldChg>
      <pc:sldChg chg="addSp delSp modSp new mod">
        <pc:chgData name="Abhishek Ojha" userId="253db238782fe597" providerId="LiveId" clId="{D78D3E2C-8E82-4946-8FE6-3E884FAE925F}" dt="2023-07-28T10:34:25.967" v="7907" actId="14100"/>
        <pc:sldMkLst>
          <pc:docMk/>
          <pc:sldMk cId="3886029422" sldId="267"/>
        </pc:sldMkLst>
        <pc:spChg chg="add mod">
          <ac:chgData name="Abhishek Ojha" userId="253db238782fe597" providerId="LiveId" clId="{D78D3E2C-8E82-4946-8FE6-3E884FAE925F}" dt="2023-07-28T10:34:25.967" v="7907" actId="14100"/>
          <ac:spMkLst>
            <pc:docMk/>
            <pc:sldMk cId="3886029422" sldId="267"/>
            <ac:spMk id="2" creationId="{27C93957-4A8B-8C71-FF4B-7BD69C372E9C}"/>
          </ac:spMkLst>
        </pc:spChg>
        <pc:spChg chg="del">
          <ac:chgData name="Abhishek Ojha" userId="253db238782fe597" providerId="LiveId" clId="{D78D3E2C-8E82-4946-8FE6-3E884FAE925F}" dt="2023-07-24T10:42:33.503" v="4568" actId="478"/>
          <ac:spMkLst>
            <pc:docMk/>
            <pc:sldMk cId="3886029422" sldId="267"/>
            <ac:spMk id="2" creationId="{F96047C9-BA79-148E-6F12-B24EDC64EDF0}"/>
          </ac:spMkLst>
        </pc:spChg>
        <pc:spChg chg="del">
          <ac:chgData name="Abhishek Ojha" userId="253db238782fe597" providerId="LiveId" clId="{D78D3E2C-8E82-4946-8FE6-3E884FAE925F}" dt="2023-07-24T10:42:33.503" v="4568" actId="478"/>
          <ac:spMkLst>
            <pc:docMk/>
            <pc:sldMk cId="3886029422" sldId="267"/>
            <ac:spMk id="3" creationId="{17B86C5A-F71A-0FFB-C9DE-965C2471DFCD}"/>
          </ac:spMkLst>
        </pc:spChg>
        <pc:spChg chg="add mod">
          <ac:chgData name="Abhishek Ojha" userId="253db238782fe597" providerId="LiveId" clId="{D78D3E2C-8E82-4946-8FE6-3E884FAE925F}" dt="2023-07-25T08:23:54.113" v="7570" actId="14100"/>
          <ac:spMkLst>
            <pc:docMk/>
            <pc:sldMk cId="3886029422" sldId="267"/>
            <ac:spMk id="3" creationId="{32159B74-C2DA-3348-8D53-CB55F11FFEF5}"/>
          </ac:spMkLst>
        </pc:spChg>
        <pc:spChg chg="add mod">
          <ac:chgData name="Abhishek Ojha" userId="253db238782fe597" providerId="LiveId" clId="{D78D3E2C-8E82-4946-8FE6-3E884FAE925F}" dt="2023-07-25T08:22:33.563" v="7542" actId="114"/>
          <ac:spMkLst>
            <pc:docMk/>
            <pc:sldMk cId="3886029422" sldId="267"/>
            <ac:spMk id="5" creationId="{62AFC677-05AA-92C1-A79F-22B0C306D7AF}"/>
          </ac:spMkLst>
        </pc:spChg>
        <pc:spChg chg="add mod">
          <ac:chgData name="Abhishek Ojha" userId="253db238782fe597" providerId="LiveId" clId="{D78D3E2C-8E82-4946-8FE6-3E884FAE925F}" dt="2023-07-25T08:22:39.231" v="7543" actId="114"/>
          <ac:spMkLst>
            <pc:docMk/>
            <pc:sldMk cId="3886029422" sldId="267"/>
            <ac:spMk id="6" creationId="{480F7A12-BEF2-0F8D-8439-9989DB0B2C88}"/>
          </ac:spMkLst>
        </pc:spChg>
        <pc:spChg chg="add mod">
          <ac:chgData name="Abhishek Ojha" userId="253db238782fe597" providerId="LiveId" clId="{D78D3E2C-8E82-4946-8FE6-3E884FAE925F}" dt="2023-07-25T08:22:43.864" v="7544" actId="114"/>
          <ac:spMkLst>
            <pc:docMk/>
            <pc:sldMk cId="3886029422" sldId="267"/>
            <ac:spMk id="7" creationId="{65518289-02D4-E958-CC82-4D1544DAE38F}"/>
          </ac:spMkLst>
        </pc:spChg>
        <pc:spChg chg="add mod">
          <ac:chgData name="Abhishek Ojha" userId="253db238782fe597" providerId="LiveId" clId="{D78D3E2C-8E82-4946-8FE6-3E884FAE925F}" dt="2023-07-25T08:22:47.407" v="7545" actId="114"/>
          <ac:spMkLst>
            <pc:docMk/>
            <pc:sldMk cId="3886029422" sldId="267"/>
            <ac:spMk id="8" creationId="{66A7D7C4-F863-DAFA-190A-441DE0523B74}"/>
          </ac:spMkLst>
        </pc:spChg>
        <pc:spChg chg="add mod">
          <ac:chgData name="Abhishek Ojha" userId="253db238782fe597" providerId="LiveId" clId="{D78D3E2C-8E82-4946-8FE6-3E884FAE925F}" dt="2023-07-25T08:24:03.431" v="7571" actId="14100"/>
          <ac:spMkLst>
            <pc:docMk/>
            <pc:sldMk cId="3886029422" sldId="267"/>
            <ac:spMk id="9" creationId="{87B66908-C677-7487-8D50-BA06D90422CB}"/>
          </ac:spMkLst>
        </pc:spChg>
        <pc:spChg chg="add del mod">
          <ac:chgData name="Abhishek Ojha" userId="253db238782fe597" providerId="LiveId" clId="{D78D3E2C-8E82-4946-8FE6-3E884FAE925F}" dt="2023-07-25T08:21:17.551" v="7521" actId="478"/>
          <ac:spMkLst>
            <pc:docMk/>
            <pc:sldMk cId="3886029422" sldId="267"/>
            <ac:spMk id="13" creationId="{2B48DF4F-6B66-DE6C-20AE-E40D2DC4B456}"/>
          </ac:spMkLst>
        </pc:spChg>
        <pc:spChg chg="add mod">
          <ac:chgData name="Abhishek Ojha" userId="253db238782fe597" providerId="LiveId" clId="{D78D3E2C-8E82-4946-8FE6-3E884FAE925F}" dt="2023-07-25T08:22:20.483" v="7540" actId="164"/>
          <ac:spMkLst>
            <pc:docMk/>
            <pc:sldMk cId="3886029422" sldId="267"/>
            <ac:spMk id="14" creationId="{AFA3F8B5-0C3D-82F9-E6B8-1600A31D6FC6}"/>
          </ac:spMkLst>
        </pc:spChg>
        <pc:spChg chg="add mod">
          <ac:chgData name="Abhishek Ojha" userId="253db238782fe597" providerId="LiveId" clId="{D78D3E2C-8E82-4946-8FE6-3E884FAE925F}" dt="2023-07-25T08:22:20.483" v="7540" actId="164"/>
          <ac:spMkLst>
            <pc:docMk/>
            <pc:sldMk cId="3886029422" sldId="267"/>
            <ac:spMk id="15" creationId="{E841661B-9DF8-B290-2CFA-B34A68A3EB85}"/>
          </ac:spMkLst>
        </pc:spChg>
        <pc:spChg chg="add mod">
          <ac:chgData name="Abhishek Ojha" userId="253db238782fe597" providerId="LiveId" clId="{D78D3E2C-8E82-4946-8FE6-3E884FAE925F}" dt="2023-07-25T08:22:20.483" v="7540" actId="164"/>
          <ac:spMkLst>
            <pc:docMk/>
            <pc:sldMk cId="3886029422" sldId="267"/>
            <ac:spMk id="16" creationId="{C2AAC087-07E8-D5F4-BDA9-00CC7304C228}"/>
          </ac:spMkLst>
        </pc:spChg>
        <pc:spChg chg="add mod">
          <ac:chgData name="Abhishek Ojha" userId="253db238782fe597" providerId="LiveId" clId="{D78D3E2C-8E82-4946-8FE6-3E884FAE925F}" dt="2023-07-25T08:22:58.891" v="7547" actId="114"/>
          <ac:spMkLst>
            <pc:docMk/>
            <pc:sldMk cId="3886029422" sldId="267"/>
            <ac:spMk id="17" creationId="{28F929C7-8385-E38E-6647-21C387CD5736}"/>
          </ac:spMkLst>
        </pc:spChg>
        <pc:spChg chg="add mod">
          <ac:chgData name="Abhishek Ojha" userId="253db238782fe597" providerId="LiveId" clId="{D78D3E2C-8E82-4946-8FE6-3E884FAE925F}" dt="2023-07-25T08:23:06.571" v="7548" actId="114"/>
          <ac:spMkLst>
            <pc:docMk/>
            <pc:sldMk cId="3886029422" sldId="267"/>
            <ac:spMk id="18" creationId="{50C684DE-9230-D5CE-FD17-9750AC463DE6}"/>
          </ac:spMkLst>
        </pc:spChg>
        <pc:spChg chg="add mod">
          <ac:chgData name="Abhishek Ojha" userId="253db238782fe597" providerId="LiveId" clId="{D78D3E2C-8E82-4946-8FE6-3E884FAE925F}" dt="2023-07-25T08:23:10.623" v="7549" actId="114"/>
          <ac:spMkLst>
            <pc:docMk/>
            <pc:sldMk cId="3886029422" sldId="267"/>
            <ac:spMk id="19" creationId="{381C8B86-5D7B-6BD8-161B-27F8719F3461}"/>
          </ac:spMkLst>
        </pc:spChg>
        <pc:spChg chg="add mod">
          <ac:chgData name="Abhishek Ojha" userId="253db238782fe597" providerId="LiveId" clId="{D78D3E2C-8E82-4946-8FE6-3E884FAE925F}" dt="2023-07-25T08:23:16.347" v="7551" actId="114"/>
          <ac:spMkLst>
            <pc:docMk/>
            <pc:sldMk cId="3886029422" sldId="267"/>
            <ac:spMk id="20" creationId="{4267433C-1B42-98A6-FAE5-1806C2B80683}"/>
          </ac:spMkLst>
        </pc:spChg>
        <pc:spChg chg="add mod">
          <ac:chgData name="Abhishek Ojha" userId="253db238782fe597" providerId="LiveId" clId="{D78D3E2C-8E82-4946-8FE6-3E884FAE925F}" dt="2023-07-25T08:24:12.541" v="7572" actId="14100"/>
          <ac:spMkLst>
            <pc:docMk/>
            <pc:sldMk cId="3886029422" sldId="267"/>
            <ac:spMk id="21" creationId="{30AF43D4-704E-F323-0D1C-DAF2E11CB29B}"/>
          </ac:spMkLst>
        </pc:spChg>
        <pc:spChg chg="add mod">
          <ac:chgData name="Abhishek Ojha" userId="253db238782fe597" providerId="LiveId" clId="{D78D3E2C-8E82-4946-8FE6-3E884FAE925F}" dt="2023-07-25T08:23:24.171" v="7553" actId="114"/>
          <ac:spMkLst>
            <pc:docMk/>
            <pc:sldMk cId="3886029422" sldId="267"/>
            <ac:spMk id="22" creationId="{1D982A47-9D18-5D12-202E-81A92CF450E5}"/>
          </ac:spMkLst>
        </pc:spChg>
        <pc:spChg chg="add mod">
          <ac:chgData name="Abhishek Ojha" userId="253db238782fe597" providerId="LiveId" clId="{D78D3E2C-8E82-4946-8FE6-3E884FAE925F}" dt="2023-07-25T08:23:29.629" v="7554" actId="114"/>
          <ac:spMkLst>
            <pc:docMk/>
            <pc:sldMk cId="3886029422" sldId="267"/>
            <ac:spMk id="23" creationId="{2B76AC1B-D9A9-487F-5B7B-C7A4C5F8A3C8}"/>
          </ac:spMkLst>
        </pc:spChg>
        <pc:spChg chg="add mod">
          <ac:chgData name="Abhishek Ojha" userId="253db238782fe597" providerId="LiveId" clId="{D78D3E2C-8E82-4946-8FE6-3E884FAE925F}" dt="2023-07-25T08:23:33.831" v="7555" actId="114"/>
          <ac:spMkLst>
            <pc:docMk/>
            <pc:sldMk cId="3886029422" sldId="267"/>
            <ac:spMk id="24" creationId="{C018CE60-5E7B-E6CC-B288-32D641490A29}"/>
          </ac:spMkLst>
        </pc:spChg>
        <pc:spChg chg="add mod">
          <ac:chgData name="Abhishek Ojha" userId="253db238782fe597" providerId="LiveId" clId="{D78D3E2C-8E82-4946-8FE6-3E884FAE925F}" dt="2023-07-25T08:23:38.062" v="7556" actId="114"/>
          <ac:spMkLst>
            <pc:docMk/>
            <pc:sldMk cId="3886029422" sldId="267"/>
            <ac:spMk id="25" creationId="{33D932D6-9568-6B70-9D6E-34B451A4A67E}"/>
          </ac:spMkLst>
        </pc:spChg>
        <pc:spChg chg="add del mod">
          <ac:chgData name="Abhishek Ojha" userId="253db238782fe597" providerId="LiveId" clId="{D78D3E2C-8E82-4946-8FE6-3E884FAE925F}" dt="2023-07-25T07:57:51.573" v="6485" actId="478"/>
          <ac:spMkLst>
            <pc:docMk/>
            <pc:sldMk cId="3886029422" sldId="267"/>
            <ac:spMk id="27" creationId="{F581A38B-DA9F-D858-78E8-CC1D3C962595}"/>
          </ac:spMkLst>
        </pc:spChg>
        <pc:spChg chg="add mod">
          <ac:chgData name="Abhishek Ojha" userId="253db238782fe597" providerId="LiveId" clId="{D78D3E2C-8E82-4946-8FE6-3E884FAE925F}" dt="2023-07-25T08:22:20.483" v="7540" actId="164"/>
          <ac:spMkLst>
            <pc:docMk/>
            <pc:sldMk cId="3886029422" sldId="267"/>
            <ac:spMk id="30" creationId="{24BA4578-909D-6CCE-771E-7CB5F08C30E7}"/>
          </ac:spMkLst>
        </pc:spChg>
        <pc:spChg chg="add mod">
          <ac:chgData name="Abhishek Ojha" userId="253db238782fe597" providerId="LiveId" clId="{D78D3E2C-8E82-4946-8FE6-3E884FAE925F}" dt="2023-07-25T08:22:12.906" v="7538" actId="571"/>
          <ac:spMkLst>
            <pc:docMk/>
            <pc:sldMk cId="3886029422" sldId="267"/>
            <ac:spMk id="32" creationId="{6CD7E4CC-5A32-7A05-D908-72824233DB3F}"/>
          </ac:spMkLst>
        </pc:spChg>
        <pc:spChg chg="add mod">
          <ac:chgData name="Abhishek Ojha" userId="253db238782fe597" providerId="LiveId" clId="{D78D3E2C-8E82-4946-8FE6-3E884FAE925F}" dt="2023-07-25T08:22:12.906" v="7538" actId="571"/>
          <ac:spMkLst>
            <pc:docMk/>
            <pc:sldMk cId="3886029422" sldId="267"/>
            <ac:spMk id="33" creationId="{3C627358-4E7D-5A32-D591-962C5A022E1C}"/>
          </ac:spMkLst>
        </pc:spChg>
        <pc:spChg chg="add mod">
          <ac:chgData name="Abhishek Ojha" userId="253db238782fe597" providerId="LiveId" clId="{D78D3E2C-8E82-4946-8FE6-3E884FAE925F}" dt="2023-07-25T08:22:12.906" v="7538" actId="571"/>
          <ac:spMkLst>
            <pc:docMk/>
            <pc:sldMk cId="3886029422" sldId="267"/>
            <ac:spMk id="34" creationId="{1D779F6B-B4A0-B3C2-3849-5C6E5617C13E}"/>
          </ac:spMkLst>
        </pc:spChg>
        <pc:spChg chg="add mod">
          <ac:chgData name="Abhishek Ojha" userId="253db238782fe597" providerId="LiveId" clId="{D78D3E2C-8E82-4946-8FE6-3E884FAE925F}" dt="2023-07-25T08:22:12.906" v="7538" actId="571"/>
          <ac:spMkLst>
            <pc:docMk/>
            <pc:sldMk cId="3886029422" sldId="267"/>
            <ac:spMk id="35" creationId="{3C3796D1-3A6A-A836-3726-852574B8B7A2}"/>
          </ac:spMkLst>
        </pc:spChg>
        <pc:spChg chg="add mod">
          <ac:chgData name="Abhishek Ojha" userId="253db238782fe597" providerId="LiveId" clId="{D78D3E2C-8E82-4946-8FE6-3E884FAE925F}" dt="2023-07-25T08:21:52.682" v="7533" actId="571"/>
          <ac:spMkLst>
            <pc:docMk/>
            <pc:sldMk cId="3886029422" sldId="267"/>
            <ac:spMk id="36" creationId="{9D16D3AA-591B-BF6B-EBC3-F2989CBAC5CA}"/>
          </ac:spMkLst>
        </pc:spChg>
        <pc:spChg chg="add mod">
          <ac:chgData name="Abhishek Ojha" userId="253db238782fe597" providerId="LiveId" clId="{D78D3E2C-8E82-4946-8FE6-3E884FAE925F}" dt="2023-07-25T08:21:52.682" v="7533" actId="571"/>
          <ac:spMkLst>
            <pc:docMk/>
            <pc:sldMk cId="3886029422" sldId="267"/>
            <ac:spMk id="37" creationId="{7D73F506-0391-1F33-AB22-B7BF5D4BEABB}"/>
          </ac:spMkLst>
        </pc:spChg>
        <pc:spChg chg="add mod">
          <ac:chgData name="Abhishek Ojha" userId="253db238782fe597" providerId="LiveId" clId="{D78D3E2C-8E82-4946-8FE6-3E884FAE925F}" dt="2023-07-25T08:21:52.682" v="7533" actId="571"/>
          <ac:spMkLst>
            <pc:docMk/>
            <pc:sldMk cId="3886029422" sldId="267"/>
            <ac:spMk id="38" creationId="{9AB3B7FB-26A7-954E-2DA9-811C8385EA74}"/>
          </ac:spMkLst>
        </pc:spChg>
        <pc:spChg chg="add mod">
          <ac:chgData name="Abhishek Ojha" userId="253db238782fe597" providerId="LiveId" clId="{D78D3E2C-8E82-4946-8FE6-3E884FAE925F}" dt="2023-07-25T08:21:52.682" v="7533" actId="571"/>
          <ac:spMkLst>
            <pc:docMk/>
            <pc:sldMk cId="3886029422" sldId="267"/>
            <ac:spMk id="39" creationId="{E61DD8F7-1082-4604-CD15-8E63C22B674A}"/>
          </ac:spMkLst>
        </pc:spChg>
        <pc:spChg chg="add mod">
          <ac:chgData name="Abhishek Ojha" userId="253db238782fe597" providerId="LiveId" clId="{D78D3E2C-8E82-4946-8FE6-3E884FAE925F}" dt="2023-07-25T08:21:52.682" v="7533" actId="571"/>
          <ac:spMkLst>
            <pc:docMk/>
            <pc:sldMk cId="3886029422" sldId="267"/>
            <ac:spMk id="40" creationId="{634F4116-10F9-82EF-5F16-6BA196ED84B3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1" creationId="{819D0B61-FBBE-D183-F9EA-F72C448F2CD7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2" creationId="{D1402722-3DB8-7E64-BDAD-0BF9CA6117C5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3" creationId="{3178B6A8-1FA4-F855-DA29-D41B20266A74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4" creationId="{2C44EE60-E5CA-2D51-C137-15EC3E200CF5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5" creationId="{CC3E6024-638B-A798-3F96-7A5F5204254D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6" creationId="{C94C62D6-58A4-BEC2-B0FB-9895A3C4B82B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7" creationId="{52F33F9E-D517-1C02-7CA0-E4642C71CA76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8" creationId="{CA4B97D2-2280-11D1-2166-9EA72DD4CACB}"/>
          </ac:spMkLst>
        </pc:spChg>
        <pc:spChg chg="add mod">
          <ac:chgData name="Abhishek Ojha" userId="253db238782fe597" providerId="LiveId" clId="{D78D3E2C-8E82-4946-8FE6-3E884FAE925F}" dt="2023-07-25T08:22:05.166" v="7537" actId="571"/>
          <ac:spMkLst>
            <pc:docMk/>
            <pc:sldMk cId="3886029422" sldId="267"/>
            <ac:spMk id="49" creationId="{99C29055-6D66-0511-E481-9F6849A69E3D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0" creationId="{89C20775-D30D-51DF-A2A9-F0B6320B43D7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1" creationId="{579DBF7F-C6AE-DA04-A69F-2E485670BF06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2" creationId="{565333B1-7EF0-B1C9-BB9D-2B38356C9075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3" creationId="{55FA9FB4-ACBA-FA1A-3FCF-6DB4A9A1E89B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4" creationId="{92ADB17F-24BB-3172-4B30-D9DFFDFA9ACB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5" creationId="{AF5E8AAB-1D54-0256-E8BF-BDB1A068B7B4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6" creationId="{8CA6443B-4957-6B94-A113-7442E556352D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7" creationId="{3467E3EF-F17F-E6C8-C36F-C5B4EA4F7B6A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8" creationId="{85C7DD11-7D37-9E94-9AE4-A72C967E0FB2}"/>
          </ac:spMkLst>
        </pc:spChg>
        <pc:spChg chg="add mod">
          <ac:chgData name="Abhishek Ojha" userId="253db238782fe597" providerId="LiveId" clId="{D78D3E2C-8E82-4946-8FE6-3E884FAE925F}" dt="2023-07-25T08:22:04.344" v="7536" actId="571"/>
          <ac:spMkLst>
            <pc:docMk/>
            <pc:sldMk cId="3886029422" sldId="267"/>
            <ac:spMk id="59" creationId="{F49A9AEE-9C66-CB91-FEC2-9A1D032FF50A}"/>
          </ac:spMkLst>
        </pc:spChg>
        <pc:spChg chg="add mod">
          <ac:chgData name="Abhishek Ojha" userId="253db238782fe597" providerId="LiveId" clId="{D78D3E2C-8E82-4946-8FE6-3E884FAE925F}" dt="2023-07-25T08:42:17.674" v="7712" actId="20577"/>
          <ac:spMkLst>
            <pc:docMk/>
            <pc:sldMk cId="3886029422" sldId="267"/>
            <ac:spMk id="62" creationId="{C1D4C88C-3DAE-546C-2B87-2AE123EED485}"/>
          </ac:spMkLst>
        </pc:spChg>
        <pc:grpChg chg="add mod">
          <ac:chgData name="Abhishek Ojha" userId="253db238782fe597" providerId="LiveId" clId="{D78D3E2C-8E82-4946-8FE6-3E884FAE925F}" dt="2023-07-25T08:22:13.742" v="7539" actId="164"/>
          <ac:grpSpMkLst>
            <pc:docMk/>
            <pc:sldMk cId="3886029422" sldId="267"/>
            <ac:grpSpMk id="31" creationId="{7588F908-599A-8BCD-1D14-6E24169BA732}"/>
          </ac:grpSpMkLst>
        </pc:grpChg>
        <pc:grpChg chg="add mod">
          <ac:chgData name="Abhishek Ojha" userId="253db238782fe597" providerId="LiveId" clId="{D78D3E2C-8E82-4946-8FE6-3E884FAE925F}" dt="2023-07-25T08:45:43.672" v="7831" actId="164"/>
          <ac:grpSpMkLst>
            <pc:docMk/>
            <pc:sldMk cId="3886029422" sldId="267"/>
            <ac:grpSpMk id="60" creationId="{3D0A94B5-3A68-92D0-14EA-13397DE168A1}"/>
          </ac:grpSpMkLst>
        </pc:grpChg>
        <pc:grpChg chg="add mod">
          <ac:chgData name="Abhishek Ojha" userId="253db238782fe597" providerId="LiveId" clId="{D78D3E2C-8E82-4946-8FE6-3E884FAE925F}" dt="2023-07-25T08:45:43.672" v="7831" actId="164"/>
          <ac:grpSpMkLst>
            <pc:docMk/>
            <pc:sldMk cId="3886029422" sldId="267"/>
            <ac:grpSpMk id="67" creationId="{11360A51-6437-999D-4090-119DDB3AABB5}"/>
          </ac:grpSpMkLst>
        </pc:grpChg>
        <pc:graphicFrameChg chg="add mod">
          <ac:chgData name="Abhishek Ojha" userId="253db238782fe597" providerId="LiveId" clId="{D78D3E2C-8E82-4946-8FE6-3E884FAE925F}" dt="2023-07-25T08:48:43.278" v="7844" actId="207"/>
          <ac:graphicFrameMkLst>
            <pc:docMk/>
            <pc:sldMk cId="3886029422" sldId="267"/>
            <ac:graphicFrameMk id="4" creationId="{B78FC33B-0976-9F68-13D8-777F4F9A0322}"/>
          </ac:graphicFrameMkLst>
        </pc:graphicFrameChg>
        <pc:cxnChg chg="add mod">
          <ac:chgData name="Abhishek Ojha" userId="253db238782fe597" providerId="LiveId" clId="{D78D3E2C-8E82-4946-8FE6-3E884FAE925F}" dt="2023-07-24T10:54:21.432" v="4600"/>
          <ac:cxnSpMkLst>
            <pc:docMk/>
            <pc:sldMk cId="3886029422" sldId="267"/>
            <ac:cxnSpMk id="5" creationId="{78463605-0FD9-E7C6-E67B-899C7C4B6A55}"/>
          </ac:cxnSpMkLst>
        </pc:cxnChg>
        <pc:cxnChg chg="add del mod">
          <ac:chgData name="Abhishek Ojha" userId="253db238782fe597" providerId="LiveId" clId="{D78D3E2C-8E82-4946-8FE6-3E884FAE925F}" dt="2023-07-24T10:55:49.257" v="5129" actId="478"/>
          <ac:cxnSpMkLst>
            <pc:docMk/>
            <pc:sldMk cId="3886029422" sldId="267"/>
            <ac:cxnSpMk id="6" creationId="{BA955ACD-DFDE-6E08-97DB-E80782772F9F}"/>
          </ac:cxnSpMkLst>
        </pc:cxnChg>
        <pc:cxnChg chg="add del mod">
          <ac:chgData name="Abhishek Ojha" userId="253db238782fe597" providerId="LiveId" clId="{D78D3E2C-8E82-4946-8FE6-3E884FAE925F}" dt="2023-07-24T10:55:51.634" v="5130" actId="478"/>
          <ac:cxnSpMkLst>
            <pc:docMk/>
            <pc:sldMk cId="3886029422" sldId="267"/>
            <ac:cxnSpMk id="7" creationId="{BA955ACD-DFDE-6E08-97DB-E80782772F9F}"/>
          </ac:cxnSpMkLst>
        </pc:cxnChg>
        <pc:cxnChg chg="add del mod">
          <ac:chgData name="Abhishek Ojha" userId="253db238782fe597" providerId="LiveId" clId="{D78D3E2C-8E82-4946-8FE6-3E884FAE925F}" dt="2023-07-24T10:55:53.987" v="5131" actId="478"/>
          <ac:cxnSpMkLst>
            <pc:docMk/>
            <pc:sldMk cId="3886029422" sldId="267"/>
            <ac:cxnSpMk id="8" creationId="{BA955ACD-DFDE-6E08-97DB-E80782772F9F}"/>
          </ac:cxnSpMkLst>
        </pc:cxnChg>
        <pc:cxnChg chg="add del mod">
          <ac:chgData name="Abhishek Ojha" userId="253db238782fe597" providerId="LiveId" clId="{D78D3E2C-8E82-4946-8FE6-3E884FAE925F}" dt="2023-07-24T10:55:47.030" v="5128" actId="478"/>
          <ac:cxnSpMkLst>
            <pc:docMk/>
            <pc:sldMk cId="3886029422" sldId="267"/>
            <ac:cxnSpMk id="9" creationId="{63DCDEE0-C64D-B63D-6A10-077B5D57447A}"/>
          </ac:cxnSpMkLst>
        </pc:cxnChg>
        <pc:cxnChg chg="add mod">
          <ac:chgData name="Abhishek Ojha" userId="253db238782fe597" providerId="LiveId" clId="{D78D3E2C-8E82-4946-8FE6-3E884FAE925F}" dt="2023-07-25T08:22:20.483" v="7540" actId="164"/>
          <ac:cxnSpMkLst>
            <pc:docMk/>
            <pc:sldMk cId="3886029422" sldId="267"/>
            <ac:cxnSpMk id="10" creationId="{B5F83320-7634-2BC5-764C-A5C90E377313}"/>
          </ac:cxnSpMkLst>
        </pc:cxnChg>
        <pc:cxnChg chg="add mod">
          <ac:chgData name="Abhishek Ojha" userId="253db238782fe597" providerId="LiveId" clId="{D78D3E2C-8E82-4946-8FE6-3E884FAE925F}" dt="2023-07-25T08:22:20.483" v="7540" actId="164"/>
          <ac:cxnSpMkLst>
            <pc:docMk/>
            <pc:sldMk cId="3886029422" sldId="267"/>
            <ac:cxnSpMk id="11" creationId="{97D8B17A-D71A-825F-A1C9-6395AF81C9AB}"/>
          </ac:cxnSpMkLst>
        </pc:cxnChg>
        <pc:cxnChg chg="add mod">
          <ac:chgData name="Abhishek Ojha" userId="253db238782fe597" providerId="LiveId" clId="{D78D3E2C-8E82-4946-8FE6-3E884FAE925F}" dt="2023-07-25T08:22:20.483" v="7540" actId="164"/>
          <ac:cxnSpMkLst>
            <pc:docMk/>
            <pc:sldMk cId="3886029422" sldId="267"/>
            <ac:cxnSpMk id="12" creationId="{0D7E15EB-F62C-D7E7-C70F-220285548967}"/>
          </ac:cxnSpMkLst>
        </pc:cxnChg>
        <pc:cxnChg chg="add del mod">
          <ac:chgData name="Abhishek Ojha" userId="253db238782fe597" providerId="LiveId" clId="{D78D3E2C-8E82-4946-8FE6-3E884FAE925F}" dt="2023-07-25T08:19:48.538" v="7299" actId="478"/>
          <ac:cxnSpMkLst>
            <pc:docMk/>
            <pc:sldMk cId="3886029422" sldId="267"/>
            <ac:cxnSpMk id="29" creationId="{DF1A5B6E-57EB-082A-073C-365C428F7201}"/>
          </ac:cxnSpMkLst>
        </pc:cxnChg>
        <pc:cxnChg chg="add mod">
          <ac:chgData name="Abhishek Ojha" userId="253db238782fe597" providerId="LiveId" clId="{D78D3E2C-8E82-4946-8FE6-3E884FAE925F}" dt="2023-07-25T08:45:43.672" v="7831" actId="164"/>
          <ac:cxnSpMkLst>
            <pc:docMk/>
            <pc:sldMk cId="3886029422" sldId="267"/>
            <ac:cxnSpMk id="64" creationId="{3253A688-03C7-F52D-5C19-883D8F7996EE}"/>
          </ac:cxnSpMkLst>
        </pc:cxnChg>
        <pc:cxnChg chg="add mod">
          <ac:chgData name="Abhishek Ojha" userId="253db238782fe597" providerId="LiveId" clId="{D78D3E2C-8E82-4946-8FE6-3E884FAE925F}" dt="2023-07-25T08:45:43.672" v="7831" actId="164"/>
          <ac:cxnSpMkLst>
            <pc:docMk/>
            <pc:sldMk cId="3886029422" sldId="267"/>
            <ac:cxnSpMk id="66" creationId="{1863F6B0-D5EA-2A81-CAA7-C3D1D77C6274}"/>
          </ac:cxnSpMkLst>
        </pc:cxnChg>
      </pc:sldChg>
      <pc:sldChg chg="delSp new mod">
        <pc:chgData name="Abhishek Ojha" userId="253db238782fe597" providerId="LiveId" clId="{D78D3E2C-8E82-4946-8FE6-3E884FAE925F}" dt="2023-07-28T10:51:25.540" v="7910" actId="478"/>
        <pc:sldMkLst>
          <pc:docMk/>
          <pc:sldMk cId="4221896893" sldId="268"/>
        </pc:sldMkLst>
        <pc:spChg chg="del">
          <ac:chgData name="Abhishek Ojha" userId="253db238782fe597" providerId="LiveId" clId="{D78D3E2C-8E82-4946-8FE6-3E884FAE925F}" dt="2023-07-28T10:51:25.540" v="7910" actId="478"/>
          <ac:spMkLst>
            <pc:docMk/>
            <pc:sldMk cId="4221896893" sldId="268"/>
            <ac:spMk id="2" creationId="{09B835EF-9F92-0B2D-B750-258B8DCCC448}"/>
          </ac:spMkLst>
        </pc:spChg>
        <pc:spChg chg="del">
          <ac:chgData name="Abhishek Ojha" userId="253db238782fe597" providerId="LiveId" clId="{D78D3E2C-8E82-4946-8FE6-3E884FAE925F}" dt="2023-07-28T10:51:25.540" v="7910" actId="478"/>
          <ac:spMkLst>
            <pc:docMk/>
            <pc:sldMk cId="4221896893" sldId="268"/>
            <ac:spMk id="3" creationId="{7F16AC3C-9341-0B02-1CE3-93317EF79C7B}"/>
          </ac:spMkLst>
        </pc:spChg>
      </pc:sldChg>
      <pc:sldChg chg="new">
        <pc:chgData name="Abhishek Ojha" userId="253db238782fe597" providerId="LiveId" clId="{D78D3E2C-8E82-4946-8FE6-3E884FAE925F}" dt="2023-07-28T10:34:33.440" v="7909" actId="680"/>
        <pc:sldMkLst>
          <pc:docMk/>
          <pc:sldMk cId="3689660141" sldId="269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253db238782fe597/Desktop/SIHS%2005-06-2023/MDR%20Manucript/Copy%20of%20MDR%20pathogen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>
                <a:noFill/>
              </a:ln>
              <a:effectLst/>
              <a:scene3d>
                <a:camera prst="orthographicFront"/>
                <a:lightRig rig="brightRoom" dir="t"/>
              </a:scene3d>
              <a:sp3d prstMaterial="flat">
                <a:bevelT w="50800" h="101600" prst="angle"/>
                <a:contourClr>
                  <a:srgbClr val="000000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1-9CD4-4228-9EEF-053181F20CAF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>
                <a:noFill/>
              </a:ln>
              <a:effectLst/>
              <a:scene3d>
                <a:camera prst="orthographicFront"/>
                <a:lightRig rig="brightRoom" dir="t"/>
              </a:scene3d>
              <a:sp3d prstMaterial="flat">
                <a:bevelT w="50800" h="101600" prst="angle"/>
                <a:contourClr>
                  <a:srgbClr val="000000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3-9CD4-4228-9EEF-053181F20CAF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>
                <a:noFill/>
              </a:ln>
              <a:effectLst/>
              <a:scene3d>
                <a:camera prst="orthographicFront"/>
                <a:lightRig rig="brightRoom" dir="t"/>
              </a:scene3d>
              <a:sp3d prstMaterial="flat">
                <a:bevelT w="50800" h="101600" prst="angle"/>
                <a:contourClr>
                  <a:srgbClr val="000000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5-9CD4-4228-9EEF-053181F20CAF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>
                <a:noFill/>
              </a:ln>
              <a:effectLst/>
              <a:scene3d>
                <a:camera prst="orthographicFront"/>
                <a:lightRig rig="brightRoom" dir="t"/>
              </a:scene3d>
              <a:sp3d prstMaterial="flat">
                <a:bevelT w="50800" h="101600" prst="angle"/>
                <a:contourClr>
                  <a:srgbClr val="000000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7-9CD4-4228-9EEF-053181F20CAF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>
                <a:noFill/>
              </a:ln>
              <a:effectLst/>
              <a:scene3d>
                <a:camera prst="orthographicFront"/>
                <a:lightRig rig="brightRoom" dir="t"/>
              </a:scene3d>
              <a:sp3d prstMaterial="flat">
                <a:bevelT w="50800" h="101600" prst="angle"/>
                <a:contourClr>
                  <a:srgbClr val="000000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9-9CD4-4228-9EEF-053181F20CAF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inEnd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[Copy of MDR pathogen2.xlsx]Patients with HAIs'!$B$76:$F$76</c:f>
              <c:strCache>
                <c:ptCount val="5"/>
                <c:pt idx="0">
                  <c:v>Eschirechia coli</c:v>
                </c:pt>
                <c:pt idx="1">
                  <c:v>Citrobacter</c:v>
                </c:pt>
                <c:pt idx="2">
                  <c:v>Kliebsiella pneumoniae</c:v>
                </c:pt>
                <c:pt idx="3">
                  <c:v>Pseudomonas aeruginosa</c:v>
                </c:pt>
                <c:pt idx="4">
                  <c:v>Acinetobacter</c:v>
                </c:pt>
              </c:strCache>
            </c:strRef>
          </c:cat>
          <c:val>
            <c:numRef>
              <c:f>'[Copy of MDR pathogen2.xlsx]Patients with HAIs'!$B$77:$F$77</c:f>
              <c:numCache>
                <c:formatCode>General</c:formatCode>
                <c:ptCount val="5"/>
                <c:pt idx="0">
                  <c:v>28</c:v>
                </c:pt>
                <c:pt idx="1">
                  <c:v>19</c:v>
                </c:pt>
                <c:pt idx="2">
                  <c:v>40</c:v>
                </c:pt>
                <c:pt idx="3">
                  <c:v>6</c:v>
                </c:pt>
                <c:pt idx="4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9CD4-4228-9EEF-053181F20CAF}"/>
            </c:ext>
          </c:extLst>
        </c:ser>
        <c:dLbls>
          <c:dLblPos val="in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8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defRPr sz="900" b="1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scene3d>
        <a:camera prst="orthographicFront"/>
        <a:lightRig rig="brightRoom" dir="t"/>
      </a:scene3d>
      <a:sp3d prstMaterial="flat">
        <a:bevelT w="50800" h="101600" prst="angle"/>
        <a:contourClr>
          <a:srgbClr val="000000"/>
        </a:contourClr>
      </a:sp3d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1905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1" i="0" kern="1200" cap="all" spc="5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3E3D50-F69D-1F7C-F99D-C5D618A1D4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BE8BE7-D15F-A54B-E706-3806C880C0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FC3DAA-9980-9F6F-B075-131DDD4F5F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CBB67E-EC42-BA44-C2D5-EB5469B827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4B3F5B-E21E-5447-120C-62AB812CF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52141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5ED1CD-3DFB-E189-61BB-157C007A09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A3D643-0468-5AE6-5414-8E6B300D9E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3410FE-AA71-6EBD-38D0-ACFB205602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644658-6BCD-63EB-8F66-B360ED6216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39DF7A-78AB-3CB1-9B81-E79790BC87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460045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3BFD274-ABB3-D2EA-567E-69195FC74A9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7F689B8-C04D-A839-E77A-4991CE6463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CB23BB-D175-6754-E22F-74319CE49A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1FD733-D611-B7EE-0B01-A44CD2DD75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36D1BC-5E61-B4E8-79AD-BD781DA0C9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90193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49D9CA-D0A3-6DAE-891B-EA35D4488A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830BCD-B96F-0959-0D99-68B69C0BCB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D12C8A-E1D1-3DA0-B75A-377C066131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43D5F7-BAB5-0F66-2FA3-293DB43840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755976-4F4F-8D19-41E0-F76EF2296E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221719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55BD01-3D8A-3211-D445-1925BF82DC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16B79F-0B9B-E327-C5C2-7A0ABA2E29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9F8FA6-7AFD-C425-39A4-CF9F59C6DE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6F13EB-114C-9008-A862-725C5B7FE5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E7D4A4-B07E-25CB-ABB3-EB27E5146E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80773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921662-F791-1585-1C71-7B86F816FB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E43304-2296-8A7C-5A9A-934073692D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EE38203-6A0A-5319-5DCB-C4369C35D8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247362-A1CE-D6CF-8E56-8F9B4B6DFE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7CB9F9-DF4A-7573-8445-4FB90569A9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371031-405E-5431-6054-A840A5EB4A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031621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663014-FC8D-6CC4-9A3F-D6150E635C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3C81CF-F469-4568-CCBE-D3366BDC05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F2DE56-2D0F-2088-B15E-49CBC54323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9BD0BAA-5A65-4407-F5E8-40A682D2CE3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783AD1F-7A31-2A92-260F-9EC07E17BF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D1A11DC-0955-3EF2-885C-EA2A52F474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1DB116C-8B53-685F-484F-2C8B7B9ECA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9285293-9A55-7C34-0F06-B296688DBB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8618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4EEA5D-3B8F-D9CC-167C-546B704E6A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053B456-1AF2-ED34-9F10-060940B3B6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5511AB9-C8C1-87B5-2D72-1B547A3303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0102E33-A2D5-3D16-0462-9DF256C8FC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21271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CD9CFCF-B0FA-3B46-434D-350AA7183A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44D1C1A-77E8-BE46-394D-B00968D4C8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347589-9234-DCD8-88BD-2B7E007CCD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51893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24B738-7E72-58B0-05A5-CB2D8E8B50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29D419-C08D-8901-52F4-EB6F37D684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682508-0A06-0622-DA80-E1B15EADDB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6332F4-8316-6E3D-8183-D99EA86616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A5781E-48BC-8307-30D2-EC38D42778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9CD068-4159-177F-5132-1773E940B1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071881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DBF655-1D87-122B-641A-6C68DC205C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D89AA3C-7053-A4E1-093D-E874DE4A7E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AC43BA-5AC8-6B72-1E4E-DED04B8ADB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F10CD0-DF91-C230-A28A-FA30079003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540BBE-A114-96E0-4CBE-916F09E1F0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A52584-7BF8-93D1-5116-CE0619842C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53763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66004FF-BCC9-2689-5437-094F285826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595709-42A9-CEBC-397D-A69F3AB715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91E50B-DC36-40D4-89AB-4DBEB2DB91C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AC99E9-B106-4720-BD3B-33142D76E30C}" type="datetimeFigureOut">
              <a:rPr lang="en-IN" smtClean="0"/>
              <a:t>17-11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8EFCB0-51D3-71EA-0185-DD535C56F3B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DED3E4-BEDC-B183-7D25-28E54E15F7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8D6936-D24E-4F5B-AE16-FF5B98E5AB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65356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496A3F53-201C-F1C4-BC44-416DFA831225}"/>
              </a:ext>
            </a:extLst>
          </p:cNvPr>
          <p:cNvGrpSpPr/>
          <p:nvPr/>
        </p:nvGrpSpPr>
        <p:grpSpPr>
          <a:xfrm>
            <a:off x="3151565" y="1519384"/>
            <a:ext cx="4955222" cy="2837310"/>
            <a:chOff x="8875" y="591690"/>
            <a:chExt cx="4955222" cy="2837310"/>
          </a:xfrm>
        </p:grpSpPr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63DB9E4E-EACE-E6C9-11FB-C50EB513202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604671"/>
                </p:ext>
              </p:extLst>
            </p:nvPr>
          </p:nvGraphicFramePr>
          <p:xfrm>
            <a:off x="392097" y="68580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808E095-5066-DE87-928E-F529210DD0C9}"/>
                </a:ext>
              </a:extLst>
            </p:cNvPr>
            <p:cNvSpPr txBox="1"/>
            <p:nvPr/>
          </p:nvSpPr>
          <p:spPr>
            <a:xfrm>
              <a:off x="239699" y="885065"/>
              <a:ext cx="1766656" cy="28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0" i="1" u="none" strike="noStrike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seudomonas aeruginosa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E3BE2C0-F646-BC41-0F77-E1DB717510B4}"/>
                </a:ext>
              </a:extLst>
            </p:cNvPr>
            <p:cNvSpPr txBox="1"/>
            <p:nvPr/>
          </p:nvSpPr>
          <p:spPr>
            <a:xfrm>
              <a:off x="3687195" y="1272598"/>
              <a:ext cx="1214762" cy="28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0" i="1" u="none" strike="noStrike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scherichia coli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681445F-97A8-3BB1-FBC5-05D779D55EFB}"/>
                </a:ext>
              </a:extLst>
            </p:cNvPr>
            <p:cNvSpPr txBox="1"/>
            <p:nvPr/>
          </p:nvSpPr>
          <p:spPr>
            <a:xfrm>
              <a:off x="3605817" y="2632175"/>
              <a:ext cx="11437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0" i="1" u="none" strike="noStrike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itrobacter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p.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F83E673-96FC-C0EB-4214-3CF6EE6BED48}"/>
                </a:ext>
              </a:extLst>
            </p:cNvPr>
            <p:cNvSpPr txBox="1"/>
            <p:nvPr/>
          </p:nvSpPr>
          <p:spPr>
            <a:xfrm>
              <a:off x="8875" y="2366687"/>
              <a:ext cx="16320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0" i="1" u="none" strike="noStrike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lebsiella pneumoniae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4F39214-E378-C9D0-950E-1F38F4C07C69}"/>
                </a:ext>
              </a:extLst>
            </p:cNvPr>
            <p:cNvSpPr txBox="1"/>
            <p:nvPr/>
          </p:nvSpPr>
          <p:spPr>
            <a:xfrm>
              <a:off x="2246050" y="591690"/>
              <a:ext cx="13597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0" i="1" u="none" strike="noStrike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cinetobacter </a:t>
              </a:r>
              <a:r>
                <a:rPr lang="en-IN" sz="1200" b="0" u="none" strike="noStrike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</a:t>
              </a:r>
              <a:r>
                <a:rPr lang="en-IN" sz="1200" b="0" i="1" u="none" strike="noStrike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6B9DDDE1-40E5-CF4F-2DC0-53D2F3C542FA}"/>
              </a:ext>
            </a:extLst>
          </p:cNvPr>
          <p:cNvSpPr txBox="1"/>
          <p:nvPr/>
        </p:nvSpPr>
        <p:spPr>
          <a:xfrm>
            <a:off x="9173" y="19050"/>
            <a:ext cx="8253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55603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86</TotalTime>
  <Words>15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hishek Ojha</dc:creator>
  <cp:lastModifiedBy>Abhishek Ojha</cp:lastModifiedBy>
  <cp:revision>1</cp:revision>
  <dcterms:created xsi:type="dcterms:W3CDTF">2023-06-23T04:53:50Z</dcterms:created>
  <dcterms:modified xsi:type="dcterms:W3CDTF">2023-11-17T06:16:47Z</dcterms:modified>
</cp:coreProperties>
</file>